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64" r:id="rId4"/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51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03EDB6-D609-9387-F32F-2DCD8CCB0B6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4C6D33A-C684-0E7D-CDA9-9752747D53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C6373E8-D1E8-0C21-9A12-BC0AF1F98C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3F8281-ECF7-D76D-A138-EF13A02360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87E969-8A64-7BFC-82EE-B8DC867616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91430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0EB407-F549-D18A-341F-5146A2F91D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792A1D-568B-7C3F-FA3E-D5C3AE11CA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49349D-1959-B4AB-2E46-98E1CA05A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8AC1F4-B4B1-D95F-A97D-A891EAB8CB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A849F3-5230-BD31-2858-A483AB6478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2011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8E0A972-D895-5962-71AF-B471303C92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A5F547B-BA06-D175-5DB6-AFC07FF0456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D9779C-1DA2-5D59-FA38-C0D6793A06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9C2789E-DDA5-3087-3A63-2B95BA17C2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A5A029-5624-06BB-6B1A-1E2A996579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6084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9A7F70-3934-7849-7B13-DD43F5CA9E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CF6AB6-69E6-C2F0-6943-B9DD563395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CE4A72-19B0-CFCB-7EE4-FB55E456E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C6FCBB-CE5B-AA0D-2B4B-C2FAEA02C0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2C6F83-F017-4A03-3266-172A27DCC7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285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8896CE-389C-D9E1-4BFD-BDDDA27B91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F770973-8C6E-BB32-16A8-B73E0ED728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A8E1750-19DD-6405-10B5-EF8D6172A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7EFD6C-E515-7487-198F-C077614220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F6C830-4A6A-258D-D74D-4ED51A2239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363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8E1A89-1C12-2738-63E5-0DC375ADE0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3AEA87D-8FEF-A472-6928-4E19D835129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A725AE-4D98-0B04-046C-4A3E476A3D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A54C2C-F3BC-22F3-E279-E0D4902818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E9C31C-6FC6-2ACC-DD0B-E0A961447D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6AF092-F743-BE56-42EB-2DCA6AED75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0965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4EB472-3FB0-8016-06B7-CA890003D5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84B10D-2D55-5E4D-503B-657A978225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E86F12C-02E8-795E-E11F-C3F6F8A5FFD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A5D3D13-8D92-1457-B8BB-FAC62AD983B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F39C068-F336-81B1-F6E0-59897B70A3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3195D4B-90C9-7ED3-AECA-98EDAAD896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BC51263-CA73-314B-3150-DB2F46D8F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610258A-B94D-91E1-92E5-6238C96C2F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182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3B492D-183E-B98B-A7B1-242BAD41AB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7C19B84-A617-0D3C-4DE6-11EBC3F286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7CF9D8D-5BC0-F903-D5D0-F00EBAE07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EA4110C-45FA-0F11-3FA4-96D902B5CD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9641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CC90AE7-1885-B849-6A5A-0B34C2305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1AB6171-7EA3-6699-2A26-67C541B8DD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E55A173-8A38-4D1A-2ABD-E4830C6511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85409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58DD54-F8DB-8C38-16B3-B24897A0A6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7E26EF-41DA-A615-7E8F-AB403B9BE8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0C3240D-EA2A-DAE2-4C7C-5D06DDC1E8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403B42-DEBB-029E-769F-9E5C021165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5D35679-5C4A-ADA3-66F2-AB77412F51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548937-CAF5-6D99-020B-43613786F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7617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A2742C-4A29-9C7B-B94F-F06DF37B3B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07DA336-F107-2419-80FB-1510AE692FA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AC55698-BAA3-2F82-882C-62E09A5656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A268EA1-F103-F8A7-7965-96EF07FA67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A1E3A04-B6A1-A4B5-C11F-8FCEF467F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57DC84-F63D-2A89-7FBD-36ECF0649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59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BDD4E68-EEBE-95D1-553B-7E09E0B4A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D07484E-02E3-703B-4988-222F20A5ED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3C25B18-21BF-239A-54BB-DBE47CCE51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EB9424-8802-4F55-AFC1-E380E1C1D269}" type="datetimeFigureOut">
              <a:rPr lang="en-US" smtClean="0"/>
              <a:t>2/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5E883D-6F98-D69C-BCE5-F84D9DFC50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69968D-497D-7161-C37A-C2D3A2B34B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567604-5DFD-49E8-A137-1911D2E6657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7828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AED7BBD4-348E-33B8-6706-36E286A0E3B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3026" y="0"/>
            <a:ext cx="11585947" cy="6858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6048BAAD-A5AF-C223-2150-CEEB601B4C1E}"/>
              </a:ext>
            </a:extLst>
          </p:cNvPr>
          <p:cNvSpPr txBox="1"/>
          <p:nvPr/>
        </p:nvSpPr>
        <p:spPr>
          <a:xfrm>
            <a:off x="7599294" y="84868"/>
            <a:ext cx="42896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rgothioneine extracted ion chromatograms</a:t>
            </a:r>
          </a:p>
          <a:p>
            <a:r>
              <a:rPr lang="en-US" dirty="0"/>
              <a:t>- output from software</a:t>
            </a:r>
          </a:p>
        </p:txBody>
      </p:sp>
    </p:spTree>
    <p:extLst>
      <p:ext uri="{BB962C8B-B14F-4D97-AF65-F5344CB8AC3E}">
        <p14:creationId xmlns:p14="http://schemas.microsoft.com/office/powerpoint/2010/main" val="39334963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84" name="Group 383">
            <a:extLst>
              <a:ext uri="{FF2B5EF4-FFF2-40B4-BE49-F238E27FC236}">
                <a16:creationId xmlns:a16="http://schemas.microsoft.com/office/drawing/2014/main" id="{E88CFF69-E03A-2C90-EB11-1F29E99DDE5B}"/>
              </a:ext>
            </a:extLst>
          </p:cNvPr>
          <p:cNvGrpSpPr/>
          <p:nvPr/>
        </p:nvGrpSpPr>
        <p:grpSpPr>
          <a:xfrm>
            <a:off x="229570" y="-11113"/>
            <a:ext cx="11585575" cy="7077692"/>
            <a:chOff x="1186928" y="1147602"/>
            <a:chExt cx="11585575" cy="7077692"/>
          </a:xfrm>
        </p:grpSpPr>
        <p:sp>
          <p:nvSpPr>
            <p:cNvPr id="3" name="AutoShape 3">
              <a:extLst>
                <a:ext uri="{FF2B5EF4-FFF2-40B4-BE49-F238E27FC236}">
                  <a16:creationId xmlns:a16="http://schemas.microsoft.com/office/drawing/2014/main" id="{5F2AAE2A-4653-56F0-A66F-E1D80C62A7F1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186928" y="1147602"/>
              <a:ext cx="11585575" cy="685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grpSp>
          <p:nvGrpSpPr>
            <p:cNvPr id="383" name="Group 382">
              <a:extLst>
                <a:ext uri="{FF2B5EF4-FFF2-40B4-BE49-F238E27FC236}">
                  <a16:creationId xmlns:a16="http://schemas.microsoft.com/office/drawing/2014/main" id="{57FD080C-D074-3272-14A6-D657CDD00FCC}"/>
                </a:ext>
              </a:extLst>
            </p:cNvPr>
            <p:cNvGrpSpPr/>
            <p:nvPr/>
          </p:nvGrpSpPr>
          <p:grpSpPr>
            <a:xfrm>
              <a:off x="1307578" y="1147602"/>
              <a:ext cx="11460163" cy="7077692"/>
              <a:chOff x="423863" y="0"/>
              <a:chExt cx="11460163" cy="7077692"/>
            </a:xfrm>
          </p:grpSpPr>
          <p:sp>
            <p:nvSpPr>
              <p:cNvPr id="183" name="Line 5">
                <a:extLst>
                  <a:ext uri="{FF2B5EF4-FFF2-40B4-BE49-F238E27FC236}">
                    <a16:creationId xmlns:a16="http://schemas.microsoft.com/office/drawing/2014/main" id="{9BBFBE10-2AB5-B1E5-EC1B-2F14FB602A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00076" y="142875"/>
                <a:ext cx="0" cy="148748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84" name="Rectangle 6">
                <a:extLst>
                  <a:ext uri="{FF2B5EF4-FFF2-40B4-BE49-F238E27FC236}">
                    <a16:creationId xmlns:a16="http://schemas.microsoft.com/office/drawing/2014/main" id="{5724A4D3-5F87-4A4E-4742-416B4A90A6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9751" y="33338"/>
                <a:ext cx="28854" cy="615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85" name="Rectangle 7">
                <a:extLst>
                  <a:ext uri="{FF2B5EF4-FFF2-40B4-BE49-F238E27FC236}">
                    <a16:creationId xmlns:a16="http://schemas.microsoft.com/office/drawing/2014/main" id="{42C815AF-1761-39B1-7B12-919F4F1410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3863" y="42863"/>
                <a:ext cx="10259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x1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86" name="Line 8">
                <a:extLst>
                  <a:ext uri="{FF2B5EF4-FFF2-40B4-BE49-F238E27FC236}">
                    <a16:creationId xmlns:a16="http://schemas.microsoft.com/office/drawing/2014/main" id="{6CD84839-5289-C14F-68B8-8BAB45B48C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1630363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87" name="Rectangle 9">
                <a:extLst>
                  <a:ext uri="{FF2B5EF4-FFF2-40B4-BE49-F238E27FC236}">
                    <a16:creationId xmlns:a16="http://schemas.microsoft.com/office/drawing/2014/main" id="{58C97511-E9F2-A61E-C91A-23F177587B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988" y="1590675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88" name="Line 10">
                <a:extLst>
                  <a:ext uri="{FF2B5EF4-FFF2-40B4-BE49-F238E27FC236}">
                    <a16:creationId xmlns:a16="http://schemas.microsoft.com/office/drawing/2014/main" id="{C28D450D-0B15-0ECA-BEC8-7A9DF357EB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1514475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89" name="Rectangle 11">
                <a:extLst>
                  <a:ext uri="{FF2B5EF4-FFF2-40B4-BE49-F238E27FC236}">
                    <a16:creationId xmlns:a16="http://schemas.microsoft.com/office/drawing/2014/main" id="{09DB9069-1D81-4C77-F15F-76B16CA7280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1476375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1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90" name="Line 12">
                <a:extLst>
                  <a:ext uri="{FF2B5EF4-FFF2-40B4-BE49-F238E27FC236}">
                    <a16:creationId xmlns:a16="http://schemas.microsoft.com/office/drawing/2014/main" id="{35466879-9AB5-C8EB-EDAC-AE9D9C9F20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1404938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91" name="Rectangle 13">
                <a:extLst>
                  <a:ext uri="{FF2B5EF4-FFF2-40B4-BE49-F238E27FC236}">
                    <a16:creationId xmlns:a16="http://schemas.microsoft.com/office/drawing/2014/main" id="{E1EFEE80-CFFD-76EE-9802-B59D3D74BD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1365250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92" name="Line 14">
                <a:extLst>
                  <a:ext uri="{FF2B5EF4-FFF2-40B4-BE49-F238E27FC236}">
                    <a16:creationId xmlns:a16="http://schemas.microsoft.com/office/drawing/2014/main" id="{2DFE030E-CF03-1E3E-969E-BD5A02D84B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1289050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93" name="Rectangle 15">
                <a:extLst>
                  <a:ext uri="{FF2B5EF4-FFF2-40B4-BE49-F238E27FC236}">
                    <a16:creationId xmlns:a16="http://schemas.microsoft.com/office/drawing/2014/main" id="{230F933C-F95A-605E-9E87-27C6CB3D4B8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12493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94" name="Line 16">
                <a:extLst>
                  <a:ext uri="{FF2B5EF4-FFF2-40B4-BE49-F238E27FC236}">
                    <a16:creationId xmlns:a16="http://schemas.microsoft.com/office/drawing/2014/main" id="{A5D6C908-F22C-F91B-ABC5-5498101691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1173163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95" name="Rectangle 17">
                <a:extLst>
                  <a:ext uri="{FF2B5EF4-FFF2-40B4-BE49-F238E27FC236}">
                    <a16:creationId xmlns:a16="http://schemas.microsoft.com/office/drawing/2014/main" id="{AC6761F6-D615-5435-7300-67361C94A9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1133475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96" name="Line 18">
                <a:extLst>
                  <a:ext uri="{FF2B5EF4-FFF2-40B4-BE49-F238E27FC236}">
                    <a16:creationId xmlns:a16="http://schemas.microsoft.com/office/drawing/2014/main" id="{0DF93B1D-37F4-5061-E693-F9A1685799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1063625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97" name="Rectangle 19">
                <a:extLst>
                  <a:ext uri="{FF2B5EF4-FFF2-40B4-BE49-F238E27FC236}">
                    <a16:creationId xmlns:a16="http://schemas.microsoft.com/office/drawing/2014/main" id="{DCAF3005-D00C-946E-9F92-6DD15720B07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1023938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98" name="Line 20">
                <a:extLst>
                  <a:ext uri="{FF2B5EF4-FFF2-40B4-BE49-F238E27FC236}">
                    <a16:creationId xmlns:a16="http://schemas.microsoft.com/office/drawing/2014/main" id="{1BEDF53B-E259-D2C1-DC2F-7EE61A381C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947738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99" name="Rectangle 21">
                <a:extLst>
                  <a:ext uri="{FF2B5EF4-FFF2-40B4-BE49-F238E27FC236}">
                    <a16:creationId xmlns:a16="http://schemas.microsoft.com/office/drawing/2014/main" id="{512696B3-67C4-EA6B-235C-7A2F8E70AB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908050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00" name="Line 22">
                <a:extLst>
                  <a:ext uri="{FF2B5EF4-FFF2-40B4-BE49-F238E27FC236}">
                    <a16:creationId xmlns:a16="http://schemas.microsoft.com/office/drawing/2014/main" id="{6F200377-A00F-CFB4-CCF4-16AC3ED3DC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831850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01" name="Rectangle 23">
                <a:extLst>
                  <a:ext uri="{FF2B5EF4-FFF2-40B4-BE49-F238E27FC236}">
                    <a16:creationId xmlns:a16="http://schemas.microsoft.com/office/drawing/2014/main" id="{F66BDE66-2348-3E5A-D786-70EAA848223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7921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02" name="Line 24">
                <a:extLst>
                  <a:ext uri="{FF2B5EF4-FFF2-40B4-BE49-F238E27FC236}">
                    <a16:creationId xmlns:a16="http://schemas.microsoft.com/office/drawing/2014/main" id="{B69E397A-DD02-4190-4F1C-5E0B497C40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722313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03" name="Rectangle 25">
                <a:extLst>
                  <a:ext uri="{FF2B5EF4-FFF2-40B4-BE49-F238E27FC236}">
                    <a16:creationId xmlns:a16="http://schemas.microsoft.com/office/drawing/2014/main" id="{2A31E30B-25DA-4EED-3DE8-6854F2C87B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682625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04" name="Line 26">
                <a:extLst>
                  <a:ext uri="{FF2B5EF4-FFF2-40B4-BE49-F238E27FC236}">
                    <a16:creationId xmlns:a16="http://schemas.microsoft.com/office/drawing/2014/main" id="{FD4B3180-8D89-3743-8368-AE56F5620A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606425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05" name="Rectangle 27">
                <a:extLst>
                  <a:ext uri="{FF2B5EF4-FFF2-40B4-BE49-F238E27FC236}">
                    <a16:creationId xmlns:a16="http://schemas.microsoft.com/office/drawing/2014/main" id="{E532A49D-9C9B-0D08-42BD-E2C0096EA7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566738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06" name="Line 28">
                <a:extLst>
                  <a:ext uri="{FF2B5EF4-FFF2-40B4-BE49-F238E27FC236}">
                    <a16:creationId xmlns:a16="http://schemas.microsoft.com/office/drawing/2014/main" id="{15EFD7B6-1C35-F51B-3CE6-76DFFEFFF5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495300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07" name="Rectangle 29">
                <a:extLst>
                  <a:ext uri="{FF2B5EF4-FFF2-40B4-BE49-F238E27FC236}">
                    <a16:creationId xmlns:a16="http://schemas.microsoft.com/office/drawing/2014/main" id="{7CDCD7B1-5D50-6566-F81E-969C17F358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988" y="457200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08" name="Line 30">
                <a:extLst>
                  <a:ext uri="{FF2B5EF4-FFF2-40B4-BE49-F238E27FC236}">
                    <a16:creationId xmlns:a16="http://schemas.microsoft.com/office/drawing/2014/main" id="{6FE01C0B-37F1-FDBF-05DD-5A8A15631C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379413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09" name="Rectangle 31">
                <a:extLst>
                  <a:ext uri="{FF2B5EF4-FFF2-40B4-BE49-F238E27FC236}">
                    <a16:creationId xmlns:a16="http://schemas.microsoft.com/office/drawing/2014/main" id="{80A80A8E-9DD3-81B2-858E-2A619D0FC3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34131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10" name="Line 32">
                <a:extLst>
                  <a:ext uri="{FF2B5EF4-FFF2-40B4-BE49-F238E27FC236}">
                    <a16:creationId xmlns:a16="http://schemas.microsoft.com/office/drawing/2014/main" id="{1CCC6D68-4A72-0521-0C1A-6209A50D4A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265113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11" name="Rectangle 33">
                <a:extLst>
                  <a:ext uri="{FF2B5EF4-FFF2-40B4-BE49-F238E27FC236}">
                    <a16:creationId xmlns:a16="http://schemas.microsoft.com/office/drawing/2014/main" id="{40F3B4AB-8E54-C0B9-D548-E5A74D3B33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225425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12" name="Line 34">
                <a:extLst>
                  <a:ext uri="{FF2B5EF4-FFF2-40B4-BE49-F238E27FC236}">
                    <a16:creationId xmlns:a16="http://schemas.microsoft.com/office/drawing/2014/main" id="{5DC19E25-B686-EFFC-2E5F-C2A4F9D6F7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153988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13" name="Rectangle 35">
                <a:extLst>
                  <a:ext uri="{FF2B5EF4-FFF2-40B4-BE49-F238E27FC236}">
                    <a16:creationId xmlns:a16="http://schemas.microsoft.com/office/drawing/2014/main" id="{6B74A670-1933-AA61-0C70-2CA2D049E6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115888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14" name="Rectangle 36">
                <a:extLst>
                  <a:ext uri="{FF2B5EF4-FFF2-40B4-BE49-F238E27FC236}">
                    <a16:creationId xmlns:a16="http://schemas.microsoft.com/office/drawing/2014/main" id="{4C94B70C-31D4-C62C-DE1A-99094053611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6426" y="0"/>
                <a:ext cx="11277600" cy="166370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16" name="Rectangle 38">
                <a:extLst>
                  <a:ext uri="{FF2B5EF4-FFF2-40B4-BE49-F238E27FC236}">
                    <a16:creationId xmlns:a16="http://schemas.microsoft.com/office/drawing/2014/main" id="{54A9529F-8C0D-FEA3-7795-AC89A61011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9802" y="38100"/>
                <a:ext cx="1612621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00 µM standard</a:t>
                </a:r>
                <a:endParaRPr kumimoji="0" lang="en-US" altLang="en-US" sz="6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18" name="Freeform 40">
                <a:extLst>
                  <a:ext uri="{FF2B5EF4-FFF2-40B4-BE49-F238E27FC236}">
                    <a16:creationId xmlns:a16="http://schemas.microsoft.com/office/drawing/2014/main" id="{5B0B4338-4A2A-A575-5BCD-DAAF64E18F1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34238" y="277813"/>
                <a:ext cx="376238" cy="1346200"/>
              </a:xfrm>
              <a:custGeom>
                <a:avLst/>
                <a:gdLst>
                  <a:gd name="T0" fmla="*/ 0 w 237"/>
                  <a:gd name="T1" fmla="*/ 848 h 848"/>
                  <a:gd name="T2" fmla="*/ 14 w 237"/>
                  <a:gd name="T3" fmla="*/ 815 h 848"/>
                  <a:gd name="T4" fmla="*/ 28 w 237"/>
                  <a:gd name="T5" fmla="*/ 642 h 848"/>
                  <a:gd name="T6" fmla="*/ 42 w 237"/>
                  <a:gd name="T7" fmla="*/ 286 h 848"/>
                  <a:gd name="T8" fmla="*/ 56 w 237"/>
                  <a:gd name="T9" fmla="*/ 0 h 848"/>
                  <a:gd name="T10" fmla="*/ 70 w 237"/>
                  <a:gd name="T11" fmla="*/ 19 h 848"/>
                  <a:gd name="T12" fmla="*/ 83 w 237"/>
                  <a:gd name="T13" fmla="*/ 243 h 848"/>
                  <a:gd name="T14" fmla="*/ 97 w 237"/>
                  <a:gd name="T15" fmla="*/ 507 h 848"/>
                  <a:gd name="T16" fmla="*/ 111 w 237"/>
                  <a:gd name="T17" fmla="*/ 688 h 848"/>
                  <a:gd name="T18" fmla="*/ 125 w 237"/>
                  <a:gd name="T19" fmla="*/ 766 h 848"/>
                  <a:gd name="T20" fmla="*/ 139 w 237"/>
                  <a:gd name="T21" fmla="*/ 802 h 848"/>
                  <a:gd name="T22" fmla="*/ 153 w 237"/>
                  <a:gd name="T23" fmla="*/ 818 h 848"/>
                  <a:gd name="T24" fmla="*/ 167 w 237"/>
                  <a:gd name="T25" fmla="*/ 831 h 848"/>
                  <a:gd name="T26" fmla="*/ 181 w 237"/>
                  <a:gd name="T27" fmla="*/ 838 h 848"/>
                  <a:gd name="T28" fmla="*/ 195 w 237"/>
                  <a:gd name="T29" fmla="*/ 843 h 848"/>
                  <a:gd name="T30" fmla="*/ 209 w 237"/>
                  <a:gd name="T31" fmla="*/ 844 h 848"/>
                  <a:gd name="T32" fmla="*/ 223 w 237"/>
                  <a:gd name="T33" fmla="*/ 847 h 848"/>
                  <a:gd name="T34" fmla="*/ 237 w 237"/>
                  <a:gd name="T35" fmla="*/ 848 h 848"/>
                  <a:gd name="T36" fmla="*/ 237 w 237"/>
                  <a:gd name="T37" fmla="*/ 848 h 848"/>
                  <a:gd name="T38" fmla="*/ 237 w 237"/>
                  <a:gd name="T39" fmla="*/ 848 h 848"/>
                  <a:gd name="T40" fmla="*/ 0 w 237"/>
                  <a:gd name="T41" fmla="*/ 848 h 848"/>
                  <a:gd name="T42" fmla="*/ 0 w 237"/>
                  <a:gd name="T43" fmla="*/ 848 h 848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</a:cxnLst>
                <a:rect l="0" t="0" r="r" b="b"/>
                <a:pathLst>
                  <a:path w="237" h="848">
                    <a:moveTo>
                      <a:pt x="0" y="848"/>
                    </a:moveTo>
                    <a:lnTo>
                      <a:pt x="14" y="815"/>
                    </a:lnTo>
                    <a:lnTo>
                      <a:pt x="28" y="642"/>
                    </a:lnTo>
                    <a:lnTo>
                      <a:pt x="42" y="286"/>
                    </a:lnTo>
                    <a:lnTo>
                      <a:pt x="56" y="0"/>
                    </a:lnTo>
                    <a:lnTo>
                      <a:pt x="70" y="19"/>
                    </a:lnTo>
                    <a:lnTo>
                      <a:pt x="83" y="243"/>
                    </a:lnTo>
                    <a:lnTo>
                      <a:pt x="97" y="507"/>
                    </a:lnTo>
                    <a:lnTo>
                      <a:pt x="111" y="688"/>
                    </a:lnTo>
                    <a:lnTo>
                      <a:pt x="125" y="766"/>
                    </a:lnTo>
                    <a:lnTo>
                      <a:pt x="139" y="802"/>
                    </a:lnTo>
                    <a:lnTo>
                      <a:pt x="153" y="818"/>
                    </a:lnTo>
                    <a:lnTo>
                      <a:pt x="167" y="831"/>
                    </a:lnTo>
                    <a:lnTo>
                      <a:pt x="181" y="838"/>
                    </a:lnTo>
                    <a:lnTo>
                      <a:pt x="195" y="843"/>
                    </a:lnTo>
                    <a:lnTo>
                      <a:pt x="209" y="844"/>
                    </a:lnTo>
                    <a:lnTo>
                      <a:pt x="223" y="847"/>
                    </a:lnTo>
                    <a:lnTo>
                      <a:pt x="237" y="848"/>
                    </a:lnTo>
                    <a:lnTo>
                      <a:pt x="237" y="848"/>
                    </a:lnTo>
                    <a:lnTo>
                      <a:pt x="237" y="848"/>
                    </a:lnTo>
                    <a:lnTo>
                      <a:pt x="0" y="848"/>
                    </a:lnTo>
                    <a:lnTo>
                      <a:pt x="0" y="848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20" name="Freeform 42">
                <a:extLst>
                  <a:ext uri="{FF2B5EF4-FFF2-40B4-BE49-F238E27FC236}">
                    <a16:creationId xmlns:a16="http://schemas.microsoft.com/office/drawing/2014/main" id="{BC287C86-D75D-8EC9-5BC5-86E7DB73332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34238" y="1624013"/>
                <a:ext cx="376238" cy="0"/>
              </a:xfrm>
              <a:custGeom>
                <a:avLst/>
                <a:gdLst>
                  <a:gd name="T0" fmla="*/ 0 w 237"/>
                  <a:gd name="T1" fmla="*/ 0 w 237"/>
                  <a:gd name="T2" fmla="*/ 237 w 237"/>
                  <a:gd name="T3" fmla="*/ 237 w 237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  <a:cxn ang="0">
                    <a:pos x="T3" y="0"/>
                  </a:cxn>
                </a:cxnLst>
                <a:rect l="0" t="0" r="r" b="b"/>
                <a:pathLst>
                  <a:path w="237">
                    <a:moveTo>
                      <a:pt x="0" y="0"/>
                    </a:moveTo>
                    <a:lnTo>
                      <a:pt x="0" y="0"/>
                    </a:lnTo>
                    <a:lnTo>
                      <a:pt x="237" y="0"/>
                    </a:lnTo>
                    <a:lnTo>
                      <a:pt x="237" y="0"/>
                    </a:lnTo>
                  </a:path>
                </a:pathLst>
              </a:cu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21" name="Freeform 43">
                <a:extLst>
                  <a:ext uri="{FF2B5EF4-FFF2-40B4-BE49-F238E27FC236}">
                    <a16:creationId xmlns:a16="http://schemas.microsoft.com/office/drawing/2014/main" id="{7B6C3F93-D265-38BC-187C-2F41AAE06CA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35288" y="280988"/>
                <a:ext cx="8931275" cy="1349375"/>
              </a:xfrm>
              <a:custGeom>
                <a:avLst/>
                <a:gdLst>
                  <a:gd name="T0" fmla="*/ 83 w 5626"/>
                  <a:gd name="T1" fmla="*/ 850 h 850"/>
                  <a:gd name="T2" fmla="*/ 180 w 5626"/>
                  <a:gd name="T3" fmla="*/ 850 h 850"/>
                  <a:gd name="T4" fmla="*/ 277 w 5626"/>
                  <a:gd name="T5" fmla="*/ 850 h 850"/>
                  <a:gd name="T6" fmla="*/ 375 w 5626"/>
                  <a:gd name="T7" fmla="*/ 850 h 850"/>
                  <a:gd name="T8" fmla="*/ 472 w 5626"/>
                  <a:gd name="T9" fmla="*/ 850 h 850"/>
                  <a:gd name="T10" fmla="*/ 572 w 5626"/>
                  <a:gd name="T11" fmla="*/ 850 h 850"/>
                  <a:gd name="T12" fmla="*/ 669 w 5626"/>
                  <a:gd name="T13" fmla="*/ 850 h 850"/>
                  <a:gd name="T14" fmla="*/ 767 w 5626"/>
                  <a:gd name="T15" fmla="*/ 850 h 850"/>
                  <a:gd name="T16" fmla="*/ 864 w 5626"/>
                  <a:gd name="T17" fmla="*/ 850 h 850"/>
                  <a:gd name="T18" fmla="*/ 961 w 5626"/>
                  <a:gd name="T19" fmla="*/ 850 h 850"/>
                  <a:gd name="T20" fmla="*/ 1061 w 5626"/>
                  <a:gd name="T21" fmla="*/ 850 h 850"/>
                  <a:gd name="T22" fmla="*/ 1159 w 5626"/>
                  <a:gd name="T23" fmla="*/ 850 h 850"/>
                  <a:gd name="T24" fmla="*/ 1256 w 5626"/>
                  <a:gd name="T25" fmla="*/ 850 h 850"/>
                  <a:gd name="T26" fmla="*/ 1353 w 5626"/>
                  <a:gd name="T27" fmla="*/ 850 h 850"/>
                  <a:gd name="T28" fmla="*/ 1450 w 5626"/>
                  <a:gd name="T29" fmla="*/ 850 h 850"/>
                  <a:gd name="T30" fmla="*/ 1547 w 5626"/>
                  <a:gd name="T31" fmla="*/ 850 h 850"/>
                  <a:gd name="T32" fmla="*/ 1648 w 5626"/>
                  <a:gd name="T33" fmla="*/ 850 h 850"/>
                  <a:gd name="T34" fmla="*/ 1745 w 5626"/>
                  <a:gd name="T35" fmla="*/ 850 h 850"/>
                  <a:gd name="T36" fmla="*/ 1842 w 5626"/>
                  <a:gd name="T37" fmla="*/ 850 h 850"/>
                  <a:gd name="T38" fmla="*/ 1939 w 5626"/>
                  <a:gd name="T39" fmla="*/ 850 h 850"/>
                  <a:gd name="T40" fmla="*/ 2036 w 5626"/>
                  <a:gd name="T41" fmla="*/ 850 h 850"/>
                  <a:gd name="T42" fmla="*/ 2137 w 5626"/>
                  <a:gd name="T43" fmla="*/ 850 h 850"/>
                  <a:gd name="T44" fmla="*/ 2234 w 5626"/>
                  <a:gd name="T45" fmla="*/ 850 h 850"/>
                  <a:gd name="T46" fmla="*/ 2331 w 5626"/>
                  <a:gd name="T47" fmla="*/ 850 h 850"/>
                  <a:gd name="T48" fmla="*/ 2428 w 5626"/>
                  <a:gd name="T49" fmla="*/ 850 h 850"/>
                  <a:gd name="T50" fmla="*/ 2525 w 5626"/>
                  <a:gd name="T51" fmla="*/ 850 h 850"/>
                  <a:gd name="T52" fmla="*/ 2622 w 5626"/>
                  <a:gd name="T53" fmla="*/ 850 h 850"/>
                  <a:gd name="T54" fmla="*/ 2723 w 5626"/>
                  <a:gd name="T55" fmla="*/ 812 h 850"/>
                  <a:gd name="T56" fmla="*/ 2820 w 5626"/>
                  <a:gd name="T57" fmla="*/ 687 h 850"/>
                  <a:gd name="T58" fmla="*/ 2917 w 5626"/>
                  <a:gd name="T59" fmla="*/ 843 h 850"/>
                  <a:gd name="T60" fmla="*/ 3014 w 5626"/>
                  <a:gd name="T61" fmla="*/ 850 h 850"/>
                  <a:gd name="T62" fmla="*/ 3111 w 5626"/>
                  <a:gd name="T63" fmla="*/ 850 h 850"/>
                  <a:gd name="T64" fmla="*/ 3212 w 5626"/>
                  <a:gd name="T65" fmla="*/ 850 h 850"/>
                  <a:gd name="T66" fmla="*/ 3309 w 5626"/>
                  <a:gd name="T67" fmla="*/ 850 h 850"/>
                  <a:gd name="T68" fmla="*/ 3406 w 5626"/>
                  <a:gd name="T69" fmla="*/ 850 h 850"/>
                  <a:gd name="T70" fmla="*/ 3503 w 5626"/>
                  <a:gd name="T71" fmla="*/ 850 h 850"/>
                  <a:gd name="T72" fmla="*/ 3600 w 5626"/>
                  <a:gd name="T73" fmla="*/ 850 h 850"/>
                  <a:gd name="T74" fmla="*/ 3698 w 5626"/>
                  <a:gd name="T75" fmla="*/ 850 h 850"/>
                  <a:gd name="T76" fmla="*/ 3798 w 5626"/>
                  <a:gd name="T77" fmla="*/ 850 h 850"/>
                  <a:gd name="T78" fmla="*/ 3895 w 5626"/>
                  <a:gd name="T79" fmla="*/ 850 h 850"/>
                  <a:gd name="T80" fmla="*/ 3992 w 5626"/>
                  <a:gd name="T81" fmla="*/ 850 h 850"/>
                  <a:gd name="T82" fmla="*/ 4090 w 5626"/>
                  <a:gd name="T83" fmla="*/ 850 h 850"/>
                  <a:gd name="T84" fmla="*/ 4187 w 5626"/>
                  <a:gd name="T85" fmla="*/ 850 h 850"/>
                  <a:gd name="T86" fmla="*/ 4287 w 5626"/>
                  <a:gd name="T87" fmla="*/ 850 h 850"/>
                  <a:gd name="T88" fmla="*/ 4384 w 5626"/>
                  <a:gd name="T89" fmla="*/ 850 h 850"/>
                  <a:gd name="T90" fmla="*/ 4481 w 5626"/>
                  <a:gd name="T91" fmla="*/ 850 h 850"/>
                  <a:gd name="T92" fmla="*/ 4579 w 5626"/>
                  <a:gd name="T93" fmla="*/ 850 h 850"/>
                  <a:gd name="T94" fmla="*/ 4676 w 5626"/>
                  <a:gd name="T95" fmla="*/ 850 h 850"/>
                  <a:gd name="T96" fmla="*/ 4773 w 5626"/>
                  <a:gd name="T97" fmla="*/ 850 h 850"/>
                  <a:gd name="T98" fmla="*/ 4873 w 5626"/>
                  <a:gd name="T99" fmla="*/ 850 h 850"/>
                  <a:gd name="T100" fmla="*/ 4971 w 5626"/>
                  <a:gd name="T101" fmla="*/ 850 h 850"/>
                  <a:gd name="T102" fmla="*/ 5068 w 5626"/>
                  <a:gd name="T103" fmla="*/ 850 h 850"/>
                  <a:gd name="T104" fmla="*/ 5165 w 5626"/>
                  <a:gd name="T105" fmla="*/ 850 h 850"/>
                  <a:gd name="T106" fmla="*/ 5262 w 5626"/>
                  <a:gd name="T107" fmla="*/ 850 h 850"/>
                  <a:gd name="T108" fmla="*/ 5363 w 5626"/>
                  <a:gd name="T109" fmla="*/ 850 h 850"/>
                  <a:gd name="T110" fmla="*/ 5460 w 5626"/>
                  <a:gd name="T111" fmla="*/ 850 h 850"/>
                  <a:gd name="T112" fmla="*/ 5557 w 5626"/>
                  <a:gd name="T113" fmla="*/ 850 h 8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</a:cxnLst>
                <a:rect l="0" t="0" r="r" b="b"/>
                <a:pathLst>
                  <a:path w="5626" h="850">
                    <a:moveTo>
                      <a:pt x="0" y="850"/>
                    </a:moveTo>
                    <a:lnTo>
                      <a:pt x="14" y="850"/>
                    </a:lnTo>
                    <a:lnTo>
                      <a:pt x="28" y="850"/>
                    </a:lnTo>
                    <a:lnTo>
                      <a:pt x="42" y="850"/>
                    </a:lnTo>
                    <a:lnTo>
                      <a:pt x="56" y="850"/>
                    </a:lnTo>
                    <a:lnTo>
                      <a:pt x="69" y="850"/>
                    </a:lnTo>
                    <a:lnTo>
                      <a:pt x="83" y="850"/>
                    </a:lnTo>
                    <a:lnTo>
                      <a:pt x="97" y="850"/>
                    </a:lnTo>
                    <a:lnTo>
                      <a:pt x="111" y="850"/>
                    </a:lnTo>
                    <a:lnTo>
                      <a:pt x="125" y="850"/>
                    </a:lnTo>
                    <a:lnTo>
                      <a:pt x="139" y="850"/>
                    </a:lnTo>
                    <a:lnTo>
                      <a:pt x="153" y="850"/>
                    </a:lnTo>
                    <a:lnTo>
                      <a:pt x="166" y="850"/>
                    </a:lnTo>
                    <a:lnTo>
                      <a:pt x="180" y="850"/>
                    </a:lnTo>
                    <a:lnTo>
                      <a:pt x="194" y="850"/>
                    </a:lnTo>
                    <a:lnTo>
                      <a:pt x="208" y="850"/>
                    </a:lnTo>
                    <a:lnTo>
                      <a:pt x="222" y="850"/>
                    </a:lnTo>
                    <a:lnTo>
                      <a:pt x="236" y="850"/>
                    </a:lnTo>
                    <a:lnTo>
                      <a:pt x="250" y="850"/>
                    </a:lnTo>
                    <a:lnTo>
                      <a:pt x="264" y="850"/>
                    </a:lnTo>
                    <a:lnTo>
                      <a:pt x="277" y="850"/>
                    </a:lnTo>
                    <a:lnTo>
                      <a:pt x="291" y="850"/>
                    </a:lnTo>
                    <a:lnTo>
                      <a:pt x="305" y="850"/>
                    </a:lnTo>
                    <a:lnTo>
                      <a:pt x="319" y="850"/>
                    </a:lnTo>
                    <a:lnTo>
                      <a:pt x="333" y="850"/>
                    </a:lnTo>
                    <a:lnTo>
                      <a:pt x="347" y="850"/>
                    </a:lnTo>
                    <a:lnTo>
                      <a:pt x="361" y="850"/>
                    </a:lnTo>
                    <a:lnTo>
                      <a:pt x="375" y="850"/>
                    </a:lnTo>
                    <a:lnTo>
                      <a:pt x="388" y="850"/>
                    </a:lnTo>
                    <a:lnTo>
                      <a:pt x="402" y="850"/>
                    </a:lnTo>
                    <a:lnTo>
                      <a:pt x="416" y="850"/>
                    </a:lnTo>
                    <a:lnTo>
                      <a:pt x="430" y="850"/>
                    </a:lnTo>
                    <a:lnTo>
                      <a:pt x="444" y="850"/>
                    </a:lnTo>
                    <a:lnTo>
                      <a:pt x="458" y="850"/>
                    </a:lnTo>
                    <a:lnTo>
                      <a:pt x="472" y="850"/>
                    </a:lnTo>
                    <a:lnTo>
                      <a:pt x="486" y="850"/>
                    </a:lnTo>
                    <a:lnTo>
                      <a:pt x="499" y="850"/>
                    </a:lnTo>
                    <a:lnTo>
                      <a:pt x="517" y="850"/>
                    </a:lnTo>
                    <a:lnTo>
                      <a:pt x="531" y="850"/>
                    </a:lnTo>
                    <a:lnTo>
                      <a:pt x="545" y="850"/>
                    </a:lnTo>
                    <a:lnTo>
                      <a:pt x="558" y="850"/>
                    </a:lnTo>
                    <a:lnTo>
                      <a:pt x="572" y="850"/>
                    </a:lnTo>
                    <a:lnTo>
                      <a:pt x="586" y="850"/>
                    </a:lnTo>
                    <a:lnTo>
                      <a:pt x="600" y="850"/>
                    </a:lnTo>
                    <a:lnTo>
                      <a:pt x="614" y="850"/>
                    </a:lnTo>
                    <a:lnTo>
                      <a:pt x="628" y="850"/>
                    </a:lnTo>
                    <a:lnTo>
                      <a:pt x="642" y="850"/>
                    </a:lnTo>
                    <a:lnTo>
                      <a:pt x="656" y="850"/>
                    </a:lnTo>
                    <a:lnTo>
                      <a:pt x="669" y="850"/>
                    </a:lnTo>
                    <a:lnTo>
                      <a:pt x="683" y="850"/>
                    </a:lnTo>
                    <a:lnTo>
                      <a:pt x="697" y="850"/>
                    </a:lnTo>
                    <a:lnTo>
                      <a:pt x="711" y="850"/>
                    </a:lnTo>
                    <a:lnTo>
                      <a:pt x="725" y="850"/>
                    </a:lnTo>
                    <a:lnTo>
                      <a:pt x="739" y="850"/>
                    </a:lnTo>
                    <a:lnTo>
                      <a:pt x="753" y="850"/>
                    </a:lnTo>
                    <a:lnTo>
                      <a:pt x="767" y="850"/>
                    </a:lnTo>
                    <a:lnTo>
                      <a:pt x="780" y="850"/>
                    </a:lnTo>
                    <a:lnTo>
                      <a:pt x="794" y="850"/>
                    </a:lnTo>
                    <a:lnTo>
                      <a:pt x="808" y="850"/>
                    </a:lnTo>
                    <a:lnTo>
                      <a:pt x="822" y="850"/>
                    </a:lnTo>
                    <a:lnTo>
                      <a:pt x="836" y="850"/>
                    </a:lnTo>
                    <a:lnTo>
                      <a:pt x="850" y="850"/>
                    </a:lnTo>
                    <a:lnTo>
                      <a:pt x="864" y="850"/>
                    </a:lnTo>
                    <a:lnTo>
                      <a:pt x="878" y="850"/>
                    </a:lnTo>
                    <a:lnTo>
                      <a:pt x="891" y="850"/>
                    </a:lnTo>
                    <a:lnTo>
                      <a:pt x="905" y="850"/>
                    </a:lnTo>
                    <a:lnTo>
                      <a:pt x="919" y="850"/>
                    </a:lnTo>
                    <a:lnTo>
                      <a:pt x="933" y="850"/>
                    </a:lnTo>
                    <a:lnTo>
                      <a:pt x="947" y="850"/>
                    </a:lnTo>
                    <a:lnTo>
                      <a:pt x="961" y="850"/>
                    </a:lnTo>
                    <a:lnTo>
                      <a:pt x="975" y="850"/>
                    </a:lnTo>
                    <a:lnTo>
                      <a:pt x="989" y="850"/>
                    </a:lnTo>
                    <a:lnTo>
                      <a:pt x="1002" y="850"/>
                    </a:lnTo>
                    <a:lnTo>
                      <a:pt x="1016" y="850"/>
                    </a:lnTo>
                    <a:lnTo>
                      <a:pt x="1030" y="850"/>
                    </a:lnTo>
                    <a:lnTo>
                      <a:pt x="1048" y="850"/>
                    </a:lnTo>
                    <a:lnTo>
                      <a:pt x="1061" y="850"/>
                    </a:lnTo>
                    <a:lnTo>
                      <a:pt x="1075" y="850"/>
                    </a:lnTo>
                    <a:lnTo>
                      <a:pt x="1089" y="850"/>
                    </a:lnTo>
                    <a:lnTo>
                      <a:pt x="1103" y="850"/>
                    </a:lnTo>
                    <a:lnTo>
                      <a:pt x="1117" y="850"/>
                    </a:lnTo>
                    <a:lnTo>
                      <a:pt x="1131" y="850"/>
                    </a:lnTo>
                    <a:lnTo>
                      <a:pt x="1145" y="850"/>
                    </a:lnTo>
                    <a:lnTo>
                      <a:pt x="1159" y="850"/>
                    </a:lnTo>
                    <a:lnTo>
                      <a:pt x="1172" y="850"/>
                    </a:lnTo>
                    <a:lnTo>
                      <a:pt x="1186" y="850"/>
                    </a:lnTo>
                    <a:lnTo>
                      <a:pt x="1200" y="850"/>
                    </a:lnTo>
                    <a:lnTo>
                      <a:pt x="1214" y="850"/>
                    </a:lnTo>
                    <a:lnTo>
                      <a:pt x="1228" y="850"/>
                    </a:lnTo>
                    <a:lnTo>
                      <a:pt x="1242" y="850"/>
                    </a:lnTo>
                    <a:lnTo>
                      <a:pt x="1256" y="850"/>
                    </a:lnTo>
                    <a:lnTo>
                      <a:pt x="1270" y="850"/>
                    </a:lnTo>
                    <a:lnTo>
                      <a:pt x="1283" y="850"/>
                    </a:lnTo>
                    <a:lnTo>
                      <a:pt x="1297" y="850"/>
                    </a:lnTo>
                    <a:lnTo>
                      <a:pt x="1311" y="850"/>
                    </a:lnTo>
                    <a:lnTo>
                      <a:pt x="1325" y="850"/>
                    </a:lnTo>
                    <a:lnTo>
                      <a:pt x="1339" y="850"/>
                    </a:lnTo>
                    <a:lnTo>
                      <a:pt x="1353" y="850"/>
                    </a:lnTo>
                    <a:lnTo>
                      <a:pt x="1367" y="850"/>
                    </a:lnTo>
                    <a:lnTo>
                      <a:pt x="1381" y="850"/>
                    </a:lnTo>
                    <a:lnTo>
                      <a:pt x="1394" y="850"/>
                    </a:lnTo>
                    <a:lnTo>
                      <a:pt x="1408" y="850"/>
                    </a:lnTo>
                    <a:lnTo>
                      <a:pt x="1422" y="850"/>
                    </a:lnTo>
                    <a:lnTo>
                      <a:pt x="1436" y="850"/>
                    </a:lnTo>
                    <a:lnTo>
                      <a:pt x="1450" y="850"/>
                    </a:lnTo>
                    <a:lnTo>
                      <a:pt x="1464" y="850"/>
                    </a:lnTo>
                    <a:lnTo>
                      <a:pt x="1478" y="850"/>
                    </a:lnTo>
                    <a:lnTo>
                      <a:pt x="1492" y="850"/>
                    </a:lnTo>
                    <a:lnTo>
                      <a:pt x="1505" y="850"/>
                    </a:lnTo>
                    <a:lnTo>
                      <a:pt x="1519" y="850"/>
                    </a:lnTo>
                    <a:lnTo>
                      <a:pt x="1533" y="850"/>
                    </a:lnTo>
                    <a:lnTo>
                      <a:pt x="1547" y="850"/>
                    </a:lnTo>
                    <a:lnTo>
                      <a:pt x="1561" y="850"/>
                    </a:lnTo>
                    <a:lnTo>
                      <a:pt x="1575" y="850"/>
                    </a:lnTo>
                    <a:lnTo>
                      <a:pt x="1592" y="850"/>
                    </a:lnTo>
                    <a:lnTo>
                      <a:pt x="1606" y="850"/>
                    </a:lnTo>
                    <a:lnTo>
                      <a:pt x="1620" y="850"/>
                    </a:lnTo>
                    <a:lnTo>
                      <a:pt x="1634" y="850"/>
                    </a:lnTo>
                    <a:lnTo>
                      <a:pt x="1648" y="850"/>
                    </a:lnTo>
                    <a:lnTo>
                      <a:pt x="1661" y="850"/>
                    </a:lnTo>
                    <a:lnTo>
                      <a:pt x="1675" y="850"/>
                    </a:lnTo>
                    <a:lnTo>
                      <a:pt x="1689" y="850"/>
                    </a:lnTo>
                    <a:lnTo>
                      <a:pt x="1703" y="850"/>
                    </a:lnTo>
                    <a:lnTo>
                      <a:pt x="1717" y="850"/>
                    </a:lnTo>
                    <a:lnTo>
                      <a:pt x="1731" y="850"/>
                    </a:lnTo>
                    <a:lnTo>
                      <a:pt x="1745" y="850"/>
                    </a:lnTo>
                    <a:lnTo>
                      <a:pt x="1759" y="850"/>
                    </a:lnTo>
                    <a:lnTo>
                      <a:pt x="1772" y="850"/>
                    </a:lnTo>
                    <a:lnTo>
                      <a:pt x="1786" y="850"/>
                    </a:lnTo>
                    <a:lnTo>
                      <a:pt x="1800" y="850"/>
                    </a:lnTo>
                    <a:lnTo>
                      <a:pt x="1814" y="850"/>
                    </a:lnTo>
                    <a:lnTo>
                      <a:pt x="1828" y="850"/>
                    </a:lnTo>
                    <a:lnTo>
                      <a:pt x="1842" y="850"/>
                    </a:lnTo>
                    <a:lnTo>
                      <a:pt x="1856" y="850"/>
                    </a:lnTo>
                    <a:lnTo>
                      <a:pt x="1870" y="850"/>
                    </a:lnTo>
                    <a:lnTo>
                      <a:pt x="1883" y="850"/>
                    </a:lnTo>
                    <a:lnTo>
                      <a:pt x="1897" y="850"/>
                    </a:lnTo>
                    <a:lnTo>
                      <a:pt x="1911" y="850"/>
                    </a:lnTo>
                    <a:lnTo>
                      <a:pt x="1925" y="850"/>
                    </a:lnTo>
                    <a:lnTo>
                      <a:pt x="1939" y="850"/>
                    </a:lnTo>
                    <a:lnTo>
                      <a:pt x="1953" y="850"/>
                    </a:lnTo>
                    <a:lnTo>
                      <a:pt x="1967" y="850"/>
                    </a:lnTo>
                    <a:lnTo>
                      <a:pt x="1981" y="850"/>
                    </a:lnTo>
                    <a:lnTo>
                      <a:pt x="1994" y="850"/>
                    </a:lnTo>
                    <a:lnTo>
                      <a:pt x="2008" y="850"/>
                    </a:lnTo>
                    <a:lnTo>
                      <a:pt x="2022" y="850"/>
                    </a:lnTo>
                    <a:lnTo>
                      <a:pt x="2036" y="850"/>
                    </a:lnTo>
                    <a:lnTo>
                      <a:pt x="2050" y="850"/>
                    </a:lnTo>
                    <a:lnTo>
                      <a:pt x="2064" y="850"/>
                    </a:lnTo>
                    <a:lnTo>
                      <a:pt x="2078" y="850"/>
                    </a:lnTo>
                    <a:lnTo>
                      <a:pt x="2092" y="850"/>
                    </a:lnTo>
                    <a:lnTo>
                      <a:pt x="2105" y="850"/>
                    </a:lnTo>
                    <a:lnTo>
                      <a:pt x="2123" y="850"/>
                    </a:lnTo>
                    <a:lnTo>
                      <a:pt x="2137" y="850"/>
                    </a:lnTo>
                    <a:lnTo>
                      <a:pt x="2151" y="850"/>
                    </a:lnTo>
                    <a:lnTo>
                      <a:pt x="2164" y="850"/>
                    </a:lnTo>
                    <a:lnTo>
                      <a:pt x="2178" y="850"/>
                    </a:lnTo>
                    <a:lnTo>
                      <a:pt x="2192" y="850"/>
                    </a:lnTo>
                    <a:lnTo>
                      <a:pt x="2206" y="850"/>
                    </a:lnTo>
                    <a:lnTo>
                      <a:pt x="2220" y="850"/>
                    </a:lnTo>
                    <a:lnTo>
                      <a:pt x="2234" y="850"/>
                    </a:lnTo>
                    <a:lnTo>
                      <a:pt x="2248" y="850"/>
                    </a:lnTo>
                    <a:lnTo>
                      <a:pt x="2262" y="850"/>
                    </a:lnTo>
                    <a:lnTo>
                      <a:pt x="2275" y="850"/>
                    </a:lnTo>
                    <a:lnTo>
                      <a:pt x="2289" y="850"/>
                    </a:lnTo>
                    <a:lnTo>
                      <a:pt x="2303" y="850"/>
                    </a:lnTo>
                    <a:lnTo>
                      <a:pt x="2317" y="850"/>
                    </a:lnTo>
                    <a:lnTo>
                      <a:pt x="2331" y="850"/>
                    </a:lnTo>
                    <a:lnTo>
                      <a:pt x="2345" y="850"/>
                    </a:lnTo>
                    <a:lnTo>
                      <a:pt x="2359" y="850"/>
                    </a:lnTo>
                    <a:lnTo>
                      <a:pt x="2373" y="850"/>
                    </a:lnTo>
                    <a:lnTo>
                      <a:pt x="2386" y="850"/>
                    </a:lnTo>
                    <a:lnTo>
                      <a:pt x="2400" y="850"/>
                    </a:lnTo>
                    <a:lnTo>
                      <a:pt x="2414" y="850"/>
                    </a:lnTo>
                    <a:lnTo>
                      <a:pt x="2428" y="850"/>
                    </a:lnTo>
                    <a:lnTo>
                      <a:pt x="2442" y="850"/>
                    </a:lnTo>
                    <a:lnTo>
                      <a:pt x="2456" y="850"/>
                    </a:lnTo>
                    <a:lnTo>
                      <a:pt x="2470" y="850"/>
                    </a:lnTo>
                    <a:lnTo>
                      <a:pt x="2484" y="850"/>
                    </a:lnTo>
                    <a:lnTo>
                      <a:pt x="2497" y="850"/>
                    </a:lnTo>
                    <a:lnTo>
                      <a:pt x="2511" y="850"/>
                    </a:lnTo>
                    <a:lnTo>
                      <a:pt x="2525" y="850"/>
                    </a:lnTo>
                    <a:lnTo>
                      <a:pt x="2539" y="850"/>
                    </a:lnTo>
                    <a:lnTo>
                      <a:pt x="2553" y="850"/>
                    </a:lnTo>
                    <a:lnTo>
                      <a:pt x="2567" y="850"/>
                    </a:lnTo>
                    <a:lnTo>
                      <a:pt x="2581" y="850"/>
                    </a:lnTo>
                    <a:lnTo>
                      <a:pt x="2595" y="850"/>
                    </a:lnTo>
                    <a:lnTo>
                      <a:pt x="2608" y="850"/>
                    </a:lnTo>
                    <a:lnTo>
                      <a:pt x="2622" y="850"/>
                    </a:lnTo>
                    <a:lnTo>
                      <a:pt x="2636" y="850"/>
                    </a:lnTo>
                    <a:lnTo>
                      <a:pt x="2650" y="850"/>
                    </a:lnTo>
                    <a:lnTo>
                      <a:pt x="2667" y="850"/>
                    </a:lnTo>
                    <a:lnTo>
                      <a:pt x="2681" y="850"/>
                    </a:lnTo>
                    <a:lnTo>
                      <a:pt x="2695" y="850"/>
                    </a:lnTo>
                    <a:lnTo>
                      <a:pt x="2709" y="847"/>
                    </a:lnTo>
                    <a:lnTo>
                      <a:pt x="2723" y="812"/>
                    </a:lnTo>
                    <a:lnTo>
                      <a:pt x="2737" y="638"/>
                    </a:lnTo>
                    <a:lnTo>
                      <a:pt x="2751" y="284"/>
                    </a:lnTo>
                    <a:lnTo>
                      <a:pt x="2764" y="0"/>
                    </a:lnTo>
                    <a:lnTo>
                      <a:pt x="2778" y="17"/>
                    </a:lnTo>
                    <a:lnTo>
                      <a:pt x="2792" y="239"/>
                    </a:lnTo>
                    <a:lnTo>
                      <a:pt x="2806" y="503"/>
                    </a:lnTo>
                    <a:lnTo>
                      <a:pt x="2820" y="687"/>
                    </a:lnTo>
                    <a:lnTo>
                      <a:pt x="2834" y="763"/>
                    </a:lnTo>
                    <a:lnTo>
                      <a:pt x="2848" y="802"/>
                    </a:lnTo>
                    <a:lnTo>
                      <a:pt x="2862" y="815"/>
                    </a:lnTo>
                    <a:lnTo>
                      <a:pt x="2875" y="829"/>
                    </a:lnTo>
                    <a:lnTo>
                      <a:pt x="2889" y="836"/>
                    </a:lnTo>
                    <a:lnTo>
                      <a:pt x="2903" y="840"/>
                    </a:lnTo>
                    <a:lnTo>
                      <a:pt x="2917" y="843"/>
                    </a:lnTo>
                    <a:lnTo>
                      <a:pt x="2931" y="843"/>
                    </a:lnTo>
                    <a:lnTo>
                      <a:pt x="2945" y="847"/>
                    </a:lnTo>
                    <a:lnTo>
                      <a:pt x="2959" y="847"/>
                    </a:lnTo>
                    <a:lnTo>
                      <a:pt x="2973" y="847"/>
                    </a:lnTo>
                    <a:lnTo>
                      <a:pt x="2986" y="847"/>
                    </a:lnTo>
                    <a:lnTo>
                      <a:pt x="3000" y="847"/>
                    </a:lnTo>
                    <a:lnTo>
                      <a:pt x="3014" y="850"/>
                    </a:lnTo>
                    <a:lnTo>
                      <a:pt x="3028" y="850"/>
                    </a:lnTo>
                    <a:lnTo>
                      <a:pt x="3042" y="850"/>
                    </a:lnTo>
                    <a:lnTo>
                      <a:pt x="3056" y="850"/>
                    </a:lnTo>
                    <a:lnTo>
                      <a:pt x="3070" y="850"/>
                    </a:lnTo>
                    <a:lnTo>
                      <a:pt x="3084" y="850"/>
                    </a:lnTo>
                    <a:lnTo>
                      <a:pt x="3097" y="850"/>
                    </a:lnTo>
                    <a:lnTo>
                      <a:pt x="3111" y="850"/>
                    </a:lnTo>
                    <a:lnTo>
                      <a:pt x="3125" y="850"/>
                    </a:lnTo>
                    <a:lnTo>
                      <a:pt x="3139" y="850"/>
                    </a:lnTo>
                    <a:lnTo>
                      <a:pt x="3153" y="850"/>
                    </a:lnTo>
                    <a:lnTo>
                      <a:pt x="3167" y="850"/>
                    </a:lnTo>
                    <a:lnTo>
                      <a:pt x="3181" y="850"/>
                    </a:lnTo>
                    <a:lnTo>
                      <a:pt x="3195" y="850"/>
                    </a:lnTo>
                    <a:lnTo>
                      <a:pt x="3212" y="850"/>
                    </a:lnTo>
                    <a:lnTo>
                      <a:pt x="3226" y="850"/>
                    </a:lnTo>
                    <a:lnTo>
                      <a:pt x="3240" y="850"/>
                    </a:lnTo>
                    <a:lnTo>
                      <a:pt x="3254" y="850"/>
                    </a:lnTo>
                    <a:lnTo>
                      <a:pt x="3267" y="850"/>
                    </a:lnTo>
                    <a:lnTo>
                      <a:pt x="3281" y="850"/>
                    </a:lnTo>
                    <a:lnTo>
                      <a:pt x="3295" y="850"/>
                    </a:lnTo>
                    <a:lnTo>
                      <a:pt x="3309" y="850"/>
                    </a:lnTo>
                    <a:lnTo>
                      <a:pt x="3323" y="850"/>
                    </a:lnTo>
                    <a:lnTo>
                      <a:pt x="3337" y="850"/>
                    </a:lnTo>
                    <a:lnTo>
                      <a:pt x="3351" y="850"/>
                    </a:lnTo>
                    <a:lnTo>
                      <a:pt x="3365" y="850"/>
                    </a:lnTo>
                    <a:lnTo>
                      <a:pt x="3378" y="850"/>
                    </a:lnTo>
                    <a:lnTo>
                      <a:pt x="3392" y="850"/>
                    </a:lnTo>
                    <a:lnTo>
                      <a:pt x="3406" y="850"/>
                    </a:lnTo>
                    <a:lnTo>
                      <a:pt x="3420" y="850"/>
                    </a:lnTo>
                    <a:lnTo>
                      <a:pt x="3434" y="850"/>
                    </a:lnTo>
                    <a:lnTo>
                      <a:pt x="3448" y="850"/>
                    </a:lnTo>
                    <a:lnTo>
                      <a:pt x="3462" y="850"/>
                    </a:lnTo>
                    <a:lnTo>
                      <a:pt x="3476" y="850"/>
                    </a:lnTo>
                    <a:lnTo>
                      <a:pt x="3489" y="850"/>
                    </a:lnTo>
                    <a:lnTo>
                      <a:pt x="3503" y="850"/>
                    </a:lnTo>
                    <a:lnTo>
                      <a:pt x="3517" y="850"/>
                    </a:lnTo>
                    <a:lnTo>
                      <a:pt x="3531" y="850"/>
                    </a:lnTo>
                    <a:lnTo>
                      <a:pt x="3545" y="850"/>
                    </a:lnTo>
                    <a:lnTo>
                      <a:pt x="3559" y="850"/>
                    </a:lnTo>
                    <a:lnTo>
                      <a:pt x="3573" y="850"/>
                    </a:lnTo>
                    <a:lnTo>
                      <a:pt x="3587" y="850"/>
                    </a:lnTo>
                    <a:lnTo>
                      <a:pt x="3600" y="850"/>
                    </a:lnTo>
                    <a:lnTo>
                      <a:pt x="3614" y="850"/>
                    </a:lnTo>
                    <a:lnTo>
                      <a:pt x="3628" y="850"/>
                    </a:lnTo>
                    <a:lnTo>
                      <a:pt x="3642" y="850"/>
                    </a:lnTo>
                    <a:lnTo>
                      <a:pt x="3656" y="850"/>
                    </a:lnTo>
                    <a:lnTo>
                      <a:pt x="3670" y="850"/>
                    </a:lnTo>
                    <a:lnTo>
                      <a:pt x="3684" y="850"/>
                    </a:lnTo>
                    <a:lnTo>
                      <a:pt x="3698" y="850"/>
                    </a:lnTo>
                    <a:lnTo>
                      <a:pt x="3711" y="850"/>
                    </a:lnTo>
                    <a:lnTo>
                      <a:pt x="3725" y="850"/>
                    </a:lnTo>
                    <a:lnTo>
                      <a:pt x="3743" y="850"/>
                    </a:lnTo>
                    <a:lnTo>
                      <a:pt x="3757" y="850"/>
                    </a:lnTo>
                    <a:lnTo>
                      <a:pt x="3770" y="850"/>
                    </a:lnTo>
                    <a:lnTo>
                      <a:pt x="3784" y="850"/>
                    </a:lnTo>
                    <a:lnTo>
                      <a:pt x="3798" y="850"/>
                    </a:lnTo>
                    <a:lnTo>
                      <a:pt x="3812" y="850"/>
                    </a:lnTo>
                    <a:lnTo>
                      <a:pt x="3826" y="850"/>
                    </a:lnTo>
                    <a:lnTo>
                      <a:pt x="3840" y="850"/>
                    </a:lnTo>
                    <a:lnTo>
                      <a:pt x="3854" y="850"/>
                    </a:lnTo>
                    <a:lnTo>
                      <a:pt x="3868" y="850"/>
                    </a:lnTo>
                    <a:lnTo>
                      <a:pt x="3881" y="850"/>
                    </a:lnTo>
                    <a:lnTo>
                      <a:pt x="3895" y="850"/>
                    </a:lnTo>
                    <a:lnTo>
                      <a:pt x="3909" y="850"/>
                    </a:lnTo>
                    <a:lnTo>
                      <a:pt x="3923" y="850"/>
                    </a:lnTo>
                    <a:lnTo>
                      <a:pt x="3937" y="850"/>
                    </a:lnTo>
                    <a:lnTo>
                      <a:pt x="3951" y="850"/>
                    </a:lnTo>
                    <a:lnTo>
                      <a:pt x="3965" y="850"/>
                    </a:lnTo>
                    <a:lnTo>
                      <a:pt x="3979" y="850"/>
                    </a:lnTo>
                    <a:lnTo>
                      <a:pt x="3992" y="850"/>
                    </a:lnTo>
                    <a:lnTo>
                      <a:pt x="4006" y="850"/>
                    </a:lnTo>
                    <a:lnTo>
                      <a:pt x="4020" y="850"/>
                    </a:lnTo>
                    <a:lnTo>
                      <a:pt x="4034" y="850"/>
                    </a:lnTo>
                    <a:lnTo>
                      <a:pt x="4048" y="850"/>
                    </a:lnTo>
                    <a:lnTo>
                      <a:pt x="4062" y="850"/>
                    </a:lnTo>
                    <a:lnTo>
                      <a:pt x="4076" y="850"/>
                    </a:lnTo>
                    <a:lnTo>
                      <a:pt x="4090" y="850"/>
                    </a:lnTo>
                    <a:lnTo>
                      <a:pt x="4103" y="850"/>
                    </a:lnTo>
                    <a:lnTo>
                      <a:pt x="4117" y="850"/>
                    </a:lnTo>
                    <a:lnTo>
                      <a:pt x="4131" y="850"/>
                    </a:lnTo>
                    <a:lnTo>
                      <a:pt x="4145" y="850"/>
                    </a:lnTo>
                    <a:lnTo>
                      <a:pt x="4159" y="850"/>
                    </a:lnTo>
                    <a:lnTo>
                      <a:pt x="4173" y="850"/>
                    </a:lnTo>
                    <a:lnTo>
                      <a:pt x="4187" y="850"/>
                    </a:lnTo>
                    <a:lnTo>
                      <a:pt x="4201" y="850"/>
                    </a:lnTo>
                    <a:lnTo>
                      <a:pt x="4214" y="850"/>
                    </a:lnTo>
                    <a:lnTo>
                      <a:pt x="4228" y="850"/>
                    </a:lnTo>
                    <a:lnTo>
                      <a:pt x="4242" y="850"/>
                    </a:lnTo>
                    <a:lnTo>
                      <a:pt x="4256" y="850"/>
                    </a:lnTo>
                    <a:lnTo>
                      <a:pt x="4270" y="850"/>
                    </a:lnTo>
                    <a:lnTo>
                      <a:pt x="4287" y="850"/>
                    </a:lnTo>
                    <a:lnTo>
                      <a:pt x="4301" y="850"/>
                    </a:lnTo>
                    <a:lnTo>
                      <a:pt x="4315" y="850"/>
                    </a:lnTo>
                    <a:lnTo>
                      <a:pt x="4329" y="850"/>
                    </a:lnTo>
                    <a:lnTo>
                      <a:pt x="4343" y="850"/>
                    </a:lnTo>
                    <a:lnTo>
                      <a:pt x="4357" y="850"/>
                    </a:lnTo>
                    <a:lnTo>
                      <a:pt x="4370" y="850"/>
                    </a:lnTo>
                    <a:lnTo>
                      <a:pt x="4384" y="850"/>
                    </a:lnTo>
                    <a:lnTo>
                      <a:pt x="4398" y="850"/>
                    </a:lnTo>
                    <a:lnTo>
                      <a:pt x="4412" y="850"/>
                    </a:lnTo>
                    <a:lnTo>
                      <a:pt x="4426" y="850"/>
                    </a:lnTo>
                    <a:lnTo>
                      <a:pt x="4440" y="850"/>
                    </a:lnTo>
                    <a:lnTo>
                      <a:pt x="4454" y="850"/>
                    </a:lnTo>
                    <a:lnTo>
                      <a:pt x="4468" y="850"/>
                    </a:lnTo>
                    <a:lnTo>
                      <a:pt x="4481" y="850"/>
                    </a:lnTo>
                    <a:lnTo>
                      <a:pt x="4495" y="850"/>
                    </a:lnTo>
                    <a:lnTo>
                      <a:pt x="4509" y="850"/>
                    </a:lnTo>
                    <a:lnTo>
                      <a:pt x="4523" y="850"/>
                    </a:lnTo>
                    <a:lnTo>
                      <a:pt x="4537" y="850"/>
                    </a:lnTo>
                    <a:lnTo>
                      <a:pt x="4551" y="850"/>
                    </a:lnTo>
                    <a:lnTo>
                      <a:pt x="4565" y="850"/>
                    </a:lnTo>
                    <a:lnTo>
                      <a:pt x="4579" y="850"/>
                    </a:lnTo>
                    <a:lnTo>
                      <a:pt x="4592" y="850"/>
                    </a:lnTo>
                    <a:lnTo>
                      <a:pt x="4606" y="850"/>
                    </a:lnTo>
                    <a:lnTo>
                      <a:pt x="4620" y="850"/>
                    </a:lnTo>
                    <a:lnTo>
                      <a:pt x="4634" y="850"/>
                    </a:lnTo>
                    <a:lnTo>
                      <a:pt x="4648" y="850"/>
                    </a:lnTo>
                    <a:lnTo>
                      <a:pt x="4662" y="850"/>
                    </a:lnTo>
                    <a:lnTo>
                      <a:pt x="4676" y="850"/>
                    </a:lnTo>
                    <a:lnTo>
                      <a:pt x="4690" y="850"/>
                    </a:lnTo>
                    <a:lnTo>
                      <a:pt x="4703" y="850"/>
                    </a:lnTo>
                    <a:lnTo>
                      <a:pt x="4717" y="850"/>
                    </a:lnTo>
                    <a:lnTo>
                      <a:pt x="4731" y="850"/>
                    </a:lnTo>
                    <a:lnTo>
                      <a:pt x="4745" y="850"/>
                    </a:lnTo>
                    <a:lnTo>
                      <a:pt x="4759" y="850"/>
                    </a:lnTo>
                    <a:lnTo>
                      <a:pt x="4773" y="850"/>
                    </a:lnTo>
                    <a:lnTo>
                      <a:pt x="4787" y="850"/>
                    </a:lnTo>
                    <a:lnTo>
                      <a:pt x="4801" y="850"/>
                    </a:lnTo>
                    <a:lnTo>
                      <a:pt x="4818" y="850"/>
                    </a:lnTo>
                    <a:lnTo>
                      <a:pt x="4832" y="850"/>
                    </a:lnTo>
                    <a:lnTo>
                      <a:pt x="4846" y="850"/>
                    </a:lnTo>
                    <a:lnTo>
                      <a:pt x="4860" y="850"/>
                    </a:lnTo>
                    <a:lnTo>
                      <a:pt x="4873" y="850"/>
                    </a:lnTo>
                    <a:lnTo>
                      <a:pt x="4887" y="850"/>
                    </a:lnTo>
                    <a:lnTo>
                      <a:pt x="4901" y="850"/>
                    </a:lnTo>
                    <a:lnTo>
                      <a:pt x="4915" y="850"/>
                    </a:lnTo>
                    <a:lnTo>
                      <a:pt x="4929" y="850"/>
                    </a:lnTo>
                    <a:lnTo>
                      <a:pt x="4943" y="850"/>
                    </a:lnTo>
                    <a:lnTo>
                      <a:pt x="4957" y="850"/>
                    </a:lnTo>
                    <a:lnTo>
                      <a:pt x="4971" y="850"/>
                    </a:lnTo>
                    <a:lnTo>
                      <a:pt x="4984" y="850"/>
                    </a:lnTo>
                    <a:lnTo>
                      <a:pt x="4998" y="850"/>
                    </a:lnTo>
                    <a:lnTo>
                      <a:pt x="5012" y="850"/>
                    </a:lnTo>
                    <a:lnTo>
                      <a:pt x="5026" y="850"/>
                    </a:lnTo>
                    <a:lnTo>
                      <a:pt x="5040" y="850"/>
                    </a:lnTo>
                    <a:lnTo>
                      <a:pt x="5054" y="850"/>
                    </a:lnTo>
                    <a:lnTo>
                      <a:pt x="5068" y="850"/>
                    </a:lnTo>
                    <a:lnTo>
                      <a:pt x="5082" y="850"/>
                    </a:lnTo>
                    <a:lnTo>
                      <a:pt x="5095" y="850"/>
                    </a:lnTo>
                    <a:lnTo>
                      <a:pt x="5109" y="850"/>
                    </a:lnTo>
                    <a:lnTo>
                      <a:pt x="5123" y="850"/>
                    </a:lnTo>
                    <a:lnTo>
                      <a:pt x="5137" y="850"/>
                    </a:lnTo>
                    <a:lnTo>
                      <a:pt x="5151" y="850"/>
                    </a:lnTo>
                    <a:lnTo>
                      <a:pt x="5165" y="850"/>
                    </a:lnTo>
                    <a:lnTo>
                      <a:pt x="5179" y="850"/>
                    </a:lnTo>
                    <a:lnTo>
                      <a:pt x="5193" y="850"/>
                    </a:lnTo>
                    <a:lnTo>
                      <a:pt x="5206" y="850"/>
                    </a:lnTo>
                    <a:lnTo>
                      <a:pt x="5220" y="850"/>
                    </a:lnTo>
                    <a:lnTo>
                      <a:pt x="5234" y="850"/>
                    </a:lnTo>
                    <a:lnTo>
                      <a:pt x="5248" y="850"/>
                    </a:lnTo>
                    <a:lnTo>
                      <a:pt x="5262" y="850"/>
                    </a:lnTo>
                    <a:lnTo>
                      <a:pt x="5276" y="850"/>
                    </a:lnTo>
                    <a:lnTo>
                      <a:pt x="5290" y="850"/>
                    </a:lnTo>
                    <a:lnTo>
                      <a:pt x="5304" y="850"/>
                    </a:lnTo>
                    <a:lnTo>
                      <a:pt x="5317" y="850"/>
                    </a:lnTo>
                    <a:lnTo>
                      <a:pt x="5331" y="850"/>
                    </a:lnTo>
                    <a:lnTo>
                      <a:pt x="5345" y="850"/>
                    </a:lnTo>
                    <a:lnTo>
                      <a:pt x="5363" y="850"/>
                    </a:lnTo>
                    <a:lnTo>
                      <a:pt x="5376" y="850"/>
                    </a:lnTo>
                    <a:lnTo>
                      <a:pt x="5390" y="850"/>
                    </a:lnTo>
                    <a:lnTo>
                      <a:pt x="5404" y="850"/>
                    </a:lnTo>
                    <a:lnTo>
                      <a:pt x="5418" y="850"/>
                    </a:lnTo>
                    <a:lnTo>
                      <a:pt x="5432" y="850"/>
                    </a:lnTo>
                    <a:lnTo>
                      <a:pt x="5446" y="850"/>
                    </a:lnTo>
                    <a:lnTo>
                      <a:pt x="5460" y="850"/>
                    </a:lnTo>
                    <a:lnTo>
                      <a:pt x="5473" y="850"/>
                    </a:lnTo>
                    <a:lnTo>
                      <a:pt x="5487" y="850"/>
                    </a:lnTo>
                    <a:lnTo>
                      <a:pt x="5501" y="850"/>
                    </a:lnTo>
                    <a:lnTo>
                      <a:pt x="5515" y="850"/>
                    </a:lnTo>
                    <a:lnTo>
                      <a:pt x="5529" y="850"/>
                    </a:lnTo>
                    <a:lnTo>
                      <a:pt x="5543" y="850"/>
                    </a:lnTo>
                    <a:lnTo>
                      <a:pt x="5557" y="850"/>
                    </a:lnTo>
                    <a:lnTo>
                      <a:pt x="5571" y="850"/>
                    </a:lnTo>
                    <a:lnTo>
                      <a:pt x="5584" y="850"/>
                    </a:lnTo>
                    <a:lnTo>
                      <a:pt x="5598" y="850"/>
                    </a:lnTo>
                    <a:lnTo>
                      <a:pt x="5612" y="850"/>
                    </a:lnTo>
                    <a:lnTo>
                      <a:pt x="5626" y="85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22" name="Rectangle 44">
                <a:extLst>
                  <a:ext uri="{FF2B5EF4-FFF2-40B4-BE49-F238E27FC236}">
                    <a16:creationId xmlns:a16="http://schemas.microsoft.com/office/drawing/2014/main" id="{C857CC67-0BBC-F9D1-3E60-70F71277C1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78085" y="89694"/>
                <a:ext cx="67326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5.884 min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24" name="Line 46">
                <a:extLst>
                  <a:ext uri="{FF2B5EF4-FFF2-40B4-BE49-F238E27FC236}">
                    <a16:creationId xmlns:a16="http://schemas.microsoft.com/office/drawing/2014/main" id="{991DAC12-E12F-41E0-2ACA-797A8CA22B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28651" y="142875"/>
                <a:ext cx="0" cy="1520825"/>
              </a:xfrm>
              <a:prstGeom prst="line">
                <a:avLst/>
              </a:prstGeom>
              <a:noFill/>
              <a:ln w="4763" cap="flat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25" name="Rectangle 47">
                <a:extLst>
                  <a:ext uri="{FF2B5EF4-FFF2-40B4-BE49-F238E27FC236}">
                    <a16:creationId xmlns:a16="http://schemas.microsoft.com/office/drawing/2014/main" id="{752AC80D-5A69-0EDF-E1B3-7B3DE78591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9763" y="142875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8080"/>
                    </a:solidFill>
                    <a:effectLst/>
                    <a:latin typeface="Helvetica" pitchFamily="2" charset="0"/>
                  </a:rPr>
                  <a:t>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30" name="Line 52">
                <a:extLst>
                  <a:ext uri="{FF2B5EF4-FFF2-40B4-BE49-F238E27FC236}">
                    <a16:creationId xmlns:a16="http://schemas.microsoft.com/office/drawing/2014/main" id="{1CBD78DB-FCD9-89BD-D8CE-B75A89BF9B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00076" y="1812925"/>
                <a:ext cx="0" cy="148590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31" name="Rectangle 53">
                <a:extLst>
                  <a:ext uri="{FF2B5EF4-FFF2-40B4-BE49-F238E27FC236}">
                    <a16:creationId xmlns:a16="http://schemas.microsoft.com/office/drawing/2014/main" id="{6C0C3840-09EC-E26F-F8DD-7CB9429C73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9751" y="1701800"/>
                <a:ext cx="28854" cy="615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32" name="Rectangle 54">
                <a:extLst>
                  <a:ext uri="{FF2B5EF4-FFF2-40B4-BE49-F238E27FC236}">
                    <a16:creationId xmlns:a16="http://schemas.microsoft.com/office/drawing/2014/main" id="{93A4B441-6659-4363-C071-9996BF38C2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3863" y="1712913"/>
                <a:ext cx="10259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x1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33" name="Line 55">
                <a:extLst>
                  <a:ext uri="{FF2B5EF4-FFF2-40B4-BE49-F238E27FC236}">
                    <a16:creationId xmlns:a16="http://schemas.microsoft.com/office/drawing/2014/main" id="{8CAC47DD-9392-9450-7874-470C720F325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3298825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34" name="Rectangle 56">
                <a:extLst>
                  <a:ext uri="{FF2B5EF4-FFF2-40B4-BE49-F238E27FC236}">
                    <a16:creationId xmlns:a16="http://schemas.microsoft.com/office/drawing/2014/main" id="{71CF0F58-BF79-8CC1-72FF-7DE8AAEFB9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988" y="3260725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35" name="Line 57">
                <a:extLst>
                  <a:ext uri="{FF2B5EF4-FFF2-40B4-BE49-F238E27FC236}">
                    <a16:creationId xmlns:a16="http://schemas.microsoft.com/office/drawing/2014/main" id="{00105112-F4B1-EBF4-9E99-5C68792FE9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3195638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36" name="Rectangle 58">
                <a:extLst>
                  <a:ext uri="{FF2B5EF4-FFF2-40B4-BE49-F238E27FC236}">
                    <a16:creationId xmlns:a16="http://schemas.microsoft.com/office/drawing/2014/main" id="{3FF43129-4309-3D41-CABA-E4DAD5606C2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2438" y="3155950"/>
                <a:ext cx="1234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2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37" name="Line 59">
                <a:extLst>
                  <a:ext uri="{FF2B5EF4-FFF2-40B4-BE49-F238E27FC236}">
                    <a16:creationId xmlns:a16="http://schemas.microsoft.com/office/drawing/2014/main" id="{93122845-AB53-07B2-0C13-92497F36BA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3095625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38" name="Rectangle 60">
                <a:extLst>
                  <a:ext uri="{FF2B5EF4-FFF2-40B4-BE49-F238E27FC236}">
                    <a16:creationId xmlns:a16="http://schemas.microsoft.com/office/drawing/2014/main" id="{14639301-A3AC-714E-0588-B1EB384E2A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3055938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39" name="Line 61">
                <a:extLst>
                  <a:ext uri="{FF2B5EF4-FFF2-40B4-BE49-F238E27FC236}">
                    <a16:creationId xmlns:a16="http://schemas.microsoft.com/office/drawing/2014/main" id="{66C90A1F-35E8-1F7E-EF8C-389CF5C78A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2990850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40" name="Rectangle 62">
                <a:extLst>
                  <a:ext uri="{FF2B5EF4-FFF2-40B4-BE49-F238E27FC236}">
                    <a16:creationId xmlns:a16="http://schemas.microsoft.com/office/drawing/2014/main" id="{BD5E8081-7C5D-4CFB-68D0-CEA452B57EA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2438" y="2952750"/>
                <a:ext cx="1234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7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41" name="Line 63">
                <a:extLst>
                  <a:ext uri="{FF2B5EF4-FFF2-40B4-BE49-F238E27FC236}">
                    <a16:creationId xmlns:a16="http://schemas.microsoft.com/office/drawing/2014/main" id="{E41D80DB-FA9F-4E0C-CA46-24ABC99F305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2886075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42" name="Rectangle 64">
                <a:extLst>
                  <a:ext uri="{FF2B5EF4-FFF2-40B4-BE49-F238E27FC236}">
                    <a16:creationId xmlns:a16="http://schemas.microsoft.com/office/drawing/2014/main" id="{DA894873-0C31-D3FD-572D-97392D15EF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988" y="2847975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43" name="Line 65">
                <a:extLst>
                  <a:ext uri="{FF2B5EF4-FFF2-40B4-BE49-F238E27FC236}">
                    <a16:creationId xmlns:a16="http://schemas.microsoft.com/office/drawing/2014/main" id="{6D8A398C-E0D1-A22B-041B-307E66214C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2787650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44" name="Rectangle 66">
                <a:extLst>
                  <a:ext uri="{FF2B5EF4-FFF2-40B4-BE49-F238E27FC236}">
                    <a16:creationId xmlns:a16="http://schemas.microsoft.com/office/drawing/2014/main" id="{9C7D6D55-FF2B-FD4E-512B-1CA7CB524F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2438" y="2747963"/>
                <a:ext cx="1234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2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45" name="Line 67">
                <a:extLst>
                  <a:ext uri="{FF2B5EF4-FFF2-40B4-BE49-F238E27FC236}">
                    <a16:creationId xmlns:a16="http://schemas.microsoft.com/office/drawing/2014/main" id="{01665D82-F955-F816-6547-FA293FFDFF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2682875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46" name="Rectangle 68">
                <a:extLst>
                  <a:ext uri="{FF2B5EF4-FFF2-40B4-BE49-F238E27FC236}">
                    <a16:creationId xmlns:a16="http://schemas.microsoft.com/office/drawing/2014/main" id="{C34BF49F-084F-6C29-449D-B10C7F0E3A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2643188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47" name="Line 69">
                <a:extLst>
                  <a:ext uri="{FF2B5EF4-FFF2-40B4-BE49-F238E27FC236}">
                    <a16:creationId xmlns:a16="http://schemas.microsoft.com/office/drawing/2014/main" id="{558809F3-8A5A-6493-40A5-FDC5E6EFE0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2578100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48" name="Rectangle 70">
                <a:extLst>
                  <a:ext uri="{FF2B5EF4-FFF2-40B4-BE49-F238E27FC236}">
                    <a16:creationId xmlns:a16="http://schemas.microsoft.com/office/drawing/2014/main" id="{F7BF474A-2632-70F6-2E5B-F9B8B49B39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2438" y="2538413"/>
                <a:ext cx="1234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7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49" name="Line 71">
                <a:extLst>
                  <a:ext uri="{FF2B5EF4-FFF2-40B4-BE49-F238E27FC236}">
                    <a16:creationId xmlns:a16="http://schemas.microsoft.com/office/drawing/2014/main" id="{9467AE6B-FA3E-8AE1-1571-7D356C82C9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2478088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50" name="Rectangle 72">
                <a:extLst>
                  <a:ext uri="{FF2B5EF4-FFF2-40B4-BE49-F238E27FC236}">
                    <a16:creationId xmlns:a16="http://schemas.microsoft.com/office/drawing/2014/main" id="{A280F0D3-297E-79A7-C18F-BF3573DDCF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988" y="2439988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51" name="Line 73">
                <a:extLst>
                  <a:ext uri="{FF2B5EF4-FFF2-40B4-BE49-F238E27FC236}">
                    <a16:creationId xmlns:a16="http://schemas.microsoft.com/office/drawing/2014/main" id="{1EE0F808-A1FD-DCA0-FA16-E52603EE39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2374900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52" name="Rectangle 74">
                <a:extLst>
                  <a:ext uri="{FF2B5EF4-FFF2-40B4-BE49-F238E27FC236}">
                    <a16:creationId xmlns:a16="http://schemas.microsoft.com/office/drawing/2014/main" id="{313AC463-A850-8204-B2AA-44BDDD8788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2438" y="2335213"/>
                <a:ext cx="1234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.2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53" name="Line 75">
                <a:extLst>
                  <a:ext uri="{FF2B5EF4-FFF2-40B4-BE49-F238E27FC236}">
                    <a16:creationId xmlns:a16="http://schemas.microsoft.com/office/drawing/2014/main" id="{EBBBABB9-477C-DC0E-8E96-C46DD72529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2270125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54" name="Rectangle 76">
                <a:extLst>
                  <a:ext uri="{FF2B5EF4-FFF2-40B4-BE49-F238E27FC236}">
                    <a16:creationId xmlns:a16="http://schemas.microsoft.com/office/drawing/2014/main" id="{8010B831-1B51-A7AE-C697-33641AB879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2230438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55" name="Line 77">
                <a:extLst>
                  <a:ext uri="{FF2B5EF4-FFF2-40B4-BE49-F238E27FC236}">
                    <a16:creationId xmlns:a16="http://schemas.microsoft.com/office/drawing/2014/main" id="{AB627BA5-089C-6DF7-1394-40A2D35810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2165350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56" name="Rectangle 78">
                <a:extLst>
                  <a:ext uri="{FF2B5EF4-FFF2-40B4-BE49-F238E27FC236}">
                    <a16:creationId xmlns:a16="http://schemas.microsoft.com/office/drawing/2014/main" id="{6ADCF5A7-6A7A-1001-7A1E-5DAC1E9A826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2438" y="2125663"/>
                <a:ext cx="1234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.7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57" name="Line 79">
                <a:extLst>
                  <a:ext uri="{FF2B5EF4-FFF2-40B4-BE49-F238E27FC236}">
                    <a16:creationId xmlns:a16="http://schemas.microsoft.com/office/drawing/2014/main" id="{0C6963B6-FB8F-C3D8-46D5-26B8D6AB94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2065338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58" name="Rectangle 80">
                <a:extLst>
                  <a:ext uri="{FF2B5EF4-FFF2-40B4-BE49-F238E27FC236}">
                    <a16:creationId xmlns:a16="http://schemas.microsoft.com/office/drawing/2014/main" id="{69B356B6-5485-6AD0-4F7F-C724BFF1246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988" y="2027238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59" name="Line 81">
                <a:extLst>
                  <a:ext uri="{FF2B5EF4-FFF2-40B4-BE49-F238E27FC236}">
                    <a16:creationId xmlns:a16="http://schemas.microsoft.com/office/drawing/2014/main" id="{178A1A77-E7AE-C163-FD42-7148C2710C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1960563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60" name="Rectangle 82">
                <a:extLst>
                  <a:ext uri="{FF2B5EF4-FFF2-40B4-BE49-F238E27FC236}">
                    <a16:creationId xmlns:a16="http://schemas.microsoft.com/office/drawing/2014/main" id="{03313900-9D2A-F3CC-4FF2-F62A3A9F13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2438" y="1922463"/>
                <a:ext cx="12343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.2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61" name="Line 83">
                <a:extLst>
                  <a:ext uri="{FF2B5EF4-FFF2-40B4-BE49-F238E27FC236}">
                    <a16:creationId xmlns:a16="http://schemas.microsoft.com/office/drawing/2014/main" id="{FF66E2DD-A142-9E8C-454A-F3781CC9AC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1855788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62" name="Rectangle 84">
                <a:extLst>
                  <a:ext uri="{FF2B5EF4-FFF2-40B4-BE49-F238E27FC236}">
                    <a16:creationId xmlns:a16="http://schemas.microsoft.com/office/drawing/2014/main" id="{AB2B3D85-2B20-C164-EDAD-A1C8D74D00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1817688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63" name="Rectangle 85">
                <a:extLst>
                  <a:ext uri="{FF2B5EF4-FFF2-40B4-BE49-F238E27FC236}">
                    <a16:creationId xmlns:a16="http://schemas.microsoft.com/office/drawing/2014/main" id="{70328D9D-98A8-D6DD-9884-C78D96167D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6426" y="1668463"/>
                <a:ext cx="11277600" cy="166370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64" name="Rectangle 86">
                <a:extLst>
                  <a:ext uri="{FF2B5EF4-FFF2-40B4-BE49-F238E27FC236}">
                    <a16:creationId xmlns:a16="http://schemas.microsoft.com/office/drawing/2014/main" id="{7469CE4B-A2C4-9ACC-E888-C96D447C8A3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538" y="1812925"/>
                <a:ext cx="11249025" cy="148590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65" name="Rectangle 87">
                <a:extLst>
                  <a:ext uri="{FF2B5EF4-FFF2-40B4-BE49-F238E27FC236}">
                    <a16:creationId xmlns:a16="http://schemas.microsoft.com/office/drawing/2014/main" id="{DEB78F2B-78E3-E81C-45F3-09638D40F0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3641" y="1706564"/>
                <a:ext cx="1838324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6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VMR_Eg1-2</a:t>
                </a:r>
                <a:endParaRPr kumimoji="0" lang="en-US" altLang="en-US" sz="60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67" name="Freeform 89">
                <a:extLst>
                  <a:ext uri="{FF2B5EF4-FFF2-40B4-BE49-F238E27FC236}">
                    <a16:creationId xmlns:a16="http://schemas.microsoft.com/office/drawing/2014/main" id="{24B68049-D288-E0BB-B7D0-4B79DC3F59F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83438" y="1947863"/>
                <a:ext cx="420688" cy="1350963"/>
              </a:xfrm>
              <a:custGeom>
                <a:avLst/>
                <a:gdLst>
                  <a:gd name="T0" fmla="*/ 0 w 265"/>
                  <a:gd name="T1" fmla="*/ 851 h 851"/>
                  <a:gd name="T2" fmla="*/ 13 w 265"/>
                  <a:gd name="T3" fmla="*/ 848 h 851"/>
                  <a:gd name="T4" fmla="*/ 28 w 265"/>
                  <a:gd name="T5" fmla="*/ 806 h 851"/>
                  <a:gd name="T6" fmla="*/ 41 w 265"/>
                  <a:gd name="T7" fmla="*/ 621 h 851"/>
                  <a:gd name="T8" fmla="*/ 56 w 265"/>
                  <a:gd name="T9" fmla="*/ 305 h 851"/>
                  <a:gd name="T10" fmla="*/ 69 w 265"/>
                  <a:gd name="T11" fmla="*/ 66 h 851"/>
                  <a:gd name="T12" fmla="*/ 83 w 265"/>
                  <a:gd name="T13" fmla="*/ 0 h 851"/>
                  <a:gd name="T14" fmla="*/ 97 w 265"/>
                  <a:gd name="T15" fmla="*/ 71 h 851"/>
                  <a:gd name="T16" fmla="*/ 111 w 265"/>
                  <a:gd name="T17" fmla="*/ 250 h 851"/>
                  <a:gd name="T18" fmla="*/ 125 w 265"/>
                  <a:gd name="T19" fmla="*/ 454 h 851"/>
                  <a:gd name="T20" fmla="*/ 139 w 265"/>
                  <a:gd name="T21" fmla="*/ 602 h 851"/>
                  <a:gd name="T22" fmla="*/ 153 w 265"/>
                  <a:gd name="T23" fmla="*/ 671 h 851"/>
                  <a:gd name="T24" fmla="*/ 167 w 265"/>
                  <a:gd name="T25" fmla="*/ 703 h 851"/>
                  <a:gd name="T26" fmla="*/ 181 w 265"/>
                  <a:gd name="T27" fmla="*/ 729 h 851"/>
                  <a:gd name="T28" fmla="*/ 195 w 265"/>
                  <a:gd name="T29" fmla="*/ 750 h 851"/>
                  <a:gd name="T30" fmla="*/ 209 w 265"/>
                  <a:gd name="T31" fmla="*/ 769 h 851"/>
                  <a:gd name="T32" fmla="*/ 223 w 265"/>
                  <a:gd name="T33" fmla="*/ 808 h 851"/>
                  <a:gd name="T34" fmla="*/ 237 w 265"/>
                  <a:gd name="T35" fmla="*/ 828 h 851"/>
                  <a:gd name="T36" fmla="*/ 251 w 265"/>
                  <a:gd name="T37" fmla="*/ 835 h 851"/>
                  <a:gd name="T38" fmla="*/ 265 w 265"/>
                  <a:gd name="T39" fmla="*/ 836 h 851"/>
                  <a:gd name="T40" fmla="*/ 265 w 265"/>
                  <a:gd name="T41" fmla="*/ 836 h 851"/>
                  <a:gd name="T42" fmla="*/ 265 w 265"/>
                  <a:gd name="T43" fmla="*/ 836 h 851"/>
                  <a:gd name="T44" fmla="*/ 0 w 265"/>
                  <a:gd name="T45" fmla="*/ 851 h 851"/>
                  <a:gd name="T46" fmla="*/ 0 w 265"/>
                  <a:gd name="T47" fmla="*/ 851 h 85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</a:cxnLst>
                <a:rect l="0" t="0" r="r" b="b"/>
                <a:pathLst>
                  <a:path w="265" h="851">
                    <a:moveTo>
                      <a:pt x="0" y="851"/>
                    </a:moveTo>
                    <a:lnTo>
                      <a:pt x="13" y="848"/>
                    </a:lnTo>
                    <a:lnTo>
                      <a:pt x="28" y="806"/>
                    </a:lnTo>
                    <a:lnTo>
                      <a:pt x="41" y="621"/>
                    </a:lnTo>
                    <a:lnTo>
                      <a:pt x="56" y="305"/>
                    </a:lnTo>
                    <a:lnTo>
                      <a:pt x="69" y="66"/>
                    </a:lnTo>
                    <a:lnTo>
                      <a:pt x="83" y="0"/>
                    </a:lnTo>
                    <a:lnTo>
                      <a:pt x="97" y="71"/>
                    </a:lnTo>
                    <a:lnTo>
                      <a:pt x="111" y="250"/>
                    </a:lnTo>
                    <a:lnTo>
                      <a:pt x="125" y="454"/>
                    </a:lnTo>
                    <a:lnTo>
                      <a:pt x="139" y="602"/>
                    </a:lnTo>
                    <a:lnTo>
                      <a:pt x="153" y="671"/>
                    </a:lnTo>
                    <a:lnTo>
                      <a:pt x="167" y="703"/>
                    </a:lnTo>
                    <a:lnTo>
                      <a:pt x="181" y="729"/>
                    </a:lnTo>
                    <a:lnTo>
                      <a:pt x="195" y="750"/>
                    </a:lnTo>
                    <a:lnTo>
                      <a:pt x="209" y="769"/>
                    </a:lnTo>
                    <a:lnTo>
                      <a:pt x="223" y="808"/>
                    </a:lnTo>
                    <a:lnTo>
                      <a:pt x="237" y="828"/>
                    </a:lnTo>
                    <a:lnTo>
                      <a:pt x="251" y="835"/>
                    </a:lnTo>
                    <a:lnTo>
                      <a:pt x="265" y="836"/>
                    </a:lnTo>
                    <a:lnTo>
                      <a:pt x="265" y="836"/>
                    </a:lnTo>
                    <a:lnTo>
                      <a:pt x="265" y="836"/>
                    </a:lnTo>
                    <a:lnTo>
                      <a:pt x="0" y="851"/>
                    </a:lnTo>
                    <a:lnTo>
                      <a:pt x="0" y="851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69" name="Freeform 91">
                <a:extLst>
                  <a:ext uri="{FF2B5EF4-FFF2-40B4-BE49-F238E27FC236}">
                    <a16:creationId xmlns:a16="http://schemas.microsoft.com/office/drawing/2014/main" id="{B23843C0-0B43-0A4A-5F91-FC4439EEFE4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83438" y="3275013"/>
                <a:ext cx="420688" cy="23813"/>
              </a:xfrm>
              <a:custGeom>
                <a:avLst/>
                <a:gdLst>
                  <a:gd name="T0" fmla="*/ 0 w 265"/>
                  <a:gd name="T1" fmla="*/ 15 h 15"/>
                  <a:gd name="T2" fmla="*/ 0 w 265"/>
                  <a:gd name="T3" fmla="*/ 15 h 15"/>
                  <a:gd name="T4" fmla="*/ 265 w 265"/>
                  <a:gd name="T5" fmla="*/ 0 h 15"/>
                  <a:gd name="T6" fmla="*/ 265 w 265"/>
                  <a:gd name="T7" fmla="*/ 0 h 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65" h="15">
                    <a:moveTo>
                      <a:pt x="0" y="15"/>
                    </a:moveTo>
                    <a:lnTo>
                      <a:pt x="0" y="15"/>
                    </a:lnTo>
                    <a:lnTo>
                      <a:pt x="265" y="0"/>
                    </a:lnTo>
                    <a:lnTo>
                      <a:pt x="265" y="0"/>
                    </a:lnTo>
                  </a:path>
                </a:pathLst>
              </a:cu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70" name="Freeform 92">
                <a:extLst>
                  <a:ext uri="{FF2B5EF4-FFF2-40B4-BE49-F238E27FC236}">
                    <a16:creationId xmlns:a16="http://schemas.microsoft.com/office/drawing/2014/main" id="{E1B06CA7-6223-8A30-6BF7-0CF76906A48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24176" y="1949450"/>
                <a:ext cx="8937625" cy="1349375"/>
              </a:xfrm>
              <a:custGeom>
                <a:avLst/>
                <a:gdLst>
                  <a:gd name="T0" fmla="*/ 87 w 5630"/>
                  <a:gd name="T1" fmla="*/ 850 h 850"/>
                  <a:gd name="T2" fmla="*/ 184 w 5630"/>
                  <a:gd name="T3" fmla="*/ 850 h 850"/>
                  <a:gd name="T4" fmla="*/ 281 w 5630"/>
                  <a:gd name="T5" fmla="*/ 850 h 850"/>
                  <a:gd name="T6" fmla="*/ 378 w 5630"/>
                  <a:gd name="T7" fmla="*/ 850 h 850"/>
                  <a:gd name="T8" fmla="*/ 475 w 5630"/>
                  <a:gd name="T9" fmla="*/ 850 h 850"/>
                  <a:gd name="T10" fmla="*/ 572 w 5630"/>
                  <a:gd name="T11" fmla="*/ 850 h 850"/>
                  <a:gd name="T12" fmla="*/ 673 w 5630"/>
                  <a:gd name="T13" fmla="*/ 850 h 850"/>
                  <a:gd name="T14" fmla="*/ 770 w 5630"/>
                  <a:gd name="T15" fmla="*/ 850 h 850"/>
                  <a:gd name="T16" fmla="*/ 867 w 5630"/>
                  <a:gd name="T17" fmla="*/ 850 h 850"/>
                  <a:gd name="T18" fmla="*/ 964 w 5630"/>
                  <a:gd name="T19" fmla="*/ 850 h 850"/>
                  <a:gd name="T20" fmla="*/ 1061 w 5630"/>
                  <a:gd name="T21" fmla="*/ 850 h 850"/>
                  <a:gd name="T22" fmla="*/ 1162 w 5630"/>
                  <a:gd name="T23" fmla="*/ 850 h 850"/>
                  <a:gd name="T24" fmla="*/ 1259 w 5630"/>
                  <a:gd name="T25" fmla="*/ 850 h 850"/>
                  <a:gd name="T26" fmla="*/ 1356 w 5630"/>
                  <a:gd name="T27" fmla="*/ 850 h 850"/>
                  <a:gd name="T28" fmla="*/ 1453 w 5630"/>
                  <a:gd name="T29" fmla="*/ 850 h 850"/>
                  <a:gd name="T30" fmla="*/ 1551 w 5630"/>
                  <a:gd name="T31" fmla="*/ 850 h 850"/>
                  <a:gd name="T32" fmla="*/ 1648 w 5630"/>
                  <a:gd name="T33" fmla="*/ 850 h 850"/>
                  <a:gd name="T34" fmla="*/ 1748 w 5630"/>
                  <a:gd name="T35" fmla="*/ 850 h 850"/>
                  <a:gd name="T36" fmla="*/ 1845 w 5630"/>
                  <a:gd name="T37" fmla="*/ 850 h 850"/>
                  <a:gd name="T38" fmla="*/ 1942 w 5630"/>
                  <a:gd name="T39" fmla="*/ 850 h 850"/>
                  <a:gd name="T40" fmla="*/ 2040 w 5630"/>
                  <a:gd name="T41" fmla="*/ 850 h 850"/>
                  <a:gd name="T42" fmla="*/ 2137 w 5630"/>
                  <a:gd name="T43" fmla="*/ 850 h 850"/>
                  <a:gd name="T44" fmla="*/ 2237 w 5630"/>
                  <a:gd name="T45" fmla="*/ 850 h 850"/>
                  <a:gd name="T46" fmla="*/ 2334 w 5630"/>
                  <a:gd name="T47" fmla="*/ 850 h 850"/>
                  <a:gd name="T48" fmla="*/ 2432 w 5630"/>
                  <a:gd name="T49" fmla="*/ 850 h 850"/>
                  <a:gd name="T50" fmla="*/ 2529 w 5630"/>
                  <a:gd name="T51" fmla="*/ 850 h 850"/>
                  <a:gd name="T52" fmla="*/ 2626 w 5630"/>
                  <a:gd name="T53" fmla="*/ 850 h 850"/>
                  <a:gd name="T54" fmla="*/ 2723 w 5630"/>
                  <a:gd name="T55" fmla="*/ 621 h 850"/>
                  <a:gd name="T56" fmla="*/ 2824 w 5630"/>
                  <a:gd name="T57" fmla="*/ 601 h 850"/>
                  <a:gd name="T58" fmla="*/ 2921 w 5630"/>
                  <a:gd name="T59" fmla="*/ 826 h 850"/>
                  <a:gd name="T60" fmla="*/ 3018 w 5630"/>
                  <a:gd name="T61" fmla="*/ 840 h 850"/>
                  <a:gd name="T62" fmla="*/ 3115 w 5630"/>
                  <a:gd name="T63" fmla="*/ 847 h 850"/>
                  <a:gd name="T64" fmla="*/ 3212 w 5630"/>
                  <a:gd name="T65" fmla="*/ 847 h 850"/>
                  <a:gd name="T66" fmla="*/ 3313 w 5630"/>
                  <a:gd name="T67" fmla="*/ 847 h 850"/>
                  <a:gd name="T68" fmla="*/ 3410 w 5630"/>
                  <a:gd name="T69" fmla="*/ 850 h 850"/>
                  <a:gd name="T70" fmla="*/ 3507 w 5630"/>
                  <a:gd name="T71" fmla="*/ 850 h 850"/>
                  <a:gd name="T72" fmla="*/ 3604 w 5630"/>
                  <a:gd name="T73" fmla="*/ 850 h 850"/>
                  <a:gd name="T74" fmla="*/ 3701 w 5630"/>
                  <a:gd name="T75" fmla="*/ 850 h 850"/>
                  <a:gd name="T76" fmla="*/ 3798 w 5630"/>
                  <a:gd name="T77" fmla="*/ 850 h 850"/>
                  <a:gd name="T78" fmla="*/ 3899 w 5630"/>
                  <a:gd name="T79" fmla="*/ 850 h 850"/>
                  <a:gd name="T80" fmla="*/ 3996 w 5630"/>
                  <a:gd name="T81" fmla="*/ 850 h 850"/>
                  <a:gd name="T82" fmla="*/ 4093 w 5630"/>
                  <a:gd name="T83" fmla="*/ 850 h 850"/>
                  <a:gd name="T84" fmla="*/ 4190 w 5630"/>
                  <a:gd name="T85" fmla="*/ 850 h 850"/>
                  <a:gd name="T86" fmla="*/ 4287 w 5630"/>
                  <a:gd name="T87" fmla="*/ 850 h 850"/>
                  <a:gd name="T88" fmla="*/ 4388 w 5630"/>
                  <a:gd name="T89" fmla="*/ 850 h 850"/>
                  <a:gd name="T90" fmla="*/ 4485 w 5630"/>
                  <a:gd name="T91" fmla="*/ 850 h 850"/>
                  <a:gd name="T92" fmla="*/ 4582 w 5630"/>
                  <a:gd name="T93" fmla="*/ 850 h 850"/>
                  <a:gd name="T94" fmla="*/ 4679 w 5630"/>
                  <a:gd name="T95" fmla="*/ 850 h 850"/>
                  <a:gd name="T96" fmla="*/ 4776 w 5630"/>
                  <a:gd name="T97" fmla="*/ 850 h 850"/>
                  <a:gd name="T98" fmla="*/ 4873 w 5630"/>
                  <a:gd name="T99" fmla="*/ 850 h 850"/>
                  <a:gd name="T100" fmla="*/ 4974 w 5630"/>
                  <a:gd name="T101" fmla="*/ 850 h 850"/>
                  <a:gd name="T102" fmla="*/ 5071 w 5630"/>
                  <a:gd name="T103" fmla="*/ 850 h 850"/>
                  <a:gd name="T104" fmla="*/ 5168 w 5630"/>
                  <a:gd name="T105" fmla="*/ 850 h 850"/>
                  <a:gd name="T106" fmla="*/ 5265 w 5630"/>
                  <a:gd name="T107" fmla="*/ 850 h 850"/>
                  <a:gd name="T108" fmla="*/ 5363 w 5630"/>
                  <a:gd name="T109" fmla="*/ 850 h 850"/>
                  <a:gd name="T110" fmla="*/ 5460 w 5630"/>
                  <a:gd name="T111" fmla="*/ 850 h 850"/>
                  <a:gd name="T112" fmla="*/ 5560 w 5630"/>
                  <a:gd name="T113" fmla="*/ 850 h 8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</a:cxnLst>
                <a:rect l="0" t="0" r="r" b="b"/>
                <a:pathLst>
                  <a:path w="5630" h="850">
                    <a:moveTo>
                      <a:pt x="0" y="850"/>
                    </a:moveTo>
                    <a:lnTo>
                      <a:pt x="14" y="850"/>
                    </a:lnTo>
                    <a:lnTo>
                      <a:pt x="28" y="850"/>
                    </a:lnTo>
                    <a:lnTo>
                      <a:pt x="42" y="850"/>
                    </a:lnTo>
                    <a:lnTo>
                      <a:pt x="56" y="850"/>
                    </a:lnTo>
                    <a:lnTo>
                      <a:pt x="73" y="850"/>
                    </a:lnTo>
                    <a:lnTo>
                      <a:pt x="87" y="850"/>
                    </a:lnTo>
                    <a:lnTo>
                      <a:pt x="101" y="850"/>
                    </a:lnTo>
                    <a:lnTo>
                      <a:pt x="115" y="850"/>
                    </a:lnTo>
                    <a:lnTo>
                      <a:pt x="128" y="850"/>
                    </a:lnTo>
                    <a:lnTo>
                      <a:pt x="142" y="850"/>
                    </a:lnTo>
                    <a:lnTo>
                      <a:pt x="156" y="850"/>
                    </a:lnTo>
                    <a:lnTo>
                      <a:pt x="170" y="850"/>
                    </a:lnTo>
                    <a:lnTo>
                      <a:pt x="184" y="850"/>
                    </a:lnTo>
                    <a:lnTo>
                      <a:pt x="198" y="850"/>
                    </a:lnTo>
                    <a:lnTo>
                      <a:pt x="212" y="850"/>
                    </a:lnTo>
                    <a:lnTo>
                      <a:pt x="226" y="850"/>
                    </a:lnTo>
                    <a:lnTo>
                      <a:pt x="239" y="850"/>
                    </a:lnTo>
                    <a:lnTo>
                      <a:pt x="253" y="850"/>
                    </a:lnTo>
                    <a:lnTo>
                      <a:pt x="267" y="850"/>
                    </a:lnTo>
                    <a:lnTo>
                      <a:pt x="281" y="850"/>
                    </a:lnTo>
                    <a:lnTo>
                      <a:pt x="295" y="850"/>
                    </a:lnTo>
                    <a:lnTo>
                      <a:pt x="309" y="850"/>
                    </a:lnTo>
                    <a:lnTo>
                      <a:pt x="323" y="850"/>
                    </a:lnTo>
                    <a:lnTo>
                      <a:pt x="337" y="850"/>
                    </a:lnTo>
                    <a:lnTo>
                      <a:pt x="350" y="850"/>
                    </a:lnTo>
                    <a:lnTo>
                      <a:pt x="364" y="850"/>
                    </a:lnTo>
                    <a:lnTo>
                      <a:pt x="378" y="850"/>
                    </a:lnTo>
                    <a:lnTo>
                      <a:pt x="392" y="850"/>
                    </a:lnTo>
                    <a:lnTo>
                      <a:pt x="406" y="850"/>
                    </a:lnTo>
                    <a:lnTo>
                      <a:pt x="420" y="850"/>
                    </a:lnTo>
                    <a:lnTo>
                      <a:pt x="434" y="850"/>
                    </a:lnTo>
                    <a:lnTo>
                      <a:pt x="448" y="850"/>
                    </a:lnTo>
                    <a:lnTo>
                      <a:pt x="461" y="850"/>
                    </a:lnTo>
                    <a:lnTo>
                      <a:pt x="475" y="850"/>
                    </a:lnTo>
                    <a:lnTo>
                      <a:pt x="489" y="850"/>
                    </a:lnTo>
                    <a:lnTo>
                      <a:pt x="503" y="850"/>
                    </a:lnTo>
                    <a:lnTo>
                      <a:pt x="517" y="850"/>
                    </a:lnTo>
                    <a:lnTo>
                      <a:pt x="531" y="850"/>
                    </a:lnTo>
                    <a:lnTo>
                      <a:pt x="545" y="850"/>
                    </a:lnTo>
                    <a:lnTo>
                      <a:pt x="559" y="850"/>
                    </a:lnTo>
                    <a:lnTo>
                      <a:pt x="572" y="850"/>
                    </a:lnTo>
                    <a:lnTo>
                      <a:pt x="586" y="850"/>
                    </a:lnTo>
                    <a:lnTo>
                      <a:pt x="600" y="850"/>
                    </a:lnTo>
                    <a:lnTo>
                      <a:pt x="617" y="850"/>
                    </a:lnTo>
                    <a:lnTo>
                      <a:pt x="631" y="850"/>
                    </a:lnTo>
                    <a:lnTo>
                      <a:pt x="645" y="850"/>
                    </a:lnTo>
                    <a:lnTo>
                      <a:pt x="659" y="850"/>
                    </a:lnTo>
                    <a:lnTo>
                      <a:pt x="673" y="850"/>
                    </a:lnTo>
                    <a:lnTo>
                      <a:pt x="687" y="850"/>
                    </a:lnTo>
                    <a:lnTo>
                      <a:pt x="701" y="850"/>
                    </a:lnTo>
                    <a:lnTo>
                      <a:pt x="715" y="850"/>
                    </a:lnTo>
                    <a:lnTo>
                      <a:pt x="728" y="850"/>
                    </a:lnTo>
                    <a:lnTo>
                      <a:pt x="742" y="850"/>
                    </a:lnTo>
                    <a:lnTo>
                      <a:pt x="756" y="850"/>
                    </a:lnTo>
                    <a:lnTo>
                      <a:pt x="770" y="850"/>
                    </a:lnTo>
                    <a:lnTo>
                      <a:pt x="784" y="850"/>
                    </a:lnTo>
                    <a:lnTo>
                      <a:pt x="798" y="850"/>
                    </a:lnTo>
                    <a:lnTo>
                      <a:pt x="812" y="850"/>
                    </a:lnTo>
                    <a:lnTo>
                      <a:pt x="826" y="850"/>
                    </a:lnTo>
                    <a:lnTo>
                      <a:pt x="839" y="850"/>
                    </a:lnTo>
                    <a:lnTo>
                      <a:pt x="853" y="850"/>
                    </a:lnTo>
                    <a:lnTo>
                      <a:pt x="867" y="850"/>
                    </a:lnTo>
                    <a:lnTo>
                      <a:pt x="881" y="850"/>
                    </a:lnTo>
                    <a:lnTo>
                      <a:pt x="895" y="850"/>
                    </a:lnTo>
                    <a:lnTo>
                      <a:pt x="909" y="850"/>
                    </a:lnTo>
                    <a:lnTo>
                      <a:pt x="923" y="850"/>
                    </a:lnTo>
                    <a:lnTo>
                      <a:pt x="937" y="850"/>
                    </a:lnTo>
                    <a:lnTo>
                      <a:pt x="950" y="850"/>
                    </a:lnTo>
                    <a:lnTo>
                      <a:pt x="964" y="850"/>
                    </a:lnTo>
                    <a:lnTo>
                      <a:pt x="978" y="850"/>
                    </a:lnTo>
                    <a:lnTo>
                      <a:pt x="992" y="850"/>
                    </a:lnTo>
                    <a:lnTo>
                      <a:pt x="1006" y="850"/>
                    </a:lnTo>
                    <a:lnTo>
                      <a:pt x="1020" y="850"/>
                    </a:lnTo>
                    <a:lnTo>
                      <a:pt x="1034" y="850"/>
                    </a:lnTo>
                    <a:lnTo>
                      <a:pt x="1048" y="850"/>
                    </a:lnTo>
                    <a:lnTo>
                      <a:pt x="1061" y="850"/>
                    </a:lnTo>
                    <a:lnTo>
                      <a:pt x="1075" y="850"/>
                    </a:lnTo>
                    <a:lnTo>
                      <a:pt x="1089" y="850"/>
                    </a:lnTo>
                    <a:lnTo>
                      <a:pt x="1103" y="850"/>
                    </a:lnTo>
                    <a:lnTo>
                      <a:pt x="1117" y="850"/>
                    </a:lnTo>
                    <a:lnTo>
                      <a:pt x="1131" y="850"/>
                    </a:lnTo>
                    <a:lnTo>
                      <a:pt x="1145" y="850"/>
                    </a:lnTo>
                    <a:lnTo>
                      <a:pt x="1162" y="850"/>
                    </a:lnTo>
                    <a:lnTo>
                      <a:pt x="1176" y="850"/>
                    </a:lnTo>
                    <a:lnTo>
                      <a:pt x="1190" y="850"/>
                    </a:lnTo>
                    <a:lnTo>
                      <a:pt x="1204" y="850"/>
                    </a:lnTo>
                    <a:lnTo>
                      <a:pt x="1218" y="850"/>
                    </a:lnTo>
                    <a:lnTo>
                      <a:pt x="1231" y="850"/>
                    </a:lnTo>
                    <a:lnTo>
                      <a:pt x="1245" y="850"/>
                    </a:lnTo>
                    <a:lnTo>
                      <a:pt x="1259" y="850"/>
                    </a:lnTo>
                    <a:lnTo>
                      <a:pt x="1273" y="850"/>
                    </a:lnTo>
                    <a:lnTo>
                      <a:pt x="1287" y="850"/>
                    </a:lnTo>
                    <a:lnTo>
                      <a:pt x="1301" y="850"/>
                    </a:lnTo>
                    <a:lnTo>
                      <a:pt x="1315" y="850"/>
                    </a:lnTo>
                    <a:lnTo>
                      <a:pt x="1329" y="850"/>
                    </a:lnTo>
                    <a:lnTo>
                      <a:pt x="1342" y="850"/>
                    </a:lnTo>
                    <a:lnTo>
                      <a:pt x="1356" y="850"/>
                    </a:lnTo>
                    <a:lnTo>
                      <a:pt x="1370" y="850"/>
                    </a:lnTo>
                    <a:lnTo>
                      <a:pt x="1384" y="850"/>
                    </a:lnTo>
                    <a:lnTo>
                      <a:pt x="1398" y="850"/>
                    </a:lnTo>
                    <a:lnTo>
                      <a:pt x="1412" y="850"/>
                    </a:lnTo>
                    <a:lnTo>
                      <a:pt x="1426" y="850"/>
                    </a:lnTo>
                    <a:lnTo>
                      <a:pt x="1440" y="850"/>
                    </a:lnTo>
                    <a:lnTo>
                      <a:pt x="1453" y="850"/>
                    </a:lnTo>
                    <a:lnTo>
                      <a:pt x="1467" y="850"/>
                    </a:lnTo>
                    <a:lnTo>
                      <a:pt x="1481" y="850"/>
                    </a:lnTo>
                    <a:lnTo>
                      <a:pt x="1495" y="850"/>
                    </a:lnTo>
                    <a:lnTo>
                      <a:pt x="1509" y="850"/>
                    </a:lnTo>
                    <a:lnTo>
                      <a:pt x="1523" y="850"/>
                    </a:lnTo>
                    <a:lnTo>
                      <a:pt x="1537" y="850"/>
                    </a:lnTo>
                    <a:lnTo>
                      <a:pt x="1551" y="850"/>
                    </a:lnTo>
                    <a:lnTo>
                      <a:pt x="1564" y="850"/>
                    </a:lnTo>
                    <a:lnTo>
                      <a:pt x="1578" y="850"/>
                    </a:lnTo>
                    <a:lnTo>
                      <a:pt x="1592" y="850"/>
                    </a:lnTo>
                    <a:lnTo>
                      <a:pt x="1606" y="850"/>
                    </a:lnTo>
                    <a:lnTo>
                      <a:pt x="1620" y="850"/>
                    </a:lnTo>
                    <a:lnTo>
                      <a:pt x="1634" y="850"/>
                    </a:lnTo>
                    <a:lnTo>
                      <a:pt x="1648" y="850"/>
                    </a:lnTo>
                    <a:lnTo>
                      <a:pt x="1662" y="850"/>
                    </a:lnTo>
                    <a:lnTo>
                      <a:pt x="1675" y="850"/>
                    </a:lnTo>
                    <a:lnTo>
                      <a:pt x="1693" y="850"/>
                    </a:lnTo>
                    <a:lnTo>
                      <a:pt x="1707" y="850"/>
                    </a:lnTo>
                    <a:lnTo>
                      <a:pt x="1721" y="850"/>
                    </a:lnTo>
                    <a:lnTo>
                      <a:pt x="1734" y="850"/>
                    </a:lnTo>
                    <a:lnTo>
                      <a:pt x="1748" y="850"/>
                    </a:lnTo>
                    <a:lnTo>
                      <a:pt x="1762" y="850"/>
                    </a:lnTo>
                    <a:lnTo>
                      <a:pt x="1776" y="850"/>
                    </a:lnTo>
                    <a:lnTo>
                      <a:pt x="1790" y="850"/>
                    </a:lnTo>
                    <a:lnTo>
                      <a:pt x="1804" y="850"/>
                    </a:lnTo>
                    <a:lnTo>
                      <a:pt x="1818" y="850"/>
                    </a:lnTo>
                    <a:lnTo>
                      <a:pt x="1832" y="850"/>
                    </a:lnTo>
                    <a:lnTo>
                      <a:pt x="1845" y="850"/>
                    </a:lnTo>
                    <a:lnTo>
                      <a:pt x="1859" y="850"/>
                    </a:lnTo>
                    <a:lnTo>
                      <a:pt x="1873" y="850"/>
                    </a:lnTo>
                    <a:lnTo>
                      <a:pt x="1887" y="850"/>
                    </a:lnTo>
                    <a:lnTo>
                      <a:pt x="1901" y="850"/>
                    </a:lnTo>
                    <a:lnTo>
                      <a:pt x="1915" y="850"/>
                    </a:lnTo>
                    <a:lnTo>
                      <a:pt x="1929" y="850"/>
                    </a:lnTo>
                    <a:lnTo>
                      <a:pt x="1942" y="850"/>
                    </a:lnTo>
                    <a:lnTo>
                      <a:pt x="1956" y="850"/>
                    </a:lnTo>
                    <a:lnTo>
                      <a:pt x="1970" y="850"/>
                    </a:lnTo>
                    <a:lnTo>
                      <a:pt x="1984" y="850"/>
                    </a:lnTo>
                    <a:lnTo>
                      <a:pt x="1998" y="850"/>
                    </a:lnTo>
                    <a:lnTo>
                      <a:pt x="2012" y="850"/>
                    </a:lnTo>
                    <a:lnTo>
                      <a:pt x="2026" y="850"/>
                    </a:lnTo>
                    <a:lnTo>
                      <a:pt x="2040" y="850"/>
                    </a:lnTo>
                    <a:lnTo>
                      <a:pt x="2053" y="850"/>
                    </a:lnTo>
                    <a:lnTo>
                      <a:pt x="2067" y="850"/>
                    </a:lnTo>
                    <a:lnTo>
                      <a:pt x="2081" y="850"/>
                    </a:lnTo>
                    <a:lnTo>
                      <a:pt x="2095" y="850"/>
                    </a:lnTo>
                    <a:lnTo>
                      <a:pt x="2109" y="850"/>
                    </a:lnTo>
                    <a:lnTo>
                      <a:pt x="2123" y="850"/>
                    </a:lnTo>
                    <a:lnTo>
                      <a:pt x="2137" y="850"/>
                    </a:lnTo>
                    <a:lnTo>
                      <a:pt x="2151" y="850"/>
                    </a:lnTo>
                    <a:lnTo>
                      <a:pt x="2164" y="850"/>
                    </a:lnTo>
                    <a:lnTo>
                      <a:pt x="2178" y="850"/>
                    </a:lnTo>
                    <a:lnTo>
                      <a:pt x="2192" y="850"/>
                    </a:lnTo>
                    <a:lnTo>
                      <a:pt x="2206" y="850"/>
                    </a:lnTo>
                    <a:lnTo>
                      <a:pt x="2220" y="850"/>
                    </a:lnTo>
                    <a:lnTo>
                      <a:pt x="2237" y="850"/>
                    </a:lnTo>
                    <a:lnTo>
                      <a:pt x="2251" y="850"/>
                    </a:lnTo>
                    <a:lnTo>
                      <a:pt x="2265" y="850"/>
                    </a:lnTo>
                    <a:lnTo>
                      <a:pt x="2279" y="850"/>
                    </a:lnTo>
                    <a:lnTo>
                      <a:pt x="2293" y="850"/>
                    </a:lnTo>
                    <a:lnTo>
                      <a:pt x="2307" y="850"/>
                    </a:lnTo>
                    <a:lnTo>
                      <a:pt x="2321" y="850"/>
                    </a:lnTo>
                    <a:lnTo>
                      <a:pt x="2334" y="850"/>
                    </a:lnTo>
                    <a:lnTo>
                      <a:pt x="2348" y="850"/>
                    </a:lnTo>
                    <a:lnTo>
                      <a:pt x="2362" y="850"/>
                    </a:lnTo>
                    <a:lnTo>
                      <a:pt x="2376" y="850"/>
                    </a:lnTo>
                    <a:lnTo>
                      <a:pt x="2390" y="850"/>
                    </a:lnTo>
                    <a:lnTo>
                      <a:pt x="2404" y="850"/>
                    </a:lnTo>
                    <a:lnTo>
                      <a:pt x="2418" y="850"/>
                    </a:lnTo>
                    <a:lnTo>
                      <a:pt x="2432" y="850"/>
                    </a:lnTo>
                    <a:lnTo>
                      <a:pt x="2445" y="850"/>
                    </a:lnTo>
                    <a:lnTo>
                      <a:pt x="2459" y="850"/>
                    </a:lnTo>
                    <a:lnTo>
                      <a:pt x="2473" y="850"/>
                    </a:lnTo>
                    <a:lnTo>
                      <a:pt x="2487" y="850"/>
                    </a:lnTo>
                    <a:lnTo>
                      <a:pt x="2501" y="850"/>
                    </a:lnTo>
                    <a:lnTo>
                      <a:pt x="2515" y="850"/>
                    </a:lnTo>
                    <a:lnTo>
                      <a:pt x="2529" y="850"/>
                    </a:lnTo>
                    <a:lnTo>
                      <a:pt x="2543" y="850"/>
                    </a:lnTo>
                    <a:lnTo>
                      <a:pt x="2556" y="850"/>
                    </a:lnTo>
                    <a:lnTo>
                      <a:pt x="2570" y="850"/>
                    </a:lnTo>
                    <a:lnTo>
                      <a:pt x="2584" y="850"/>
                    </a:lnTo>
                    <a:lnTo>
                      <a:pt x="2598" y="850"/>
                    </a:lnTo>
                    <a:lnTo>
                      <a:pt x="2612" y="850"/>
                    </a:lnTo>
                    <a:lnTo>
                      <a:pt x="2626" y="850"/>
                    </a:lnTo>
                    <a:lnTo>
                      <a:pt x="2640" y="850"/>
                    </a:lnTo>
                    <a:lnTo>
                      <a:pt x="2654" y="850"/>
                    </a:lnTo>
                    <a:lnTo>
                      <a:pt x="2667" y="850"/>
                    </a:lnTo>
                    <a:lnTo>
                      <a:pt x="2681" y="850"/>
                    </a:lnTo>
                    <a:lnTo>
                      <a:pt x="2695" y="847"/>
                    </a:lnTo>
                    <a:lnTo>
                      <a:pt x="2709" y="805"/>
                    </a:lnTo>
                    <a:lnTo>
                      <a:pt x="2723" y="621"/>
                    </a:lnTo>
                    <a:lnTo>
                      <a:pt x="2737" y="302"/>
                    </a:lnTo>
                    <a:lnTo>
                      <a:pt x="2751" y="63"/>
                    </a:lnTo>
                    <a:lnTo>
                      <a:pt x="2765" y="0"/>
                    </a:lnTo>
                    <a:lnTo>
                      <a:pt x="2782" y="70"/>
                    </a:lnTo>
                    <a:lnTo>
                      <a:pt x="2796" y="250"/>
                    </a:lnTo>
                    <a:lnTo>
                      <a:pt x="2810" y="451"/>
                    </a:lnTo>
                    <a:lnTo>
                      <a:pt x="2824" y="601"/>
                    </a:lnTo>
                    <a:lnTo>
                      <a:pt x="2837" y="670"/>
                    </a:lnTo>
                    <a:lnTo>
                      <a:pt x="2851" y="701"/>
                    </a:lnTo>
                    <a:lnTo>
                      <a:pt x="2865" y="729"/>
                    </a:lnTo>
                    <a:lnTo>
                      <a:pt x="2879" y="750"/>
                    </a:lnTo>
                    <a:lnTo>
                      <a:pt x="2893" y="767"/>
                    </a:lnTo>
                    <a:lnTo>
                      <a:pt x="2907" y="809"/>
                    </a:lnTo>
                    <a:lnTo>
                      <a:pt x="2921" y="826"/>
                    </a:lnTo>
                    <a:lnTo>
                      <a:pt x="2935" y="833"/>
                    </a:lnTo>
                    <a:lnTo>
                      <a:pt x="2948" y="833"/>
                    </a:lnTo>
                    <a:lnTo>
                      <a:pt x="2962" y="833"/>
                    </a:lnTo>
                    <a:lnTo>
                      <a:pt x="2976" y="830"/>
                    </a:lnTo>
                    <a:lnTo>
                      <a:pt x="2990" y="830"/>
                    </a:lnTo>
                    <a:lnTo>
                      <a:pt x="3004" y="837"/>
                    </a:lnTo>
                    <a:lnTo>
                      <a:pt x="3018" y="840"/>
                    </a:lnTo>
                    <a:lnTo>
                      <a:pt x="3032" y="847"/>
                    </a:lnTo>
                    <a:lnTo>
                      <a:pt x="3046" y="847"/>
                    </a:lnTo>
                    <a:lnTo>
                      <a:pt x="3059" y="847"/>
                    </a:lnTo>
                    <a:lnTo>
                      <a:pt x="3073" y="847"/>
                    </a:lnTo>
                    <a:lnTo>
                      <a:pt x="3087" y="847"/>
                    </a:lnTo>
                    <a:lnTo>
                      <a:pt x="3101" y="847"/>
                    </a:lnTo>
                    <a:lnTo>
                      <a:pt x="3115" y="847"/>
                    </a:lnTo>
                    <a:lnTo>
                      <a:pt x="3129" y="847"/>
                    </a:lnTo>
                    <a:lnTo>
                      <a:pt x="3143" y="850"/>
                    </a:lnTo>
                    <a:lnTo>
                      <a:pt x="3157" y="850"/>
                    </a:lnTo>
                    <a:lnTo>
                      <a:pt x="3170" y="850"/>
                    </a:lnTo>
                    <a:lnTo>
                      <a:pt x="3184" y="850"/>
                    </a:lnTo>
                    <a:lnTo>
                      <a:pt x="3198" y="847"/>
                    </a:lnTo>
                    <a:lnTo>
                      <a:pt x="3212" y="847"/>
                    </a:lnTo>
                    <a:lnTo>
                      <a:pt x="3226" y="847"/>
                    </a:lnTo>
                    <a:lnTo>
                      <a:pt x="3240" y="844"/>
                    </a:lnTo>
                    <a:lnTo>
                      <a:pt x="3254" y="844"/>
                    </a:lnTo>
                    <a:lnTo>
                      <a:pt x="3268" y="847"/>
                    </a:lnTo>
                    <a:lnTo>
                      <a:pt x="3281" y="847"/>
                    </a:lnTo>
                    <a:lnTo>
                      <a:pt x="3295" y="847"/>
                    </a:lnTo>
                    <a:lnTo>
                      <a:pt x="3313" y="847"/>
                    </a:lnTo>
                    <a:lnTo>
                      <a:pt x="3326" y="847"/>
                    </a:lnTo>
                    <a:lnTo>
                      <a:pt x="3340" y="847"/>
                    </a:lnTo>
                    <a:lnTo>
                      <a:pt x="3354" y="850"/>
                    </a:lnTo>
                    <a:lnTo>
                      <a:pt x="3368" y="850"/>
                    </a:lnTo>
                    <a:lnTo>
                      <a:pt x="3382" y="850"/>
                    </a:lnTo>
                    <a:lnTo>
                      <a:pt x="3396" y="850"/>
                    </a:lnTo>
                    <a:lnTo>
                      <a:pt x="3410" y="850"/>
                    </a:lnTo>
                    <a:lnTo>
                      <a:pt x="3424" y="850"/>
                    </a:lnTo>
                    <a:lnTo>
                      <a:pt x="3437" y="850"/>
                    </a:lnTo>
                    <a:lnTo>
                      <a:pt x="3451" y="850"/>
                    </a:lnTo>
                    <a:lnTo>
                      <a:pt x="3465" y="850"/>
                    </a:lnTo>
                    <a:lnTo>
                      <a:pt x="3479" y="850"/>
                    </a:lnTo>
                    <a:lnTo>
                      <a:pt x="3493" y="850"/>
                    </a:lnTo>
                    <a:lnTo>
                      <a:pt x="3507" y="850"/>
                    </a:lnTo>
                    <a:lnTo>
                      <a:pt x="3521" y="850"/>
                    </a:lnTo>
                    <a:lnTo>
                      <a:pt x="3535" y="850"/>
                    </a:lnTo>
                    <a:lnTo>
                      <a:pt x="3548" y="850"/>
                    </a:lnTo>
                    <a:lnTo>
                      <a:pt x="3562" y="850"/>
                    </a:lnTo>
                    <a:lnTo>
                      <a:pt x="3576" y="850"/>
                    </a:lnTo>
                    <a:lnTo>
                      <a:pt x="3590" y="850"/>
                    </a:lnTo>
                    <a:lnTo>
                      <a:pt x="3604" y="850"/>
                    </a:lnTo>
                    <a:lnTo>
                      <a:pt x="3618" y="850"/>
                    </a:lnTo>
                    <a:lnTo>
                      <a:pt x="3632" y="850"/>
                    </a:lnTo>
                    <a:lnTo>
                      <a:pt x="3646" y="850"/>
                    </a:lnTo>
                    <a:lnTo>
                      <a:pt x="3659" y="850"/>
                    </a:lnTo>
                    <a:lnTo>
                      <a:pt x="3673" y="850"/>
                    </a:lnTo>
                    <a:lnTo>
                      <a:pt x="3687" y="850"/>
                    </a:lnTo>
                    <a:lnTo>
                      <a:pt x="3701" y="850"/>
                    </a:lnTo>
                    <a:lnTo>
                      <a:pt x="3715" y="850"/>
                    </a:lnTo>
                    <a:lnTo>
                      <a:pt x="3729" y="850"/>
                    </a:lnTo>
                    <a:lnTo>
                      <a:pt x="3743" y="850"/>
                    </a:lnTo>
                    <a:lnTo>
                      <a:pt x="3757" y="850"/>
                    </a:lnTo>
                    <a:lnTo>
                      <a:pt x="3770" y="850"/>
                    </a:lnTo>
                    <a:lnTo>
                      <a:pt x="3784" y="850"/>
                    </a:lnTo>
                    <a:lnTo>
                      <a:pt x="3798" y="850"/>
                    </a:lnTo>
                    <a:lnTo>
                      <a:pt x="3812" y="850"/>
                    </a:lnTo>
                    <a:lnTo>
                      <a:pt x="3826" y="850"/>
                    </a:lnTo>
                    <a:lnTo>
                      <a:pt x="3840" y="850"/>
                    </a:lnTo>
                    <a:lnTo>
                      <a:pt x="3857" y="850"/>
                    </a:lnTo>
                    <a:lnTo>
                      <a:pt x="3871" y="850"/>
                    </a:lnTo>
                    <a:lnTo>
                      <a:pt x="3885" y="850"/>
                    </a:lnTo>
                    <a:lnTo>
                      <a:pt x="3899" y="850"/>
                    </a:lnTo>
                    <a:lnTo>
                      <a:pt x="3913" y="850"/>
                    </a:lnTo>
                    <a:lnTo>
                      <a:pt x="3927" y="850"/>
                    </a:lnTo>
                    <a:lnTo>
                      <a:pt x="3940" y="850"/>
                    </a:lnTo>
                    <a:lnTo>
                      <a:pt x="3954" y="850"/>
                    </a:lnTo>
                    <a:lnTo>
                      <a:pt x="3968" y="850"/>
                    </a:lnTo>
                    <a:lnTo>
                      <a:pt x="3982" y="850"/>
                    </a:lnTo>
                    <a:lnTo>
                      <a:pt x="3996" y="850"/>
                    </a:lnTo>
                    <a:lnTo>
                      <a:pt x="4010" y="850"/>
                    </a:lnTo>
                    <a:lnTo>
                      <a:pt x="4024" y="850"/>
                    </a:lnTo>
                    <a:lnTo>
                      <a:pt x="4038" y="850"/>
                    </a:lnTo>
                    <a:lnTo>
                      <a:pt x="4051" y="850"/>
                    </a:lnTo>
                    <a:lnTo>
                      <a:pt x="4065" y="850"/>
                    </a:lnTo>
                    <a:lnTo>
                      <a:pt x="4079" y="850"/>
                    </a:lnTo>
                    <a:lnTo>
                      <a:pt x="4093" y="850"/>
                    </a:lnTo>
                    <a:lnTo>
                      <a:pt x="4107" y="850"/>
                    </a:lnTo>
                    <a:lnTo>
                      <a:pt x="4121" y="850"/>
                    </a:lnTo>
                    <a:lnTo>
                      <a:pt x="4135" y="850"/>
                    </a:lnTo>
                    <a:lnTo>
                      <a:pt x="4149" y="850"/>
                    </a:lnTo>
                    <a:lnTo>
                      <a:pt x="4162" y="850"/>
                    </a:lnTo>
                    <a:lnTo>
                      <a:pt x="4176" y="850"/>
                    </a:lnTo>
                    <a:lnTo>
                      <a:pt x="4190" y="850"/>
                    </a:lnTo>
                    <a:lnTo>
                      <a:pt x="4204" y="850"/>
                    </a:lnTo>
                    <a:lnTo>
                      <a:pt x="4218" y="850"/>
                    </a:lnTo>
                    <a:lnTo>
                      <a:pt x="4232" y="850"/>
                    </a:lnTo>
                    <a:lnTo>
                      <a:pt x="4246" y="850"/>
                    </a:lnTo>
                    <a:lnTo>
                      <a:pt x="4260" y="850"/>
                    </a:lnTo>
                    <a:lnTo>
                      <a:pt x="4273" y="850"/>
                    </a:lnTo>
                    <a:lnTo>
                      <a:pt x="4287" y="850"/>
                    </a:lnTo>
                    <a:lnTo>
                      <a:pt x="4301" y="850"/>
                    </a:lnTo>
                    <a:lnTo>
                      <a:pt x="4315" y="850"/>
                    </a:lnTo>
                    <a:lnTo>
                      <a:pt x="4329" y="850"/>
                    </a:lnTo>
                    <a:lnTo>
                      <a:pt x="4343" y="850"/>
                    </a:lnTo>
                    <a:lnTo>
                      <a:pt x="4357" y="850"/>
                    </a:lnTo>
                    <a:lnTo>
                      <a:pt x="4371" y="850"/>
                    </a:lnTo>
                    <a:lnTo>
                      <a:pt x="4388" y="850"/>
                    </a:lnTo>
                    <a:lnTo>
                      <a:pt x="4402" y="850"/>
                    </a:lnTo>
                    <a:lnTo>
                      <a:pt x="4416" y="850"/>
                    </a:lnTo>
                    <a:lnTo>
                      <a:pt x="4430" y="850"/>
                    </a:lnTo>
                    <a:lnTo>
                      <a:pt x="4443" y="850"/>
                    </a:lnTo>
                    <a:lnTo>
                      <a:pt x="4457" y="850"/>
                    </a:lnTo>
                    <a:lnTo>
                      <a:pt x="4471" y="850"/>
                    </a:lnTo>
                    <a:lnTo>
                      <a:pt x="4485" y="850"/>
                    </a:lnTo>
                    <a:lnTo>
                      <a:pt x="4499" y="850"/>
                    </a:lnTo>
                    <a:lnTo>
                      <a:pt x="4513" y="850"/>
                    </a:lnTo>
                    <a:lnTo>
                      <a:pt x="4527" y="850"/>
                    </a:lnTo>
                    <a:lnTo>
                      <a:pt x="4540" y="850"/>
                    </a:lnTo>
                    <a:lnTo>
                      <a:pt x="4554" y="850"/>
                    </a:lnTo>
                    <a:lnTo>
                      <a:pt x="4568" y="850"/>
                    </a:lnTo>
                    <a:lnTo>
                      <a:pt x="4582" y="850"/>
                    </a:lnTo>
                    <a:lnTo>
                      <a:pt x="4596" y="850"/>
                    </a:lnTo>
                    <a:lnTo>
                      <a:pt x="4610" y="850"/>
                    </a:lnTo>
                    <a:lnTo>
                      <a:pt x="4624" y="850"/>
                    </a:lnTo>
                    <a:lnTo>
                      <a:pt x="4638" y="850"/>
                    </a:lnTo>
                    <a:lnTo>
                      <a:pt x="4651" y="850"/>
                    </a:lnTo>
                    <a:lnTo>
                      <a:pt x="4665" y="850"/>
                    </a:lnTo>
                    <a:lnTo>
                      <a:pt x="4679" y="850"/>
                    </a:lnTo>
                    <a:lnTo>
                      <a:pt x="4693" y="850"/>
                    </a:lnTo>
                    <a:lnTo>
                      <a:pt x="4707" y="850"/>
                    </a:lnTo>
                    <a:lnTo>
                      <a:pt x="4721" y="850"/>
                    </a:lnTo>
                    <a:lnTo>
                      <a:pt x="4735" y="850"/>
                    </a:lnTo>
                    <a:lnTo>
                      <a:pt x="4749" y="850"/>
                    </a:lnTo>
                    <a:lnTo>
                      <a:pt x="4762" y="850"/>
                    </a:lnTo>
                    <a:lnTo>
                      <a:pt x="4776" y="850"/>
                    </a:lnTo>
                    <a:lnTo>
                      <a:pt x="4790" y="850"/>
                    </a:lnTo>
                    <a:lnTo>
                      <a:pt x="4804" y="850"/>
                    </a:lnTo>
                    <a:lnTo>
                      <a:pt x="4818" y="850"/>
                    </a:lnTo>
                    <a:lnTo>
                      <a:pt x="4832" y="850"/>
                    </a:lnTo>
                    <a:lnTo>
                      <a:pt x="4846" y="850"/>
                    </a:lnTo>
                    <a:lnTo>
                      <a:pt x="4860" y="850"/>
                    </a:lnTo>
                    <a:lnTo>
                      <a:pt x="4873" y="850"/>
                    </a:lnTo>
                    <a:lnTo>
                      <a:pt x="4887" y="850"/>
                    </a:lnTo>
                    <a:lnTo>
                      <a:pt x="4901" y="850"/>
                    </a:lnTo>
                    <a:lnTo>
                      <a:pt x="4915" y="850"/>
                    </a:lnTo>
                    <a:lnTo>
                      <a:pt x="4932" y="850"/>
                    </a:lnTo>
                    <a:lnTo>
                      <a:pt x="4946" y="850"/>
                    </a:lnTo>
                    <a:lnTo>
                      <a:pt x="4960" y="850"/>
                    </a:lnTo>
                    <a:lnTo>
                      <a:pt x="4974" y="850"/>
                    </a:lnTo>
                    <a:lnTo>
                      <a:pt x="4988" y="850"/>
                    </a:lnTo>
                    <a:lnTo>
                      <a:pt x="5002" y="850"/>
                    </a:lnTo>
                    <a:lnTo>
                      <a:pt x="5016" y="850"/>
                    </a:lnTo>
                    <a:lnTo>
                      <a:pt x="5030" y="850"/>
                    </a:lnTo>
                    <a:lnTo>
                      <a:pt x="5043" y="850"/>
                    </a:lnTo>
                    <a:lnTo>
                      <a:pt x="5057" y="850"/>
                    </a:lnTo>
                    <a:lnTo>
                      <a:pt x="5071" y="850"/>
                    </a:lnTo>
                    <a:lnTo>
                      <a:pt x="5085" y="850"/>
                    </a:lnTo>
                    <a:lnTo>
                      <a:pt x="5099" y="850"/>
                    </a:lnTo>
                    <a:lnTo>
                      <a:pt x="5113" y="850"/>
                    </a:lnTo>
                    <a:lnTo>
                      <a:pt x="5127" y="850"/>
                    </a:lnTo>
                    <a:lnTo>
                      <a:pt x="5141" y="850"/>
                    </a:lnTo>
                    <a:lnTo>
                      <a:pt x="5154" y="850"/>
                    </a:lnTo>
                    <a:lnTo>
                      <a:pt x="5168" y="850"/>
                    </a:lnTo>
                    <a:lnTo>
                      <a:pt x="5182" y="850"/>
                    </a:lnTo>
                    <a:lnTo>
                      <a:pt x="5196" y="850"/>
                    </a:lnTo>
                    <a:lnTo>
                      <a:pt x="5210" y="850"/>
                    </a:lnTo>
                    <a:lnTo>
                      <a:pt x="5224" y="850"/>
                    </a:lnTo>
                    <a:lnTo>
                      <a:pt x="5238" y="850"/>
                    </a:lnTo>
                    <a:lnTo>
                      <a:pt x="5252" y="850"/>
                    </a:lnTo>
                    <a:lnTo>
                      <a:pt x="5265" y="850"/>
                    </a:lnTo>
                    <a:lnTo>
                      <a:pt x="5279" y="850"/>
                    </a:lnTo>
                    <a:lnTo>
                      <a:pt x="5293" y="850"/>
                    </a:lnTo>
                    <a:lnTo>
                      <a:pt x="5307" y="850"/>
                    </a:lnTo>
                    <a:lnTo>
                      <a:pt x="5321" y="850"/>
                    </a:lnTo>
                    <a:lnTo>
                      <a:pt x="5335" y="850"/>
                    </a:lnTo>
                    <a:lnTo>
                      <a:pt x="5349" y="850"/>
                    </a:lnTo>
                    <a:lnTo>
                      <a:pt x="5363" y="850"/>
                    </a:lnTo>
                    <a:lnTo>
                      <a:pt x="5376" y="850"/>
                    </a:lnTo>
                    <a:lnTo>
                      <a:pt x="5390" y="850"/>
                    </a:lnTo>
                    <a:lnTo>
                      <a:pt x="5404" y="850"/>
                    </a:lnTo>
                    <a:lnTo>
                      <a:pt x="5418" y="850"/>
                    </a:lnTo>
                    <a:lnTo>
                      <a:pt x="5432" y="850"/>
                    </a:lnTo>
                    <a:lnTo>
                      <a:pt x="5446" y="850"/>
                    </a:lnTo>
                    <a:lnTo>
                      <a:pt x="5460" y="850"/>
                    </a:lnTo>
                    <a:lnTo>
                      <a:pt x="5477" y="850"/>
                    </a:lnTo>
                    <a:lnTo>
                      <a:pt x="5491" y="850"/>
                    </a:lnTo>
                    <a:lnTo>
                      <a:pt x="5505" y="850"/>
                    </a:lnTo>
                    <a:lnTo>
                      <a:pt x="5519" y="850"/>
                    </a:lnTo>
                    <a:lnTo>
                      <a:pt x="5533" y="850"/>
                    </a:lnTo>
                    <a:lnTo>
                      <a:pt x="5546" y="850"/>
                    </a:lnTo>
                    <a:lnTo>
                      <a:pt x="5560" y="850"/>
                    </a:lnTo>
                    <a:lnTo>
                      <a:pt x="5574" y="850"/>
                    </a:lnTo>
                    <a:lnTo>
                      <a:pt x="5588" y="850"/>
                    </a:lnTo>
                    <a:lnTo>
                      <a:pt x="5602" y="850"/>
                    </a:lnTo>
                    <a:lnTo>
                      <a:pt x="5616" y="850"/>
                    </a:lnTo>
                    <a:lnTo>
                      <a:pt x="5630" y="85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71" name="Rectangle 93">
                <a:extLst>
                  <a:ext uri="{FF2B5EF4-FFF2-40B4-BE49-F238E27FC236}">
                    <a16:creationId xmlns:a16="http://schemas.microsoft.com/office/drawing/2014/main" id="{9259CE4C-A7E1-8D87-2129-84DFC3C35A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19951" y="1812029"/>
                <a:ext cx="67326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5.878 min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72" name="Rectangle 94">
                <a:extLst>
                  <a:ext uri="{FF2B5EF4-FFF2-40B4-BE49-F238E27FC236}">
                    <a16:creationId xmlns:a16="http://schemas.microsoft.com/office/drawing/2014/main" id="{B1F4AE15-0C0A-5CC2-17E2-8A6EBB0A1B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1188" y="1674813"/>
                <a:ext cx="11266488" cy="1652588"/>
              </a:xfrm>
              <a:prstGeom prst="rect">
                <a:avLst/>
              </a:prstGeom>
              <a:noFill/>
              <a:ln w="11113" cap="flat">
                <a:solidFill>
                  <a:srgbClr val="F0F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73" name="Line 95">
                <a:extLst>
                  <a:ext uri="{FF2B5EF4-FFF2-40B4-BE49-F238E27FC236}">
                    <a16:creationId xmlns:a16="http://schemas.microsoft.com/office/drawing/2014/main" id="{C7B224B4-C703-1584-226D-14B99FF881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22301" y="1812925"/>
                <a:ext cx="0" cy="1519238"/>
              </a:xfrm>
              <a:prstGeom prst="line">
                <a:avLst/>
              </a:prstGeom>
              <a:noFill/>
              <a:ln w="4763" cap="flat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74" name="Rectangle 96">
                <a:extLst>
                  <a:ext uri="{FF2B5EF4-FFF2-40B4-BE49-F238E27FC236}">
                    <a16:creationId xmlns:a16="http://schemas.microsoft.com/office/drawing/2014/main" id="{E2758D42-A98C-B5E8-D143-5203E6C36C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3413" y="1811338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8080"/>
                    </a:solidFill>
                    <a:effectLst/>
                    <a:latin typeface="Helvetica" pitchFamily="2" charset="0"/>
                  </a:rPr>
                  <a:t>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79" name="Line 101">
                <a:extLst>
                  <a:ext uri="{FF2B5EF4-FFF2-40B4-BE49-F238E27FC236}">
                    <a16:creationId xmlns:a16="http://schemas.microsoft.com/office/drawing/2014/main" id="{366B18C4-FE4F-F508-189A-91FECA5845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00076" y="3481388"/>
                <a:ext cx="0" cy="148748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80" name="Rectangle 102">
                <a:extLst>
                  <a:ext uri="{FF2B5EF4-FFF2-40B4-BE49-F238E27FC236}">
                    <a16:creationId xmlns:a16="http://schemas.microsoft.com/office/drawing/2014/main" id="{938CC311-55C5-9881-9703-056F61F048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9751" y="3370263"/>
                <a:ext cx="28854" cy="615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81" name="Rectangle 103">
                <a:extLst>
                  <a:ext uri="{FF2B5EF4-FFF2-40B4-BE49-F238E27FC236}">
                    <a16:creationId xmlns:a16="http://schemas.microsoft.com/office/drawing/2014/main" id="{C0000636-CD58-89FE-24E3-5ACCCC344A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3863" y="3381375"/>
                <a:ext cx="10259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x1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82" name="Line 104">
                <a:extLst>
                  <a:ext uri="{FF2B5EF4-FFF2-40B4-BE49-F238E27FC236}">
                    <a16:creationId xmlns:a16="http://schemas.microsoft.com/office/drawing/2014/main" id="{918CEB35-2ACE-EC6E-6FAB-D06D220097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4968875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83" name="Rectangle 105">
                <a:extLst>
                  <a:ext uri="{FF2B5EF4-FFF2-40B4-BE49-F238E27FC236}">
                    <a16:creationId xmlns:a16="http://schemas.microsoft.com/office/drawing/2014/main" id="{FA42930B-2708-944D-D37C-5AEA25DC07A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988" y="4929188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84" name="Line 106">
                <a:extLst>
                  <a:ext uri="{FF2B5EF4-FFF2-40B4-BE49-F238E27FC236}">
                    <a16:creationId xmlns:a16="http://schemas.microsoft.com/office/drawing/2014/main" id="{FE7A39A4-E2BC-6D78-4537-9B64345CCE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4814888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85" name="Rectangle 107">
                <a:extLst>
                  <a:ext uri="{FF2B5EF4-FFF2-40B4-BE49-F238E27FC236}">
                    <a16:creationId xmlns:a16="http://schemas.microsoft.com/office/drawing/2014/main" id="{BB786D0E-67FD-326E-064A-67602B2615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4775200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86" name="Line 108">
                <a:extLst>
                  <a:ext uri="{FF2B5EF4-FFF2-40B4-BE49-F238E27FC236}">
                    <a16:creationId xmlns:a16="http://schemas.microsoft.com/office/drawing/2014/main" id="{37D2E517-ADAE-5DE0-E07D-EFBC752B56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4654550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87" name="Rectangle 109">
                <a:extLst>
                  <a:ext uri="{FF2B5EF4-FFF2-40B4-BE49-F238E27FC236}">
                    <a16:creationId xmlns:a16="http://schemas.microsoft.com/office/drawing/2014/main" id="{1DFED250-A6A9-7C5D-293F-FB7BB19DEE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988" y="4614863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88" name="Line 110">
                <a:extLst>
                  <a:ext uri="{FF2B5EF4-FFF2-40B4-BE49-F238E27FC236}">
                    <a16:creationId xmlns:a16="http://schemas.microsoft.com/office/drawing/2014/main" id="{0B3D2EE6-8083-8B80-AB08-44BC1E98F9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4500563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89" name="Rectangle 111">
                <a:extLst>
                  <a:ext uri="{FF2B5EF4-FFF2-40B4-BE49-F238E27FC236}">
                    <a16:creationId xmlns:a16="http://schemas.microsoft.com/office/drawing/2014/main" id="{F2216F48-7323-B3A4-F700-B17E5A02C7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4460875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90" name="Line 112">
                <a:extLst>
                  <a:ext uri="{FF2B5EF4-FFF2-40B4-BE49-F238E27FC236}">
                    <a16:creationId xmlns:a16="http://schemas.microsoft.com/office/drawing/2014/main" id="{7BEDD10F-000C-425B-9B32-90BC61CFF7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4340225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91" name="Rectangle 113">
                <a:extLst>
                  <a:ext uri="{FF2B5EF4-FFF2-40B4-BE49-F238E27FC236}">
                    <a16:creationId xmlns:a16="http://schemas.microsoft.com/office/drawing/2014/main" id="{BBF478A3-D22F-0845-1910-09E1DC7B93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988" y="4302125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92" name="Line 114">
                <a:extLst>
                  <a:ext uri="{FF2B5EF4-FFF2-40B4-BE49-F238E27FC236}">
                    <a16:creationId xmlns:a16="http://schemas.microsoft.com/office/drawing/2014/main" id="{1EC499DF-62B0-2BCC-A1B7-C8E0181C90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4186238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93" name="Rectangle 115">
                <a:extLst>
                  <a:ext uri="{FF2B5EF4-FFF2-40B4-BE49-F238E27FC236}">
                    <a16:creationId xmlns:a16="http://schemas.microsoft.com/office/drawing/2014/main" id="{87B47F94-F737-7291-DB48-519A0649F2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4148138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94" name="Line 116">
                <a:extLst>
                  <a:ext uri="{FF2B5EF4-FFF2-40B4-BE49-F238E27FC236}">
                    <a16:creationId xmlns:a16="http://schemas.microsoft.com/office/drawing/2014/main" id="{D81DCA08-15C8-4E62-2E7E-5AF5F068F66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4025900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95" name="Rectangle 117">
                <a:extLst>
                  <a:ext uri="{FF2B5EF4-FFF2-40B4-BE49-F238E27FC236}">
                    <a16:creationId xmlns:a16="http://schemas.microsoft.com/office/drawing/2014/main" id="{857095AF-B717-83BF-D37E-DD33D27A4F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988" y="3987800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96" name="Line 118">
                <a:extLst>
                  <a:ext uri="{FF2B5EF4-FFF2-40B4-BE49-F238E27FC236}">
                    <a16:creationId xmlns:a16="http://schemas.microsoft.com/office/drawing/2014/main" id="{11790FF2-3A2D-7740-8322-8CC8AF858E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3871913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97" name="Rectangle 119">
                <a:extLst>
                  <a:ext uri="{FF2B5EF4-FFF2-40B4-BE49-F238E27FC236}">
                    <a16:creationId xmlns:a16="http://schemas.microsoft.com/office/drawing/2014/main" id="{4302E54F-4262-C142-FEC3-E7DCD3E60A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383381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98" name="Line 120">
                <a:extLst>
                  <a:ext uri="{FF2B5EF4-FFF2-40B4-BE49-F238E27FC236}">
                    <a16:creationId xmlns:a16="http://schemas.microsoft.com/office/drawing/2014/main" id="{C02D7CF8-77E2-483C-EE72-E34AD03E62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3713163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99" name="Rectangle 121">
                <a:extLst>
                  <a:ext uri="{FF2B5EF4-FFF2-40B4-BE49-F238E27FC236}">
                    <a16:creationId xmlns:a16="http://schemas.microsoft.com/office/drawing/2014/main" id="{433C6095-0C84-69C6-535E-F35353B72C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988" y="3673475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00" name="Line 122">
                <a:extLst>
                  <a:ext uri="{FF2B5EF4-FFF2-40B4-BE49-F238E27FC236}">
                    <a16:creationId xmlns:a16="http://schemas.microsoft.com/office/drawing/2014/main" id="{B3DACF91-4B2C-28E4-C9DA-22481F905E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3559175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01" name="Rectangle 123">
                <a:extLst>
                  <a:ext uri="{FF2B5EF4-FFF2-40B4-BE49-F238E27FC236}">
                    <a16:creationId xmlns:a16="http://schemas.microsoft.com/office/drawing/2014/main" id="{96012294-7A83-CCC0-EBE2-341B59323E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3519488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02" name="Rectangle 124">
                <a:extLst>
                  <a:ext uri="{FF2B5EF4-FFF2-40B4-BE49-F238E27FC236}">
                    <a16:creationId xmlns:a16="http://schemas.microsoft.com/office/drawing/2014/main" id="{C79E1308-D43F-447D-2A53-7E44C25031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6426" y="3338513"/>
                <a:ext cx="11277600" cy="166370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03" name="Rectangle 125">
                <a:extLst>
                  <a:ext uri="{FF2B5EF4-FFF2-40B4-BE49-F238E27FC236}">
                    <a16:creationId xmlns:a16="http://schemas.microsoft.com/office/drawing/2014/main" id="{47096849-1237-55DA-5DB4-0024753E75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538" y="3481388"/>
                <a:ext cx="11249025" cy="148748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06" name="Freeform 128">
                <a:extLst>
                  <a:ext uri="{FF2B5EF4-FFF2-40B4-BE49-F238E27FC236}">
                    <a16:creationId xmlns:a16="http://schemas.microsoft.com/office/drawing/2014/main" id="{5E33E933-0997-E22E-5998-6105B05DF1B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15188" y="3616325"/>
                <a:ext cx="420688" cy="1349375"/>
              </a:xfrm>
              <a:custGeom>
                <a:avLst/>
                <a:gdLst>
                  <a:gd name="T0" fmla="*/ 0 w 265"/>
                  <a:gd name="T1" fmla="*/ 850 h 850"/>
                  <a:gd name="T2" fmla="*/ 14 w 265"/>
                  <a:gd name="T3" fmla="*/ 820 h 850"/>
                  <a:gd name="T4" fmla="*/ 28 w 265"/>
                  <a:gd name="T5" fmla="*/ 674 h 850"/>
                  <a:gd name="T6" fmla="*/ 42 w 265"/>
                  <a:gd name="T7" fmla="*/ 401 h 850"/>
                  <a:gd name="T8" fmla="*/ 56 w 265"/>
                  <a:gd name="T9" fmla="*/ 149 h 850"/>
                  <a:gd name="T10" fmla="*/ 70 w 265"/>
                  <a:gd name="T11" fmla="*/ 0 h 850"/>
                  <a:gd name="T12" fmla="*/ 84 w 265"/>
                  <a:gd name="T13" fmla="*/ 1 h 850"/>
                  <a:gd name="T14" fmla="*/ 98 w 265"/>
                  <a:gd name="T15" fmla="*/ 123 h 850"/>
                  <a:gd name="T16" fmla="*/ 111 w 265"/>
                  <a:gd name="T17" fmla="*/ 296 h 850"/>
                  <a:gd name="T18" fmla="*/ 126 w 265"/>
                  <a:gd name="T19" fmla="*/ 458 h 850"/>
                  <a:gd name="T20" fmla="*/ 139 w 265"/>
                  <a:gd name="T21" fmla="*/ 566 h 850"/>
                  <a:gd name="T22" fmla="*/ 153 w 265"/>
                  <a:gd name="T23" fmla="*/ 629 h 850"/>
                  <a:gd name="T24" fmla="*/ 167 w 265"/>
                  <a:gd name="T25" fmla="*/ 669 h 850"/>
                  <a:gd name="T26" fmla="*/ 181 w 265"/>
                  <a:gd name="T27" fmla="*/ 698 h 850"/>
                  <a:gd name="T28" fmla="*/ 195 w 265"/>
                  <a:gd name="T29" fmla="*/ 721 h 850"/>
                  <a:gd name="T30" fmla="*/ 209 w 265"/>
                  <a:gd name="T31" fmla="*/ 760 h 850"/>
                  <a:gd name="T32" fmla="*/ 223 w 265"/>
                  <a:gd name="T33" fmla="*/ 798 h 850"/>
                  <a:gd name="T34" fmla="*/ 237 w 265"/>
                  <a:gd name="T35" fmla="*/ 817 h 850"/>
                  <a:gd name="T36" fmla="*/ 251 w 265"/>
                  <a:gd name="T37" fmla="*/ 823 h 850"/>
                  <a:gd name="T38" fmla="*/ 265 w 265"/>
                  <a:gd name="T39" fmla="*/ 821 h 850"/>
                  <a:gd name="T40" fmla="*/ 265 w 265"/>
                  <a:gd name="T41" fmla="*/ 821 h 850"/>
                  <a:gd name="T42" fmla="*/ 265 w 265"/>
                  <a:gd name="T43" fmla="*/ 821 h 850"/>
                  <a:gd name="T44" fmla="*/ 0 w 265"/>
                  <a:gd name="T45" fmla="*/ 850 h 850"/>
                  <a:gd name="T46" fmla="*/ 0 w 265"/>
                  <a:gd name="T47" fmla="*/ 850 h 8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</a:cxnLst>
                <a:rect l="0" t="0" r="r" b="b"/>
                <a:pathLst>
                  <a:path w="265" h="850">
                    <a:moveTo>
                      <a:pt x="0" y="850"/>
                    </a:moveTo>
                    <a:lnTo>
                      <a:pt x="14" y="820"/>
                    </a:lnTo>
                    <a:lnTo>
                      <a:pt x="28" y="674"/>
                    </a:lnTo>
                    <a:lnTo>
                      <a:pt x="42" y="401"/>
                    </a:lnTo>
                    <a:lnTo>
                      <a:pt x="56" y="149"/>
                    </a:lnTo>
                    <a:lnTo>
                      <a:pt x="70" y="0"/>
                    </a:lnTo>
                    <a:lnTo>
                      <a:pt x="84" y="1"/>
                    </a:lnTo>
                    <a:lnTo>
                      <a:pt x="98" y="123"/>
                    </a:lnTo>
                    <a:lnTo>
                      <a:pt x="111" y="296"/>
                    </a:lnTo>
                    <a:lnTo>
                      <a:pt x="126" y="458"/>
                    </a:lnTo>
                    <a:lnTo>
                      <a:pt x="139" y="566"/>
                    </a:lnTo>
                    <a:lnTo>
                      <a:pt x="153" y="629"/>
                    </a:lnTo>
                    <a:lnTo>
                      <a:pt x="167" y="669"/>
                    </a:lnTo>
                    <a:lnTo>
                      <a:pt x="181" y="698"/>
                    </a:lnTo>
                    <a:lnTo>
                      <a:pt x="195" y="721"/>
                    </a:lnTo>
                    <a:lnTo>
                      <a:pt x="209" y="760"/>
                    </a:lnTo>
                    <a:lnTo>
                      <a:pt x="223" y="798"/>
                    </a:lnTo>
                    <a:lnTo>
                      <a:pt x="237" y="817"/>
                    </a:lnTo>
                    <a:lnTo>
                      <a:pt x="251" y="823"/>
                    </a:lnTo>
                    <a:lnTo>
                      <a:pt x="265" y="821"/>
                    </a:lnTo>
                    <a:lnTo>
                      <a:pt x="265" y="821"/>
                    </a:lnTo>
                    <a:lnTo>
                      <a:pt x="265" y="821"/>
                    </a:lnTo>
                    <a:lnTo>
                      <a:pt x="0" y="850"/>
                    </a:lnTo>
                    <a:lnTo>
                      <a:pt x="0" y="850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08" name="Freeform 130">
                <a:extLst>
                  <a:ext uri="{FF2B5EF4-FFF2-40B4-BE49-F238E27FC236}">
                    <a16:creationId xmlns:a16="http://schemas.microsoft.com/office/drawing/2014/main" id="{D9254C2C-10EE-2C7A-26EB-D6B7FB7E8AA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215188" y="4919663"/>
                <a:ext cx="420688" cy="46038"/>
              </a:xfrm>
              <a:custGeom>
                <a:avLst/>
                <a:gdLst>
                  <a:gd name="T0" fmla="*/ 0 w 265"/>
                  <a:gd name="T1" fmla="*/ 29 h 29"/>
                  <a:gd name="T2" fmla="*/ 0 w 265"/>
                  <a:gd name="T3" fmla="*/ 29 h 29"/>
                  <a:gd name="T4" fmla="*/ 265 w 265"/>
                  <a:gd name="T5" fmla="*/ 0 h 29"/>
                  <a:gd name="T6" fmla="*/ 265 w 265"/>
                  <a:gd name="T7" fmla="*/ 0 h 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65" h="29">
                    <a:moveTo>
                      <a:pt x="0" y="29"/>
                    </a:moveTo>
                    <a:lnTo>
                      <a:pt x="0" y="29"/>
                    </a:lnTo>
                    <a:lnTo>
                      <a:pt x="265" y="0"/>
                    </a:lnTo>
                    <a:lnTo>
                      <a:pt x="265" y="0"/>
                    </a:lnTo>
                  </a:path>
                </a:pathLst>
              </a:cu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09" name="Freeform 131">
                <a:extLst>
                  <a:ext uri="{FF2B5EF4-FFF2-40B4-BE49-F238E27FC236}">
                    <a16:creationId xmlns:a16="http://schemas.microsoft.com/office/drawing/2014/main" id="{D848D3B5-E836-DD57-9C66-0A0B2D9F94E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35288" y="3619500"/>
                <a:ext cx="8915400" cy="1349375"/>
              </a:xfrm>
              <a:custGeom>
                <a:avLst/>
                <a:gdLst>
                  <a:gd name="T0" fmla="*/ 83 w 5616"/>
                  <a:gd name="T1" fmla="*/ 850 h 850"/>
                  <a:gd name="T2" fmla="*/ 184 w 5616"/>
                  <a:gd name="T3" fmla="*/ 850 h 850"/>
                  <a:gd name="T4" fmla="*/ 281 w 5616"/>
                  <a:gd name="T5" fmla="*/ 850 h 850"/>
                  <a:gd name="T6" fmla="*/ 378 w 5616"/>
                  <a:gd name="T7" fmla="*/ 850 h 850"/>
                  <a:gd name="T8" fmla="*/ 475 w 5616"/>
                  <a:gd name="T9" fmla="*/ 850 h 850"/>
                  <a:gd name="T10" fmla="*/ 572 w 5616"/>
                  <a:gd name="T11" fmla="*/ 850 h 850"/>
                  <a:gd name="T12" fmla="*/ 669 w 5616"/>
                  <a:gd name="T13" fmla="*/ 850 h 850"/>
                  <a:gd name="T14" fmla="*/ 770 w 5616"/>
                  <a:gd name="T15" fmla="*/ 850 h 850"/>
                  <a:gd name="T16" fmla="*/ 867 w 5616"/>
                  <a:gd name="T17" fmla="*/ 850 h 850"/>
                  <a:gd name="T18" fmla="*/ 964 w 5616"/>
                  <a:gd name="T19" fmla="*/ 850 h 850"/>
                  <a:gd name="T20" fmla="*/ 1061 w 5616"/>
                  <a:gd name="T21" fmla="*/ 850 h 850"/>
                  <a:gd name="T22" fmla="*/ 1159 w 5616"/>
                  <a:gd name="T23" fmla="*/ 850 h 850"/>
                  <a:gd name="T24" fmla="*/ 1259 w 5616"/>
                  <a:gd name="T25" fmla="*/ 850 h 850"/>
                  <a:gd name="T26" fmla="*/ 1356 w 5616"/>
                  <a:gd name="T27" fmla="*/ 850 h 850"/>
                  <a:gd name="T28" fmla="*/ 1453 w 5616"/>
                  <a:gd name="T29" fmla="*/ 850 h 850"/>
                  <a:gd name="T30" fmla="*/ 1550 w 5616"/>
                  <a:gd name="T31" fmla="*/ 850 h 850"/>
                  <a:gd name="T32" fmla="*/ 1648 w 5616"/>
                  <a:gd name="T33" fmla="*/ 850 h 850"/>
                  <a:gd name="T34" fmla="*/ 1745 w 5616"/>
                  <a:gd name="T35" fmla="*/ 850 h 850"/>
                  <a:gd name="T36" fmla="*/ 1845 w 5616"/>
                  <a:gd name="T37" fmla="*/ 850 h 850"/>
                  <a:gd name="T38" fmla="*/ 1942 w 5616"/>
                  <a:gd name="T39" fmla="*/ 850 h 850"/>
                  <a:gd name="T40" fmla="*/ 2040 w 5616"/>
                  <a:gd name="T41" fmla="*/ 850 h 850"/>
                  <a:gd name="T42" fmla="*/ 2137 w 5616"/>
                  <a:gd name="T43" fmla="*/ 850 h 850"/>
                  <a:gd name="T44" fmla="*/ 2234 w 5616"/>
                  <a:gd name="T45" fmla="*/ 850 h 850"/>
                  <a:gd name="T46" fmla="*/ 2331 w 5616"/>
                  <a:gd name="T47" fmla="*/ 850 h 850"/>
                  <a:gd name="T48" fmla="*/ 2432 w 5616"/>
                  <a:gd name="T49" fmla="*/ 850 h 850"/>
                  <a:gd name="T50" fmla="*/ 2529 w 5616"/>
                  <a:gd name="T51" fmla="*/ 850 h 850"/>
                  <a:gd name="T52" fmla="*/ 2626 w 5616"/>
                  <a:gd name="T53" fmla="*/ 850 h 850"/>
                  <a:gd name="T54" fmla="*/ 2723 w 5616"/>
                  <a:gd name="T55" fmla="*/ 673 h 850"/>
                  <a:gd name="T56" fmla="*/ 2820 w 5616"/>
                  <a:gd name="T57" fmla="*/ 454 h 850"/>
                  <a:gd name="T58" fmla="*/ 2921 w 5616"/>
                  <a:gd name="T59" fmla="*/ 798 h 850"/>
                  <a:gd name="T60" fmla="*/ 3018 w 5616"/>
                  <a:gd name="T61" fmla="*/ 836 h 850"/>
                  <a:gd name="T62" fmla="*/ 3115 w 5616"/>
                  <a:gd name="T63" fmla="*/ 846 h 850"/>
                  <a:gd name="T64" fmla="*/ 3212 w 5616"/>
                  <a:gd name="T65" fmla="*/ 846 h 850"/>
                  <a:gd name="T66" fmla="*/ 3309 w 5616"/>
                  <a:gd name="T67" fmla="*/ 846 h 850"/>
                  <a:gd name="T68" fmla="*/ 3406 w 5616"/>
                  <a:gd name="T69" fmla="*/ 850 h 850"/>
                  <a:gd name="T70" fmla="*/ 3507 w 5616"/>
                  <a:gd name="T71" fmla="*/ 850 h 850"/>
                  <a:gd name="T72" fmla="*/ 3604 w 5616"/>
                  <a:gd name="T73" fmla="*/ 850 h 850"/>
                  <a:gd name="T74" fmla="*/ 3701 w 5616"/>
                  <a:gd name="T75" fmla="*/ 850 h 850"/>
                  <a:gd name="T76" fmla="*/ 3798 w 5616"/>
                  <a:gd name="T77" fmla="*/ 850 h 850"/>
                  <a:gd name="T78" fmla="*/ 3895 w 5616"/>
                  <a:gd name="T79" fmla="*/ 850 h 850"/>
                  <a:gd name="T80" fmla="*/ 3996 w 5616"/>
                  <a:gd name="T81" fmla="*/ 850 h 850"/>
                  <a:gd name="T82" fmla="*/ 4093 w 5616"/>
                  <a:gd name="T83" fmla="*/ 850 h 850"/>
                  <a:gd name="T84" fmla="*/ 4190 w 5616"/>
                  <a:gd name="T85" fmla="*/ 850 h 850"/>
                  <a:gd name="T86" fmla="*/ 4287 w 5616"/>
                  <a:gd name="T87" fmla="*/ 850 h 850"/>
                  <a:gd name="T88" fmla="*/ 4384 w 5616"/>
                  <a:gd name="T89" fmla="*/ 850 h 850"/>
                  <a:gd name="T90" fmla="*/ 4481 w 5616"/>
                  <a:gd name="T91" fmla="*/ 850 h 850"/>
                  <a:gd name="T92" fmla="*/ 4582 w 5616"/>
                  <a:gd name="T93" fmla="*/ 850 h 850"/>
                  <a:gd name="T94" fmla="*/ 4679 w 5616"/>
                  <a:gd name="T95" fmla="*/ 850 h 850"/>
                  <a:gd name="T96" fmla="*/ 4776 w 5616"/>
                  <a:gd name="T97" fmla="*/ 850 h 850"/>
                  <a:gd name="T98" fmla="*/ 4873 w 5616"/>
                  <a:gd name="T99" fmla="*/ 850 h 850"/>
                  <a:gd name="T100" fmla="*/ 4971 w 5616"/>
                  <a:gd name="T101" fmla="*/ 850 h 850"/>
                  <a:gd name="T102" fmla="*/ 5071 w 5616"/>
                  <a:gd name="T103" fmla="*/ 850 h 850"/>
                  <a:gd name="T104" fmla="*/ 5168 w 5616"/>
                  <a:gd name="T105" fmla="*/ 850 h 850"/>
                  <a:gd name="T106" fmla="*/ 5265 w 5616"/>
                  <a:gd name="T107" fmla="*/ 850 h 850"/>
                  <a:gd name="T108" fmla="*/ 5363 w 5616"/>
                  <a:gd name="T109" fmla="*/ 850 h 850"/>
                  <a:gd name="T110" fmla="*/ 5460 w 5616"/>
                  <a:gd name="T111" fmla="*/ 850 h 850"/>
                  <a:gd name="T112" fmla="*/ 5557 w 5616"/>
                  <a:gd name="T113" fmla="*/ 850 h 8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</a:cxnLst>
                <a:rect l="0" t="0" r="r" b="b"/>
                <a:pathLst>
                  <a:path w="5616" h="850">
                    <a:moveTo>
                      <a:pt x="0" y="850"/>
                    </a:moveTo>
                    <a:lnTo>
                      <a:pt x="14" y="850"/>
                    </a:lnTo>
                    <a:lnTo>
                      <a:pt x="28" y="850"/>
                    </a:lnTo>
                    <a:lnTo>
                      <a:pt x="42" y="850"/>
                    </a:lnTo>
                    <a:lnTo>
                      <a:pt x="56" y="850"/>
                    </a:lnTo>
                    <a:lnTo>
                      <a:pt x="69" y="850"/>
                    </a:lnTo>
                    <a:lnTo>
                      <a:pt x="83" y="850"/>
                    </a:lnTo>
                    <a:lnTo>
                      <a:pt x="97" y="850"/>
                    </a:lnTo>
                    <a:lnTo>
                      <a:pt x="111" y="850"/>
                    </a:lnTo>
                    <a:lnTo>
                      <a:pt x="125" y="850"/>
                    </a:lnTo>
                    <a:lnTo>
                      <a:pt x="139" y="850"/>
                    </a:lnTo>
                    <a:lnTo>
                      <a:pt x="153" y="850"/>
                    </a:lnTo>
                    <a:lnTo>
                      <a:pt x="166" y="850"/>
                    </a:lnTo>
                    <a:lnTo>
                      <a:pt x="184" y="850"/>
                    </a:lnTo>
                    <a:lnTo>
                      <a:pt x="198" y="850"/>
                    </a:lnTo>
                    <a:lnTo>
                      <a:pt x="212" y="850"/>
                    </a:lnTo>
                    <a:lnTo>
                      <a:pt x="225" y="850"/>
                    </a:lnTo>
                    <a:lnTo>
                      <a:pt x="239" y="850"/>
                    </a:lnTo>
                    <a:lnTo>
                      <a:pt x="253" y="850"/>
                    </a:lnTo>
                    <a:lnTo>
                      <a:pt x="267" y="850"/>
                    </a:lnTo>
                    <a:lnTo>
                      <a:pt x="281" y="850"/>
                    </a:lnTo>
                    <a:lnTo>
                      <a:pt x="295" y="850"/>
                    </a:lnTo>
                    <a:lnTo>
                      <a:pt x="309" y="850"/>
                    </a:lnTo>
                    <a:lnTo>
                      <a:pt x="323" y="850"/>
                    </a:lnTo>
                    <a:lnTo>
                      <a:pt x="336" y="850"/>
                    </a:lnTo>
                    <a:lnTo>
                      <a:pt x="350" y="850"/>
                    </a:lnTo>
                    <a:lnTo>
                      <a:pt x="364" y="850"/>
                    </a:lnTo>
                    <a:lnTo>
                      <a:pt x="378" y="850"/>
                    </a:lnTo>
                    <a:lnTo>
                      <a:pt x="392" y="850"/>
                    </a:lnTo>
                    <a:lnTo>
                      <a:pt x="406" y="850"/>
                    </a:lnTo>
                    <a:lnTo>
                      <a:pt x="420" y="850"/>
                    </a:lnTo>
                    <a:lnTo>
                      <a:pt x="434" y="850"/>
                    </a:lnTo>
                    <a:lnTo>
                      <a:pt x="447" y="850"/>
                    </a:lnTo>
                    <a:lnTo>
                      <a:pt x="461" y="850"/>
                    </a:lnTo>
                    <a:lnTo>
                      <a:pt x="475" y="850"/>
                    </a:lnTo>
                    <a:lnTo>
                      <a:pt x="489" y="850"/>
                    </a:lnTo>
                    <a:lnTo>
                      <a:pt x="503" y="850"/>
                    </a:lnTo>
                    <a:lnTo>
                      <a:pt x="517" y="850"/>
                    </a:lnTo>
                    <a:lnTo>
                      <a:pt x="531" y="850"/>
                    </a:lnTo>
                    <a:lnTo>
                      <a:pt x="545" y="850"/>
                    </a:lnTo>
                    <a:lnTo>
                      <a:pt x="558" y="850"/>
                    </a:lnTo>
                    <a:lnTo>
                      <a:pt x="572" y="850"/>
                    </a:lnTo>
                    <a:lnTo>
                      <a:pt x="586" y="850"/>
                    </a:lnTo>
                    <a:lnTo>
                      <a:pt x="600" y="850"/>
                    </a:lnTo>
                    <a:lnTo>
                      <a:pt x="614" y="850"/>
                    </a:lnTo>
                    <a:lnTo>
                      <a:pt x="628" y="850"/>
                    </a:lnTo>
                    <a:lnTo>
                      <a:pt x="642" y="850"/>
                    </a:lnTo>
                    <a:lnTo>
                      <a:pt x="656" y="850"/>
                    </a:lnTo>
                    <a:lnTo>
                      <a:pt x="669" y="850"/>
                    </a:lnTo>
                    <a:lnTo>
                      <a:pt x="683" y="850"/>
                    </a:lnTo>
                    <a:lnTo>
                      <a:pt x="697" y="850"/>
                    </a:lnTo>
                    <a:lnTo>
                      <a:pt x="711" y="850"/>
                    </a:lnTo>
                    <a:lnTo>
                      <a:pt x="728" y="850"/>
                    </a:lnTo>
                    <a:lnTo>
                      <a:pt x="742" y="850"/>
                    </a:lnTo>
                    <a:lnTo>
                      <a:pt x="756" y="850"/>
                    </a:lnTo>
                    <a:lnTo>
                      <a:pt x="770" y="850"/>
                    </a:lnTo>
                    <a:lnTo>
                      <a:pt x="784" y="850"/>
                    </a:lnTo>
                    <a:lnTo>
                      <a:pt x="798" y="850"/>
                    </a:lnTo>
                    <a:lnTo>
                      <a:pt x="812" y="850"/>
                    </a:lnTo>
                    <a:lnTo>
                      <a:pt x="826" y="850"/>
                    </a:lnTo>
                    <a:lnTo>
                      <a:pt x="839" y="850"/>
                    </a:lnTo>
                    <a:lnTo>
                      <a:pt x="853" y="850"/>
                    </a:lnTo>
                    <a:lnTo>
                      <a:pt x="867" y="850"/>
                    </a:lnTo>
                    <a:lnTo>
                      <a:pt x="881" y="850"/>
                    </a:lnTo>
                    <a:lnTo>
                      <a:pt x="895" y="850"/>
                    </a:lnTo>
                    <a:lnTo>
                      <a:pt x="909" y="850"/>
                    </a:lnTo>
                    <a:lnTo>
                      <a:pt x="923" y="850"/>
                    </a:lnTo>
                    <a:lnTo>
                      <a:pt x="937" y="850"/>
                    </a:lnTo>
                    <a:lnTo>
                      <a:pt x="950" y="850"/>
                    </a:lnTo>
                    <a:lnTo>
                      <a:pt x="964" y="850"/>
                    </a:lnTo>
                    <a:lnTo>
                      <a:pt x="978" y="850"/>
                    </a:lnTo>
                    <a:lnTo>
                      <a:pt x="992" y="850"/>
                    </a:lnTo>
                    <a:lnTo>
                      <a:pt x="1006" y="850"/>
                    </a:lnTo>
                    <a:lnTo>
                      <a:pt x="1020" y="850"/>
                    </a:lnTo>
                    <a:lnTo>
                      <a:pt x="1034" y="850"/>
                    </a:lnTo>
                    <a:lnTo>
                      <a:pt x="1048" y="850"/>
                    </a:lnTo>
                    <a:lnTo>
                      <a:pt x="1061" y="850"/>
                    </a:lnTo>
                    <a:lnTo>
                      <a:pt x="1075" y="850"/>
                    </a:lnTo>
                    <a:lnTo>
                      <a:pt x="1089" y="850"/>
                    </a:lnTo>
                    <a:lnTo>
                      <a:pt x="1103" y="850"/>
                    </a:lnTo>
                    <a:lnTo>
                      <a:pt x="1117" y="850"/>
                    </a:lnTo>
                    <a:lnTo>
                      <a:pt x="1131" y="850"/>
                    </a:lnTo>
                    <a:lnTo>
                      <a:pt x="1145" y="850"/>
                    </a:lnTo>
                    <a:lnTo>
                      <a:pt x="1159" y="850"/>
                    </a:lnTo>
                    <a:lnTo>
                      <a:pt x="1172" y="850"/>
                    </a:lnTo>
                    <a:lnTo>
                      <a:pt x="1186" y="850"/>
                    </a:lnTo>
                    <a:lnTo>
                      <a:pt x="1200" y="850"/>
                    </a:lnTo>
                    <a:lnTo>
                      <a:pt x="1214" y="850"/>
                    </a:lnTo>
                    <a:lnTo>
                      <a:pt x="1228" y="850"/>
                    </a:lnTo>
                    <a:lnTo>
                      <a:pt x="1242" y="850"/>
                    </a:lnTo>
                    <a:lnTo>
                      <a:pt x="1259" y="850"/>
                    </a:lnTo>
                    <a:lnTo>
                      <a:pt x="1273" y="850"/>
                    </a:lnTo>
                    <a:lnTo>
                      <a:pt x="1287" y="850"/>
                    </a:lnTo>
                    <a:lnTo>
                      <a:pt x="1301" y="850"/>
                    </a:lnTo>
                    <a:lnTo>
                      <a:pt x="1315" y="850"/>
                    </a:lnTo>
                    <a:lnTo>
                      <a:pt x="1328" y="850"/>
                    </a:lnTo>
                    <a:lnTo>
                      <a:pt x="1342" y="850"/>
                    </a:lnTo>
                    <a:lnTo>
                      <a:pt x="1356" y="850"/>
                    </a:lnTo>
                    <a:lnTo>
                      <a:pt x="1370" y="850"/>
                    </a:lnTo>
                    <a:lnTo>
                      <a:pt x="1384" y="850"/>
                    </a:lnTo>
                    <a:lnTo>
                      <a:pt x="1398" y="850"/>
                    </a:lnTo>
                    <a:lnTo>
                      <a:pt x="1412" y="850"/>
                    </a:lnTo>
                    <a:lnTo>
                      <a:pt x="1426" y="850"/>
                    </a:lnTo>
                    <a:lnTo>
                      <a:pt x="1439" y="850"/>
                    </a:lnTo>
                    <a:lnTo>
                      <a:pt x="1453" y="850"/>
                    </a:lnTo>
                    <a:lnTo>
                      <a:pt x="1467" y="850"/>
                    </a:lnTo>
                    <a:lnTo>
                      <a:pt x="1481" y="850"/>
                    </a:lnTo>
                    <a:lnTo>
                      <a:pt x="1495" y="850"/>
                    </a:lnTo>
                    <a:lnTo>
                      <a:pt x="1509" y="850"/>
                    </a:lnTo>
                    <a:lnTo>
                      <a:pt x="1523" y="850"/>
                    </a:lnTo>
                    <a:lnTo>
                      <a:pt x="1537" y="850"/>
                    </a:lnTo>
                    <a:lnTo>
                      <a:pt x="1550" y="850"/>
                    </a:lnTo>
                    <a:lnTo>
                      <a:pt x="1564" y="850"/>
                    </a:lnTo>
                    <a:lnTo>
                      <a:pt x="1578" y="850"/>
                    </a:lnTo>
                    <a:lnTo>
                      <a:pt x="1592" y="850"/>
                    </a:lnTo>
                    <a:lnTo>
                      <a:pt x="1606" y="850"/>
                    </a:lnTo>
                    <a:lnTo>
                      <a:pt x="1620" y="850"/>
                    </a:lnTo>
                    <a:lnTo>
                      <a:pt x="1634" y="850"/>
                    </a:lnTo>
                    <a:lnTo>
                      <a:pt x="1648" y="850"/>
                    </a:lnTo>
                    <a:lnTo>
                      <a:pt x="1661" y="850"/>
                    </a:lnTo>
                    <a:lnTo>
                      <a:pt x="1675" y="850"/>
                    </a:lnTo>
                    <a:lnTo>
                      <a:pt x="1689" y="850"/>
                    </a:lnTo>
                    <a:lnTo>
                      <a:pt x="1703" y="850"/>
                    </a:lnTo>
                    <a:lnTo>
                      <a:pt x="1717" y="850"/>
                    </a:lnTo>
                    <a:lnTo>
                      <a:pt x="1731" y="850"/>
                    </a:lnTo>
                    <a:lnTo>
                      <a:pt x="1745" y="850"/>
                    </a:lnTo>
                    <a:lnTo>
                      <a:pt x="1759" y="850"/>
                    </a:lnTo>
                    <a:lnTo>
                      <a:pt x="1772" y="850"/>
                    </a:lnTo>
                    <a:lnTo>
                      <a:pt x="1786" y="850"/>
                    </a:lnTo>
                    <a:lnTo>
                      <a:pt x="1804" y="850"/>
                    </a:lnTo>
                    <a:lnTo>
                      <a:pt x="1818" y="850"/>
                    </a:lnTo>
                    <a:lnTo>
                      <a:pt x="1831" y="850"/>
                    </a:lnTo>
                    <a:lnTo>
                      <a:pt x="1845" y="850"/>
                    </a:lnTo>
                    <a:lnTo>
                      <a:pt x="1859" y="850"/>
                    </a:lnTo>
                    <a:lnTo>
                      <a:pt x="1873" y="850"/>
                    </a:lnTo>
                    <a:lnTo>
                      <a:pt x="1887" y="850"/>
                    </a:lnTo>
                    <a:lnTo>
                      <a:pt x="1901" y="850"/>
                    </a:lnTo>
                    <a:lnTo>
                      <a:pt x="1915" y="850"/>
                    </a:lnTo>
                    <a:lnTo>
                      <a:pt x="1929" y="850"/>
                    </a:lnTo>
                    <a:lnTo>
                      <a:pt x="1942" y="850"/>
                    </a:lnTo>
                    <a:lnTo>
                      <a:pt x="1956" y="850"/>
                    </a:lnTo>
                    <a:lnTo>
                      <a:pt x="1970" y="850"/>
                    </a:lnTo>
                    <a:lnTo>
                      <a:pt x="1984" y="850"/>
                    </a:lnTo>
                    <a:lnTo>
                      <a:pt x="1998" y="850"/>
                    </a:lnTo>
                    <a:lnTo>
                      <a:pt x="2012" y="850"/>
                    </a:lnTo>
                    <a:lnTo>
                      <a:pt x="2026" y="850"/>
                    </a:lnTo>
                    <a:lnTo>
                      <a:pt x="2040" y="850"/>
                    </a:lnTo>
                    <a:lnTo>
                      <a:pt x="2053" y="850"/>
                    </a:lnTo>
                    <a:lnTo>
                      <a:pt x="2067" y="850"/>
                    </a:lnTo>
                    <a:lnTo>
                      <a:pt x="2081" y="850"/>
                    </a:lnTo>
                    <a:lnTo>
                      <a:pt x="2095" y="850"/>
                    </a:lnTo>
                    <a:lnTo>
                      <a:pt x="2109" y="850"/>
                    </a:lnTo>
                    <a:lnTo>
                      <a:pt x="2123" y="850"/>
                    </a:lnTo>
                    <a:lnTo>
                      <a:pt x="2137" y="850"/>
                    </a:lnTo>
                    <a:lnTo>
                      <a:pt x="2151" y="850"/>
                    </a:lnTo>
                    <a:lnTo>
                      <a:pt x="2164" y="850"/>
                    </a:lnTo>
                    <a:lnTo>
                      <a:pt x="2178" y="850"/>
                    </a:lnTo>
                    <a:lnTo>
                      <a:pt x="2192" y="850"/>
                    </a:lnTo>
                    <a:lnTo>
                      <a:pt x="2206" y="850"/>
                    </a:lnTo>
                    <a:lnTo>
                      <a:pt x="2220" y="850"/>
                    </a:lnTo>
                    <a:lnTo>
                      <a:pt x="2234" y="850"/>
                    </a:lnTo>
                    <a:lnTo>
                      <a:pt x="2248" y="850"/>
                    </a:lnTo>
                    <a:lnTo>
                      <a:pt x="2262" y="850"/>
                    </a:lnTo>
                    <a:lnTo>
                      <a:pt x="2275" y="850"/>
                    </a:lnTo>
                    <a:lnTo>
                      <a:pt x="2289" y="850"/>
                    </a:lnTo>
                    <a:lnTo>
                      <a:pt x="2303" y="850"/>
                    </a:lnTo>
                    <a:lnTo>
                      <a:pt x="2317" y="850"/>
                    </a:lnTo>
                    <a:lnTo>
                      <a:pt x="2331" y="850"/>
                    </a:lnTo>
                    <a:lnTo>
                      <a:pt x="2348" y="850"/>
                    </a:lnTo>
                    <a:lnTo>
                      <a:pt x="2362" y="850"/>
                    </a:lnTo>
                    <a:lnTo>
                      <a:pt x="2376" y="850"/>
                    </a:lnTo>
                    <a:lnTo>
                      <a:pt x="2390" y="850"/>
                    </a:lnTo>
                    <a:lnTo>
                      <a:pt x="2404" y="850"/>
                    </a:lnTo>
                    <a:lnTo>
                      <a:pt x="2418" y="850"/>
                    </a:lnTo>
                    <a:lnTo>
                      <a:pt x="2432" y="850"/>
                    </a:lnTo>
                    <a:lnTo>
                      <a:pt x="2445" y="850"/>
                    </a:lnTo>
                    <a:lnTo>
                      <a:pt x="2459" y="850"/>
                    </a:lnTo>
                    <a:lnTo>
                      <a:pt x="2473" y="850"/>
                    </a:lnTo>
                    <a:lnTo>
                      <a:pt x="2487" y="850"/>
                    </a:lnTo>
                    <a:lnTo>
                      <a:pt x="2501" y="850"/>
                    </a:lnTo>
                    <a:lnTo>
                      <a:pt x="2515" y="850"/>
                    </a:lnTo>
                    <a:lnTo>
                      <a:pt x="2529" y="850"/>
                    </a:lnTo>
                    <a:lnTo>
                      <a:pt x="2543" y="850"/>
                    </a:lnTo>
                    <a:lnTo>
                      <a:pt x="2556" y="850"/>
                    </a:lnTo>
                    <a:lnTo>
                      <a:pt x="2570" y="850"/>
                    </a:lnTo>
                    <a:lnTo>
                      <a:pt x="2584" y="850"/>
                    </a:lnTo>
                    <a:lnTo>
                      <a:pt x="2598" y="850"/>
                    </a:lnTo>
                    <a:lnTo>
                      <a:pt x="2612" y="850"/>
                    </a:lnTo>
                    <a:lnTo>
                      <a:pt x="2626" y="850"/>
                    </a:lnTo>
                    <a:lnTo>
                      <a:pt x="2640" y="850"/>
                    </a:lnTo>
                    <a:lnTo>
                      <a:pt x="2654" y="850"/>
                    </a:lnTo>
                    <a:lnTo>
                      <a:pt x="2667" y="850"/>
                    </a:lnTo>
                    <a:lnTo>
                      <a:pt x="2681" y="850"/>
                    </a:lnTo>
                    <a:lnTo>
                      <a:pt x="2695" y="846"/>
                    </a:lnTo>
                    <a:lnTo>
                      <a:pt x="2709" y="819"/>
                    </a:lnTo>
                    <a:lnTo>
                      <a:pt x="2723" y="673"/>
                    </a:lnTo>
                    <a:lnTo>
                      <a:pt x="2737" y="399"/>
                    </a:lnTo>
                    <a:lnTo>
                      <a:pt x="2751" y="145"/>
                    </a:lnTo>
                    <a:lnTo>
                      <a:pt x="2764" y="0"/>
                    </a:lnTo>
                    <a:lnTo>
                      <a:pt x="2778" y="0"/>
                    </a:lnTo>
                    <a:lnTo>
                      <a:pt x="2792" y="121"/>
                    </a:lnTo>
                    <a:lnTo>
                      <a:pt x="2806" y="295"/>
                    </a:lnTo>
                    <a:lnTo>
                      <a:pt x="2820" y="454"/>
                    </a:lnTo>
                    <a:lnTo>
                      <a:pt x="2834" y="565"/>
                    </a:lnTo>
                    <a:lnTo>
                      <a:pt x="2848" y="628"/>
                    </a:lnTo>
                    <a:lnTo>
                      <a:pt x="2862" y="666"/>
                    </a:lnTo>
                    <a:lnTo>
                      <a:pt x="2879" y="697"/>
                    </a:lnTo>
                    <a:lnTo>
                      <a:pt x="2893" y="718"/>
                    </a:lnTo>
                    <a:lnTo>
                      <a:pt x="2907" y="760"/>
                    </a:lnTo>
                    <a:lnTo>
                      <a:pt x="2921" y="798"/>
                    </a:lnTo>
                    <a:lnTo>
                      <a:pt x="2934" y="815"/>
                    </a:lnTo>
                    <a:lnTo>
                      <a:pt x="2948" y="822"/>
                    </a:lnTo>
                    <a:lnTo>
                      <a:pt x="2962" y="819"/>
                    </a:lnTo>
                    <a:lnTo>
                      <a:pt x="2976" y="815"/>
                    </a:lnTo>
                    <a:lnTo>
                      <a:pt x="2990" y="815"/>
                    </a:lnTo>
                    <a:lnTo>
                      <a:pt x="3004" y="826"/>
                    </a:lnTo>
                    <a:lnTo>
                      <a:pt x="3018" y="836"/>
                    </a:lnTo>
                    <a:lnTo>
                      <a:pt x="3032" y="843"/>
                    </a:lnTo>
                    <a:lnTo>
                      <a:pt x="3045" y="843"/>
                    </a:lnTo>
                    <a:lnTo>
                      <a:pt x="3059" y="846"/>
                    </a:lnTo>
                    <a:lnTo>
                      <a:pt x="3073" y="846"/>
                    </a:lnTo>
                    <a:lnTo>
                      <a:pt x="3087" y="846"/>
                    </a:lnTo>
                    <a:lnTo>
                      <a:pt x="3101" y="843"/>
                    </a:lnTo>
                    <a:lnTo>
                      <a:pt x="3115" y="846"/>
                    </a:lnTo>
                    <a:lnTo>
                      <a:pt x="3129" y="846"/>
                    </a:lnTo>
                    <a:lnTo>
                      <a:pt x="3143" y="846"/>
                    </a:lnTo>
                    <a:lnTo>
                      <a:pt x="3156" y="846"/>
                    </a:lnTo>
                    <a:lnTo>
                      <a:pt x="3170" y="846"/>
                    </a:lnTo>
                    <a:lnTo>
                      <a:pt x="3184" y="846"/>
                    </a:lnTo>
                    <a:lnTo>
                      <a:pt x="3198" y="846"/>
                    </a:lnTo>
                    <a:lnTo>
                      <a:pt x="3212" y="846"/>
                    </a:lnTo>
                    <a:lnTo>
                      <a:pt x="3226" y="846"/>
                    </a:lnTo>
                    <a:lnTo>
                      <a:pt x="3240" y="846"/>
                    </a:lnTo>
                    <a:lnTo>
                      <a:pt x="3254" y="846"/>
                    </a:lnTo>
                    <a:lnTo>
                      <a:pt x="3267" y="846"/>
                    </a:lnTo>
                    <a:lnTo>
                      <a:pt x="3281" y="846"/>
                    </a:lnTo>
                    <a:lnTo>
                      <a:pt x="3295" y="846"/>
                    </a:lnTo>
                    <a:lnTo>
                      <a:pt x="3309" y="846"/>
                    </a:lnTo>
                    <a:lnTo>
                      <a:pt x="3323" y="846"/>
                    </a:lnTo>
                    <a:lnTo>
                      <a:pt x="3337" y="846"/>
                    </a:lnTo>
                    <a:lnTo>
                      <a:pt x="3351" y="846"/>
                    </a:lnTo>
                    <a:lnTo>
                      <a:pt x="3365" y="850"/>
                    </a:lnTo>
                    <a:lnTo>
                      <a:pt x="3378" y="850"/>
                    </a:lnTo>
                    <a:lnTo>
                      <a:pt x="3392" y="850"/>
                    </a:lnTo>
                    <a:lnTo>
                      <a:pt x="3406" y="850"/>
                    </a:lnTo>
                    <a:lnTo>
                      <a:pt x="3424" y="850"/>
                    </a:lnTo>
                    <a:lnTo>
                      <a:pt x="3437" y="850"/>
                    </a:lnTo>
                    <a:lnTo>
                      <a:pt x="3451" y="850"/>
                    </a:lnTo>
                    <a:lnTo>
                      <a:pt x="3465" y="850"/>
                    </a:lnTo>
                    <a:lnTo>
                      <a:pt x="3479" y="850"/>
                    </a:lnTo>
                    <a:lnTo>
                      <a:pt x="3493" y="850"/>
                    </a:lnTo>
                    <a:lnTo>
                      <a:pt x="3507" y="850"/>
                    </a:lnTo>
                    <a:lnTo>
                      <a:pt x="3521" y="850"/>
                    </a:lnTo>
                    <a:lnTo>
                      <a:pt x="3535" y="850"/>
                    </a:lnTo>
                    <a:lnTo>
                      <a:pt x="3548" y="850"/>
                    </a:lnTo>
                    <a:lnTo>
                      <a:pt x="3562" y="850"/>
                    </a:lnTo>
                    <a:lnTo>
                      <a:pt x="3576" y="850"/>
                    </a:lnTo>
                    <a:lnTo>
                      <a:pt x="3590" y="850"/>
                    </a:lnTo>
                    <a:lnTo>
                      <a:pt x="3604" y="850"/>
                    </a:lnTo>
                    <a:lnTo>
                      <a:pt x="3618" y="850"/>
                    </a:lnTo>
                    <a:lnTo>
                      <a:pt x="3632" y="850"/>
                    </a:lnTo>
                    <a:lnTo>
                      <a:pt x="3646" y="850"/>
                    </a:lnTo>
                    <a:lnTo>
                      <a:pt x="3659" y="850"/>
                    </a:lnTo>
                    <a:lnTo>
                      <a:pt x="3673" y="850"/>
                    </a:lnTo>
                    <a:lnTo>
                      <a:pt x="3687" y="850"/>
                    </a:lnTo>
                    <a:lnTo>
                      <a:pt x="3701" y="850"/>
                    </a:lnTo>
                    <a:lnTo>
                      <a:pt x="3715" y="850"/>
                    </a:lnTo>
                    <a:lnTo>
                      <a:pt x="3729" y="850"/>
                    </a:lnTo>
                    <a:lnTo>
                      <a:pt x="3743" y="850"/>
                    </a:lnTo>
                    <a:lnTo>
                      <a:pt x="3757" y="850"/>
                    </a:lnTo>
                    <a:lnTo>
                      <a:pt x="3770" y="850"/>
                    </a:lnTo>
                    <a:lnTo>
                      <a:pt x="3784" y="850"/>
                    </a:lnTo>
                    <a:lnTo>
                      <a:pt x="3798" y="850"/>
                    </a:lnTo>
                    <a:lnTo>
                      <a:pt x="3812" y="850"/>
                    </a:lnTo>
                    <a:lnTo>
                      <a:pt x="3826" y="850"/>
                    </a:lnTo>
                    <a:lnTo>
                      <a:pt x="3840" y="850"/>
                    </a:lnTo>
                    <a:lnTo>
                      <a:pt x="3854" y="850"/>
                    </a:lnTo>
                    <a:lnTo>
                      <a:pt x="3868" y="850"/>
                    </a:lnTo>
                    <a:lnTo>
                      <a:pt x="3881" y="850"/>
                    </a:lnTo>
                    <a:lnTo>
                      <a:pt x="3895" y="850"/>
                    </a:lnTo>
                    <a:lnTo>
                      <a:pt x="3909" y="850"/>
                    </a:lnTo>
                    <a:lnTo>
                      <a:pt x="3923" y="850"/>
                    </a:lnTo>
                    <a:lnTo>
                      <a:pt x="3937" y="850"/>
                    </a:lnTo>
                    <a:lnTo>
                      <a:pt x="3951" y="850"/>
                    </a:lnTo>
                    <a:lnTo>
                      <a:pt x="3968" y="850"/>
                    </a:lnTo>
                    <a:lnTo>
                      <a:pt x="3982" y="850"/>
                    </a:lnTo>
                    <a:lnTo>
                      <a:pt x="3996" y="850"/>
                    </a:lnTo>
                    <a:lnTo>
                      <a:pt x="4010" y="850"/>
                    </a:lnTo>
                    <a:lnTo>
                      <a:pt x="4024" y="850"/>
                    </a:lnTo>
                    <a:lnTo>
                      <a:pt x="4037" y="850"/>
                    </a:lnTo>
                    <a:lnTo>
                      <a:pt x="4051" y="850"/>
                    </a:lnTo>
                    <a:lnTo>
                      <a:pt x="4065" y="850"/>
                    </a:lnTo>
                    <a:lnTo>
                      <a:pt x="4079" y="850"/>
                    </a:lnTo>
                    <a:lnTo>
                      <a:pt x="4093" y="850"/>
                    </a:lnTo>
                    <a:lnTo>
                      <a:pt x="4107" y="850"/>
                    </a:lnTo>
                    <a:lnTo>
                      <a:pt x="4121" y="850"/>
                    </a:lnTo>
                    <a:lnTo>
                      <a:pt x="4135" y="850"/>
                    </a:lnTo>
                    <a:lnTo>
                      <a:pt x="4148" y="850"/>
                    </a:lnTo>
                    <a:lnTo>
                      <a:pt x="4162" y="850"/>
                    </a:lnTo>
                    <a:lnTo>
                      <a:pt x="4176" y="850"/>
                    </a:lnTo>
                    <a:lnTo>
                      <a:pt x="4190" y="850"/>
                    </a:lnTo>
                    <a:lnTo>
                      <a:pt x="4204" y="850"/>
                    </a:lnTo>
                    <a:lnTo>
                      <a:pt x="4218" y="850"/>
                    </a:lnTo>
                    <a:lnTo>
                      <a:pt x="4232" y="850"/>
                    </a:lnTo>
                    <a:lnTo>
                      <a:pt x="4246" y="850"/>
                    </a:lnTo>
                    <a:lnTo>
                      <a:pt x="4259" y="850"/>
                    </a:lnTo>
                    <a:lnTo>
                      <a:pt x="4273" y="850"/>
                    </a:lnTo>
                    <a:lnTo>
                      <a:pt x="4287" y="850"/>
                    </a:lnTo>
                    <a:lnTo>
                      <a:pt x="4301" y="850"/>
                    </a:lnTo>
                    <a:lnTo>
                      <a:pt x="4315" y="850"/>
                    </a:lnTo>
                    <a:lnTo>
                      <a:pt x="4329" y="850"/>
                    </a:lnTo>
                    <a:lnTo>
                      <a:pt x="4343" y="850"/>
                    </a:lnTo>
                    <a:lnTo>
                      <a:pt x="4357" y="850"/>
                    </a:lnTo>
                    <a:lnTo>
                      <a:pt x="4370" y="850"/>
                    </a:lnTo>
                    <a:lnTo>
                      <a:pt x="4384" y="850"/>
                    </a:lnTo>
                    <a:lnTo>
                      <a:pt x="4398" y="850"/>
                    </a:lnTo>
                    <a:lnTo>
                      <a:pt x="4412" y="850"/>
                    </a:lnTo>
                    <a:lnTo>
                      <a:pt x="4426" y="850"/>
                    </a:lnTo>
                    <a:lnTo>
                      <a:pt x="4440" y="850"/>
                    </a:lnTo>
                    <a:lnTo>
                      <a:pt x="4454" y="850"/>
                    </a:lnTo>
                    <a:lnTo>
                      <a:pt x="4468" y="850"/>
                    </a:lnTo>
                    <a:lnTo>
                      <a:pt x="4481" y="850"/>
                    </a:lnTo>
                    <a:lnTo>
                      <a:pt x="4499" y="850"/>
                    </a:lnTo>
                    <a:lnTo>
                      <a:pt x="4513" y="850"/>
                    </a:lnTo>
                    <a:lnTo>
                      <a:pt x="4527" y="850"/>
                    </a:lnTo>
                    <a:lnTo>
                      <a:pt x="4540" y="850"/>
                    </a:lnTo>
                    <a:lnTo>
                      <a:pt x="4554" y="850"/>
                    </a:lnTo>
                    <a:lnTo>
                      <a:pt x="4568" y="850"/>
                    </a:lnTo>
                    <a:lnTo>
                      <a:pt x="4582" y="850"/>
                    </a:lnTo>
                    <a:lnTo>
                      <a:pt x="4596" y="850"/>
                    </a:lnTo>
                    <a:lnTo>
                      <a:pt x="4610" y="850"/>
                    </a:lnTo>
                    <a:lnTo>
                      <a:pt x="4624" y="850"/>
                    </a:lnTo>
                    <a:lnTo>
                      <a:pt x="4638" y="850"/>
                    </a:lnTo>
                    <a:lnTo>
                      <a:pt x="4651" y="850"/>
                    </a:lnTo>
                    <a:lnTo>
                      <a:pt x="4665" y="850"/>
                    </a:lnTo>
                    <a:lnTo>
                      <a:pt x="4679" y="850"/>
                    </a:lnTo>
                    <a:lnTo>
                      <a:pt x="4693" y="850"/>
                    </a:lnTo>
                    <a:lnTo>
                      <a:pt x="4707" y="850"/>
                    </a:lnTo>
                    <a:lnTo>
                      <a:pt x="4721" y="850"/>
                    </a:lnTo>
                    <a:lnTo>
                      <a:pt x="4735" y="850"/>
                    </a:lnTo>
                    <a:lnTo>
                      <a:pt x="4749" y="850"/>
                    </a:lnTo>
                    <a:lnTo>
                      <a:pt x="4762" y="850"/>
                    </a:lnTo>
                    <a:lnTo>
                      <a:pt x="4776" y="850"/>
                    </a:lnTo>
                    <a:lnTo>
                      <a:pt x="4790" y="850"/>
                    </a:lnTo>
                    <a:lnTo>
                      <a:pt x="4804" y="850"/>
                    </a:lnTo>
                    <a:lnTo>
                      <a:pt x="4818" y="850"/>
                    </a:lnTo>
                    <a:lnTo>
                      <a:pt x="4832" y="850"/>
                    </a:lnTo>
                    <a:lnTo>
                      <a:pt x="4846" y="850"/>
                    </a:lnTo>
                    <a:lnTo>
                      <a:pt x="4860" y="850"/>
                    </a:lnTo>
                    <a:lnTo>
                      <a:pt x="4873" y="850"/>
                    </a:lnTo>
                    <a:lnTo>
                      <a:pt x="4887" y="850"/>
                    </a:lnTo>
                    <a:lnTo>
                      <a:pt x="4901" y="850"/>
                    </a:lnTo>
                    <a:lnTo>
                      <a:pt x="4915" y="850"/>
                    </a:lnTo>
                    <a:lnTo>
                      <a:pt x="4929" y="850"/>
                    </a:lnTo>
                    <a:lnTo>
                      <a:pt x="4943" y="850"/>
                    </a:lnTo>
                    <a:lnTo>
                      <a:pt x="4957" y="850"/>
                    </a:lnTo>
                    <a:lnTo>
                      <a:pt x="4971" y="850"/>
                    </a:lnTo>
                    <a:lnTo>
                      <a:pt x="4984" y="850"/>
                    </a:lnTo>
                    <a:lnTo>
                      <a:pt x="4998" y="850"/>
                    </a:lnTo>
                    <a:lnTo>
                      <a:pt x="5012" y="850"/>
                    </a:lnTo>
                    <a:lnTo>
                      <a:pt x="5026" y="850"/>
                    </a:lnTo>
                    <a:lnTo>
                      <a:pt x="5043" y="850"/>
                    </a:lnTo>
                    <a:lnTo>
                      <a:pt x="5057" y="850"/>
                    </a:lnTo>
                    <a:lnTo>
                      <a:pt x="5071" y="850"/>
                    </a:lnTo>
                    <a:lnTo>
                      <a:pt x="5085" y="850"/>
                    </a:lnTo>
                    <a:lnTo>
                      <a:pt x="5099" y="850"/>
                    </a:lnTo>
                    <a:lnTo>
                      <a:pt x="5113" y="850"/>
                    </a:lnTo>
                    <a:lnTo>
                      <a:pt x="5127" y="850"/>
                    </a:lnTo>
                    <a:lnTo>
                      <a:pt x="5141" y="850"/>
                    </a:lnTo>
                    <a:lnTo>
                      <a:pt x="5154" y="850"/>
                    </a:lnTo>
                    <a:lnTo>
                      <a:pt x="5168" y="850"/>
                    </a:lnTo>
                    <a:lnTo>
                      <a:pt x="5182" y="850"/>
                    </a:lnTo>
                    <a:lnTo>
                      <a:pt x="5196" y="850"/>
                    </a:lnTo>
                    <a:lnTo>
                      <a:pt x="5210" y="850"/>
                    </a:lnTo>
                    <a:lnTo>
                      <a:pt x="5224" y="850"/>
                    </a:lnTo>
                    <a:lnTo>
                      <a:pt x="5238" y="850"/>
                    </a:lnTo>
                    <a:lnTo>
                      <a:pt x="5252" y="850"/>
                    </a:lnTo>
                    <a:lnTo>
                      <a:pt x="5265" y="850"/>
                    </a:lnTo>
                    <a:lnTo>
                      <a:pt x="5279" y="850"/>
                    </a:lnTo>
                    <a:lnTo>
                      <a:pt x="5293" y="850"/>
                    </a:lnTo>
                    <a:lnTo>
                      <a:pt x="5307" y="850"/>
                    </a:lnTo>
                    <a:lnTo>
                      <a:pt x="5321" y="850"/>
                    </a:lnTo>
                    <a:lnTo>
                      <a:pt x="5335" y="850"/>
                    </a:lnTo>
                    <a:lnTo>
                      <a:pt x="5349" y="850"/>
                    </a:lnTo>
                    <a:lnTo>
                      <a:pt x="5363" y="850"/>
                    </a:lnTo>
                    <a:lnTo>
                      <a:pt x="5376" y="850"/>
                    </a:lnTo>
                    <a:lnTo>
                      <a:pt x="5390" y="850"/>
                    </a:lnTo>
                    <a:lnTo>
                      <a:pt x="5404" y="850"/>
                    </a:lnTo>
                    <a:lnTo>
                      <a:pt x="5418" y="850"/>
                    </a:lnTo>
                    <a:lnTo>
                      <a:pt x="5432" y="850"/>
                    </a:lnTo>
                    <a:lnTo>
                      <a:pt x="5446" y="850"/>
                    </a:lnTo>
                    <a:lnTo>
                      <a:pt x="5460" y="850"/>
                    </a:lnTo>
                    <a:lnTo>
                      <a:pt x="5473" y="850"/>
                    </a:lnTo>
                    <a:lnTo>
                      <a:pt x="5487" y="850"/>
                    </a:lnTo>
                    <a:lnTo>
                      <a:pt x="5501" y="850"/>
                    </a:lnTo>
                    <a:lnTo>
                      <a:pt x="5515" y="850"/>
                    </a:lnTo>
                    <a:lnTo>
                      <a:pt x="5529" y="850"/>
                    </a:lnTo>
                    <a:lnTo>
                      <a:pt x="5543" y="850"/>
                    </a:lnTo>
                    <a:lnTo>
                      <a:pt x="5557" y="850"/>
                    </a:lnTo>
                    <a:lnTo>
                      <a:pt x="5574" y="850"/>
                    </a:lnTo>
                    <a:lnTo>
                      <a:pt x="5588" y="850"/>
                    </a:lnTo>
                    <a:lnTo>
                      <a:pt x="5602" y="850"/>
                    </a:lnTo>
                    <a:lnTo>
                      <a:pt x="5616" y="85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10" name="Rectangle 132">
                <a:extLst>
                  <a:ext uri="{FF2B5EF4-FFF2-40B4-BE49-F238E27FC236}">
                    <a16:creationId xmlns:a16="http://schemas.microsoft.com/office/drawing/2014/main" id="{742C766D-55B4-D6E3-5EFE-87B0885591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16020" y="3424024"/>
                <a:ext cx="71654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*</a:t>
                </a: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5.887 min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11" name="Rectangle 133">
                <a:extLst>
                  <a:ext uri="{FF2B5EF4-FFF2-40B4-BE49-F238E27FC236}">
                    <a16:creationId xmlns:a16="http://schemas.microsoft.com/office/drawing/2014/main" id="{1B9E8EBB-85F5-EA1F-2238-F80C4CC93B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1188" y="3343275"/>
                <a:ext cx="11266488" cy="1652588"/>
              </a:xfrm>
              <a:prstGeom prst="rect">
                <a:avLst/>
              </a:prstGeom>
              <a:noFill/>
              <a:ln w="11113" cap="flat">
                <a:solidFill>
                  <a:srgbClr val="F0F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12" name="Line 134">
                <a:extLst>
                  <a:ext uri="{FF2B5EF4-FFF2-40B4-BE49-F238E27FC236}">
                    <a16:creationId xmlns:a16="http://schemas.microsoft.com/office/drawing/2014/main" id="{EA0EFF6F-2AF7-90F3-0B28-258C8F0B66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28651" y="3481388"/>
                <a:ext cx="0" cy="1520825"/>
              </a:xfrm>
              <a:prstGeom prst="line">
                <a:avLst/>
              </a:prstGeom>
              <a:noFill/>
              <a:ln w="4763" cap="flat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13" name="Rectangle 135">
                <a:extLst>
                  <a:ext uri="{FF2B5EF4-FFF2-40B4-BE49-F238E27FC236}">
                    <a16:creationId xmlns:a16="http://schemas.microsoft.com/office/drawing/2014/main" id="{2A0F5FEC-5676-143F-D4FC-9DC58B34A1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9763" y="3481388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8080"/>
                    </a:solidFill>
                    <a:effectLst/>
                    <a:latin typeface="Helvetica" pitchFamily="2" charset="0"/>
                  </a:rPr>
                  <a:t>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18" name="Line 140">
                <a:extLst>
                  <a:ext uri="{FF2B5EF4-FFF2-40B4-BE49-F238E27FC236}">
                    <a16:creationId xmlns:a16="http://schemas.microsoft.com/office/drawing/2014/main" id="{93B409DE-41D0-BE10-8535-771B149516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00076" y="5149850"/>
                <a:ext cx="0" cy="1487488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19" name="Rectangle 141">
                <a:extLst>
                  <a:ext uri="{FF2B5EF4-FFF2-40B4-BE49-F238E27FC236}">
                    <a16:creationId xmlns:a16="http://schemas.microsoft.com/office/drawing/2014/main" id="{8A2B8A00-4535-FDA5-E648-540E528FE0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9751" y="5040313"/>
                <a:ext cx="28854" cy="6155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4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20" name="Rectangle 142">
                <a:extLst>
                  <a:ext uri="{FF2B5EF4-FFF2-40B4-BE49-F238E27FC236}">
                    <a16:creationId xmlns:a16="http://schemas.microsoft.com/office/drawing/2014/main" id="{A1FAFBF3-7850-BE2B-3A7F-31D11D8E86E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3863" y="5051425"/>
                <a:ext cx="102592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x1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21" name="Line 143">
                <a:extLst>
                  <a:ext uri="{FF2B5EF4-FFF2-40B4-BE49-F238E27FC236}">
                    <a16:creationId xmlns:a16="http://schemas.microsoft.com/office/drawing/2014/main" id="{B21A532D-8155-2F47-34DF-7686F4F11C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6637338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22" name="Rectangle 144">
                <a:extLst>
                  <a:ext uri="{FF2B5EF4-FFF2-40B4-BE49-F238E27FC236}">
                    <a16:creationId xmlns:a16="http://schemas.microsoft.com/office/drawing/2014/main" id="{993791DF-6140-CFB8-33F7-0AEB9CCADEC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988" y="6599238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23" name="Line 145">
                <a:extLst>
                  <a:ext uri="{FF2B5EF4-FFF2-40B4-BE49-F238E27FC236}">
                    <a16:creationId xmlns:a16="http://schemas.microsoft.com/office/drawing/2014/main" id="{5E0F7E7F-6AA2-C5E9-E53A-22166E8C8F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6505575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24" name="Rectangle 146">
                <a:extLst>
                  <a:ext uri="{FF2B5EF4-FFF2-40B4-BE49-F238E27FC236}">
                    <a16:creationId xmlns:a16="http://schemas.microsoft.com/office/drawing/2014/main" id="{A98D8D69-A152-575D-0277-029F6C45F6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6465888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25" name="Line 147">
                <a:extLst>
                  <a:ext uri="{FF2B5EF4-FFF2-40B4-BE49-F238E27FC236}">
                    <a16:creationId xmlns:a16="http://schemas.microsoft.com/office/drawing/2014/main" id="{70BD20D5-6146-E074-8EF6-D4DAA3BA32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6373813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26" name="Rectangle 148">
                <a:extLst>
                  <a:ext uri="{FF2B5EF4-FFF2-40B4-BE49-F238E27FC236}">
                    <a16:creationId xmlns:a16="http://schemas.microsoft.com/office/drawing/2014/main" id="{2AC2D229-61F0-AB7E-B1D1-AF1EDAA047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6334125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27" name="Line 149">
                <a:extLst>
                  <a:ext uri="{FF2B5EF4-FFF2-40B4-BE49-F238E27FC236}">
                    <a16:creationId xmlns:a16="http://schemas.microsoft.com/office/drawing/2014/main" id="{20FFFD94-8F06-9B51-0838-75F0E942AA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6240463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28" name="Rectangle 150">
                <a:extLst>
                  <a:ext uri="{FF2B5EF4-FFF2-40B4-BE49-F238E27FC236}">
                    <a16:creationId xmlns:a16="http://schemas.microsoft.com/office/drawing/2014/main" id="{9C61E5A9-41DF-2A79-9565-68CF0DF8C45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62023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29" name="Line 151">
                <a:extLst>
                  <a:ext uri="{FF2B5EF4-FFF2-40B4-BE49-F238E27FC236}">
                    <a16:creationId xmlns:a16="http://schemas.microsoft.com/office/drawing/2014/main" id="{F717F95B-75D6-40D8-A36E-8357D8ABB8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6115050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30" name="Rectangle 152">
                <a:extLst>
                  <a:ext uri="{FF2B5EF4-FFF2-40B4-BE49-F238E27FC236}">
                    <a16:creationId xmlns:a16="http://schemas.microsoft.com/office/drawing/2014/main" id="{40FBDA5A-A02D-5B5D-8A55-85D7EF93B7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60753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31" name="Line 153">
                <a:extLst>
                  <a:ext uri="{FF2B5EF4-FFF2-40B4-BE49-F238E27FC236}">
                    <a16:creationId xmlns:a16="http://schemas.microsoft.com/office/drawing/2014/main" id="{C5F9996E-8DB7-03E3-5EAE-4E7A3089E5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5981700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32" name="Rectangle 154">
                <a:extLst>
                  <a:ext uri="{FF2B5EF4-FFF2-40B4-BE49-F238E27FC236}">
                    <a16:creationId xmlns:a16="http://schemas.microsoft.com/office/drawing/2014/main" id="{3190DCC9-51E9-67A9-53A1-64939A83264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988" y="5943600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33" name="Line 155">
                <a:extLst>
                  <a:ext uri="{FF2B5EF4-FFF2-40B4-BE49-F238E27FC236}">
                    <a16:creationId xmlns:a16="http://schemas.microsoft.com/office/drawing/2014/main" id="{BCBD14A9-2547-CF0D-67D7-5A43AA2BEF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5849938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34" name="Rectangle 156">
                <a:extLst>
                  <a:ext uri="{FF2B5EF4-FFF2-40B4-BE49-F238E27FC236}">
                    <a16:creationId xmlns:a16="http://schemas.microsoft.com/office/drawing/2014/main" id="{6DCBE549-B3DA-A454-2637-606041E9E7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5810250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35" name="Line 157">
                <a:extLst>
                  <a:ext uri="{FF2B5EF4-FFF2-40B4-BE49-F238E27FC236}">
                    <a16:creationId xmlns:a16="http://schemas.microsoft.com/office/drawing/2014/main" id="{E007219F-5DA6-C496-BBF4-FA20BA886C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5718175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36" name="Rectangle 158">
                <a:extLst>
                  <a:ext uri="{FF2B5EF4-FFF2-40B4-BE49-F238E27FC236}">
                    <a16:creationId xmlns:a16="http://schemas.microsoft.com/office/drawing/2014/main" id="{AEC1B5EA-DF01-C635-5BC7-88D1E20B1DD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5678488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37" name="Line 159">
                <a:extLst>
                  <a:ext uri="{FF2B5EF4-FFF2-40B4-BE49-F238E27FC236}">
                    <a16:creationId xmlns:a16="http://schemas.microsoft.com/office/drawing/2014/main" id="{93ACD2DA-31A2-77F6-8ADB-35360390D8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5584825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38" name="Rectangle 160">
                <a:extLst>
                  <a:ext uri="{FF2B5EF4-FFF2-40B4-BE49-F238E27FC236}">
                    <a16:creationId xmlns:a16="http://schemas.microsoft.com/office/drawing/2014/main" id="{9002202A-6E0F-0017-8257-799AA5F7B82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5546725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39" name="Line 161">
                <a:extLst>
                  <a:ext uri="{FF2B5EF4-FFF2-40B4-BE49-F238E27FC236}">
                    <a16:creationId xmlns:a16="http://schemas.microsoft.com/office/drawing/2014/main" id="{03F838BA-51EE-DF6F-D25F-0ED2FA85C8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5453063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40" name="Rectangle 162">
                <a:extLst>
                  <a:ext uri="{FF2B5EF4-FFF2-40B4-BE49-F238E27FC236}">
                    <a16:creationId xmlns:a16="http://schemas.microsoft.com/office/drawing/2014/main" id="{5C6517AB-25B3-BDE4-A579-63574E07A41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54149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41" name="Line 163">
                <a:extLst>
                  <a:ext uri="{FF2B5EF4-FFF2-40B4-BE49-F238E27FC236}">
                    <a16:creationId xmlns:a16="http://schemas.microsoft.com/office/drawing/2014/main" id="{B0D56D90-2B21-9794-FB83-D61373726D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5326063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42" name="Rectangle 164">
                <a:extLst>
                  <a:ext uri="{FF2B5EF4-FFF2-40B4-BE49-F238E27FC236}">
                    <a16:creationId xmlns:a16="http://schemas.microsoft.com/office/drawing/2014/main" id="{3D211ED7-A8FA-C99C-B01B-4F926DB2CD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988" y="5287963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43" name="Line 165">
                <a:extLst>
                  <a:ext uri="{FF2B5EF4-FFF2-40B4-BE49-F238E27FC236}">
                    <a16:creationId xmlns:a16="http://schemas.microsoft.com/office/drawing/2014/main" id="{30722F28-A5D5-831D-3515-EB913569EC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77851" y="5194300"/>
                <a:ext cx="222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44" name="Rectangle 166">
                <a:extLst>
                  <a:ext uri="{FF2B5EF4-FFF2-40B4-BE49-F238E27FC236}">
                    <a16:creationId xmlns:a16="http://schemas.microsoft.com/office/drawing/2014/main" id="{2DAA4E3C-26A0-1133-AEF6-5808AFBCA8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88" y="5156200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.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45" name="Rectangle 167">
                <a:extLst>
                  <a:ext uri="{FF2B5EF4-FFF2-40B4-BE49-F238E27FC236}">
                    <a16:creationId xmlns:a16="http://schemas.microsoft.com/office/drawing/2014/main" id="{1CAD76E9-493D-81B2-9173-43702C12360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6426" y="5006975"/>
                <a:ext cx="11277600" cy="166370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46" name="Rectangle 168">
                <a:extLst>
                  <a:ext uri="{FF2B5EF4-FFF2-40B4-BE49-F238E27FC236}">
                    <a16:creationId xmlns:a16="http://schemas.microsoft.com/office/drawing/2014/main" id="{45F3E0F1-BA0E-A367-71B8-682C625E12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7538" y="5149850"/>
                <a:ext cx="11249025" cy="148748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49" name="Freeform 171">
                <a:extLst>
                  <a:ext uri="{FF2B5EF4-FFF2-40B4-BE49-F238E27FC236}">
                    <a16:creationId xmlns:a16="http://schemas.microsoft.com/office/drawing/2014/main" id="{1B367F5D-A9A3-222D-0581-466E3A31238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72326" y="5286375"/>
                <a:ext cx="398463" cy="1341438"/>
              </a:xfrm>
              <a:custGeom>
                <a:avLst/>
                <a:gdLst>
                  <a:gd name="T0" fmla="*/ 0 w 251"/>
                  <a:gd name="T1" fmla="*/ 845 h 845"/>
                  <a:gd name="T2" fmla="*/ 14 w 251"/>
                  <a:gd name="T3" fmla="*/ 790 h 845"/>
                  <a:gd name="T4" fmla="*/ 28 w 251"/>
                  <a:gd name="T5" fmla="*/ 562 h 845"/>
                  <a:gd name="T6" fmla="*/ 42 w 251"/>
                  <a:gd name="T7" fmla="*/ 230 h 845"/>
                  <a:gd name="T8" fmla="*/ 56 w 251"/>
                  <a:gd name="T9" fmla="*/ 28 h 845"/>
                  <a:gd name="T10" fmla="*/ 70 w 251"/>
                  <a:gd name="T11" fmla="*/ 0 h 845"/>
                  <a:gd name="T12" fmla="*/ 84 w 251"/>
                  <a:gd name="T13" fmla="*/ 133 h 845"/>
                  <a:gd name="T14" fmla="*/ 98 w 251"/>
                  <a:gd name="T15" fmla="*/ 342 h 845"/>
                  <a:gd name="T16" fmla="*/ 112 w 251"/>
                  <a:gd name="T17" fmla="*/ 516 h 845"/>
                  <a:gd name="T18" fmla="*/ 126 w 251"/>
                  <a:gd name="T19" fmla="*/ 644 h 845"/>
                  <a:gd name="T20" fmla="*/ 140 w 251"/>
                  <a:gd name="T21" fmla="*/ 717 h 845"/>
                  <a:gd name="T22" fmla="*/ 154 w 251"/>
                  <a:gd name="T23" fmla="*/ 764 h 845"/>
                  <a:gd name="T24" fmla="*/ 168 w 251"/>
                  <a:gd name="T25" fmla="*/ 791 h 845"/>
                  <a:gd name="T26" fmla="*/ 182 w 251"/>
                  <a:gd name="T27" fmla="*/ 806 h 845"/>
                  <a:gd name="T28" fmla="*/ 195 w 251"/>
                  <a:gd name="T29" fmla="*/ 823 h 845"/>
                  <a:gd name="T30" fmla="*/ 210 w 251"/>
                  <a:gd name="T31" fmla="*/ 834 h 845"/>
                  <a:gd name="T32" fmla="*/ 223 w 251"/>
                  <a:gd name="T33" fmla="*/ 837 h 845"/>
                  <a:gd name="T34" fmla="*/ 237 w 251"/>
                  <a:gd name="T35" fmla="*/ 839 h 845"/>
                  <a:gd name="T36" fmla="*/ 251 w 251"/>
                  <a:gd name="T37" fmla="*/ 841 h 845"/>
                  <a:gd name="T38" fmla="*/ 251 w 251"/>
                  <a:gd name="T39" fmla="*/ 841 h 845"/>
                  <a:gd name="T40" fmla="*/ 251 w 251"/>
                  <a:gd name="T41" fmla="*/ 841 h 845"/>
                  <a:gd name="T42" fmla="*/ 0 w 251"/>
                  <a:gd name="T43" fmla="*/ 845 h 845"/>
                  <a:gd name="T44" fmla="*/ 0 w 251"/>
                  <a:gd name="T45" fmla="*/ 845 h 84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</a:cxnLst>
                <a:rect l="0" t="0" r="r" b="b"/>
                <a:pathLst>
                  <a:path w="251" h="845">
                    <a:moveTo>
                      <a:pt x="0" y="845"/>
                    </a:moveTo>
                    <a:lnTo>
                      <a:pt x="14" y="790"/>
                    </a:lnTo>
                    <a:lnTo>
                      <a:pt x="28" y="562"/>
                    </a:lnTo>
                    <a:lnTo>
                      <a:pt x="42" y="230"/>
                    </a:lnTo>
                    <a:lnTo>
                      <a:pt x="56" y="28"/>
                    </a:lnTo>
                    <a:lnTo>
                      <a:pt x="70" y="0"/>
                    </a:lnTo>
                    <a:lnTo>
                      <a:pt x="84" y="133"/>
                    </a:lnTo>
                    <a:lnTo>
                      <a:pt x="98" y="342"/>
                    </a:lnTo>
                    <a:lnTo>
                      <a:pt x="112" y="516"/>
                    </a:lnTo>
                    <a:lnTo>
                      <a:pt x="126" y="644"/>
                    </a:lnTo>
                    <a:lnTo>
                      <a:pt x="140" y="717"/>
                    </a:lnTo>
                    <a:lnTo>
                      <a:pt x="154" y="764"/>
                    </a:lnTo>
                    <a:lnTo>
                      <a:pt x="168" y="791"/>
                    </a:lnTo>
                    <a:lnTo>
                      <a:pt x="182" y="806"/>
                    </a:lnTo>
                    <a:lnTo>
                      <a:pt x="195" y="823"/>
                    </a:lnTo>
                    <a:lnTo>
                      <a:pt x="210" y="834"/>
                    </a:lnTo>
                    <a:lnTo>
                      <a:pt x="223" y="837"/>
                    </a:lnTo>
                    <a:lnTo>
                      <a:pt x="237" y="839"/>
                    </a:lnTo>
                    <a:lnTo>
                      <a:pt x="251" y="841"/>
                    </a:lnTo>
                    <a:lnTo>
                      <a:pt x="251" y="841"/>
                    </a:lnTo>
                    <a:lnTo>
                      <a:pt x="251" y="841"/>
                    </a:lnTo>
                    <a:lnTo>
                      <a:pt x="0" y="845"/>
                    </a:lnTo>
                    <a:lnTo>
                      <a:pt x="0" y="845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51" name="Freeform 173">
                <a:extLst>
                  <a:ext uri="{FF2B5EF4-FFF2-40B4-BE49-F238E27FC236}">
                    <a16:creationId xmlns:a16="http://schemas.microsoft.com/office/drawing/2014/main" id="{99456DCF-1B91-5B89-1F4B-7FA49AF4B93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72326" y="6621463"/>
                <a:ext cx="398463" cy="6350"/>
              </a:xfrm>
              <a:custGeom>
                <a:avLst/>
                <a:gdLst>
                  <a:gd name="T0" fmla="*/ 0 w 251"/>
                  <a:gd name="T1" fmla="*/ 4 h 4"/>
                  <a:gd name="T2" fmla="*/ 0 w 251"/>
                  <a:gd name="T3" fmla="*/ 4 h 4"/>
                  <a:gd name="T4" fmla="*/ 251 w 251"/>
                  <a:gd name="T5" fmla="*/ 0 h 4"/>
                  <a:gd name="T6" fmla="*/ 251 w 251"/>
                  <a:gd name="T7" fmla="*/ 0 h 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</a:cxnLst>
                <a:rect l="0" t="0" r="r" b="b"/>
                <a:pathLst>
                  <a:path w="251" h="4">
                    <a:moveTo>
                      <a:pt x="0" y="4"/>
                    </a:moveTo>
                    <a:lnTo>
                      <a:pt x="0" y="4"/>
                    </a:lnTo>
                    <a:lnTo>
                      <a:pt x="251" y="0"/>
                    </a:lnTo>
                    <a:lnTo>
                      <a:pt x="251" y="0"/>
                    </a:lnTo>
                  </a:path>
                </a:pathLst>
              </a:custGeom>
              <a:noFill/>
              <a:ln w="4763" cap="flat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52" name="Freeform 174">
                <a:extLst>
                  <a:ext uri="{FF2B5EF4-FFF2-40B4-BE49-F238E27FC236}">
                    <a16:creationId xmlns:a16="http://schemas.microsoft.com/office/drawing/2014/main" id="{589FC3C2-FDE7-29A3-6EE9-EB1510D657B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941638" y="5287963"/>
                <a:ext cx="8909050" cy="1349375"/>
              </a:xfrm>
              <a:custGeom>
                <a:avLst/>
                <a:gdLst>
                  <a:gd name="T0" fmla="*/ 84 w 5613"/>
                  <a:gd name="T1" fmla="*/ 850 h 850"/>
                  <a:gd name="T2" fmla="*/ 181 w 5613"/>
                  <a:gd name="T3" fmla="*/ 850 h 850"/>
                  <a:gd name="T4" fmla="*/ 278 w 5613"/>
                  <a:gd name="T5" fmla="*/ 850 h 850"/>
                  <a:gd name="T6" fmla="*/ 375 w 5613"/>
                  <a:gd name="T7" fmla="*/ 850 h 850"/>
                  <a:gd name="T8" fmla="*/ 472 w 5613"/>
                  <a:gd name="T9" fmla="*/ 850 h 850"/>
                  <a:gd name="T10" fmla="*/ 573 w 5613"/>
                  <a:gd name="T11" fmla="*/ 850 h 850"/>
                  <a:gd name="T12" fmla="*/ 670 w 5613"/>
                  <a:gd name="T13" fmla="*/ 850 h 850"/>
                  <a:gd name="T14" fmla="*/ 767 w 5613"/>
                  <a:gd name="T15" fmla="*/ 850 h 850"/>
                  <a:gd name="T16" fmla="*/ 864 w 5613"/>
                  <a:gd name="T17" fmla="*/ 850 h 850"/>
                  <a:gd name="T18" fmla="*/ 961 w 5613"/>
                  <a:gd name="T19" fmla="*/ 850 h 850"/>
                  <a:gd name="T20" fmla="*/ 1058 w 5613"/>
                  <a:gd name="T21" fmla="*/ 850 h 850"/>
                  <a:gd name="T22" fmla="*/ 1159 w 5613"/>
                  <a:gd name="T23" fmla="*/ 850 h 850"/>
                  <a:gd name="T24" fmla="*/ 1256 w 5613"/>
                  <a:gd name="T25" fmla="*/ 850 h 850"/>
                  <a:gd name="T26" fmla="*/ 1353 w 5613"/>
                  <a:gd name="T27" fmla="*/ 850 h 850"/>
                  <a:gd name="T28" fmla="*/ 1450 w 5613"/>
                  <a:gd name="T29" fmla="*/ 850 h 850"/>
                  <a:gd name="T30" fmla="*/ 1547 w 5613"/>
                  <a:gd name="T31" fmla="*/ 850 h 850"/>
                  <a:gd name="T32" fmla="*/ 1648 w 5613"/>
                  <a:gd name="T33" fmla="*/ 850 h 850"/>
                  <a:gd name="T34" fmla="*/ 1745 w 5613"/>
                  <a:gd name="T35" fmla="*/ 850 h 850"/>
                  <a:gd name="T36" fmla="*/ 1842 w 5613"/>
                  <a:gd name="T37" fmla="*/ 850 h 850"/>
                  <a:gd name="T38" fmla="*/ 1939 w 5613"/>
                  <a:gd name="T39" fmla="*/ 850 h 850"/>
                  <a:gd name="T40" fmla="*/ 2037 w 5613"/>
                  <a:gd name="T41" fmla="*/ 850 h 850"/>
                  <a:gd name="T42" fmla="*/ 2134 w 5613"/>
                  <a:gd name="T43" fmla="*/ 850 h 850"/>
                  <a:gd name="T44" fmla="*/ 2234 w 5613"/>
                  <a:gd name="T45" fmla="*/ 850 h 850"/>
                  <a:gd name="T46" fmla="*/ 2331 w 5613"/>
                  <a:gd name="T47" fmla="*/ 850 h 850"/>
                  <a:gd name="T48" fmla="*/ 2429 w 5613"/>
                  <a:gd name="T49" fmla="*/ 850 h 850"/>
                  <a:gd name="T50" fmla="*/ 2526 w 5613"/>
                  <a:gd name="T51" fmla="*/ 850 h 850"/>
                  <a:gd name="T52" fmla="*/ 2623 w 5613"/>
                  <a:gd name="T53" fmla="*/ 850 h 850"/>
                  <a:gd name="T54" fmla="*/ 2723 w 5613"/>
                  <a:gd name="T55" fmla="*/ 28 h 850"/>
                  <a:gd name="T56" fmla="*/ 2820 w 5613"/>
                  <a:gd name="T57" fmla="*/ 763 h 850"/>
                  <a:gd name="T58" fmla="*/ 2918 w 5613"/>
                  <a:gd name="T59" fmla="*/ 840 h 850"/>
                  <a:gd name="T60" fmla="*/ 3015 w 5613"/>
                  <a:gd name="T61" fmla="*/ 850 h 850"/>
                  <a:gd name="T62" fmla="*/ 3112 w 5613"/>
                  <a:gd name="T63" fmla="*/ 850 h 850"/>
                  <a:gd name="T64" fmla="*/ 3209 w 5613"/>
                  <a:gd name="T65" fmla="*/ 840 h 850"/>
                  <a:gd name="T66" fmla="*/ 3310 w 5613"/>
                  <a:gd name="T67" fmla="*/ 850 h 850"/>
                  <a:gd name="T68" fmla="*/ 3407 w 5613"/>
                  <a:gd name="T69" fmla="*/ 850 h 850"/>
                  <a:gd name="T70" fmla="*/ 3504 w 5613"/>
                  <a:gd name="T71" fmla="*/ 850 h 850"/>
                  <a:gd name="T72" fmla="*/ 3601 w 5613"/>
                  <a:gd name="T73" fmla="*/ 850 h 850"/>
                  <a:gd name="T74" fmla="*/ 3698 w 5613"/>
                  <a:gd name="T75" fmla="*/ 850 h 850"/>
                  <a:gd name="T76" fmla="*/ 3799 w 5613"/>
                  <a:gd name="T77" fmla="*/ 850 h 850"/>
                  <a:gd name="T78" fmla="*/ 3896 w 5613"/>
                  <a:gd name="T79" fmla="*/ 850 h 850"/>
                  <a:gd name="T80" fmla="*/ 3993 w 5613"/>
                  <a:gd name="T81" fmla="*/ 850 h 850"/>
                  <a:gd name="T82" fmla="*/ 4090 w 5613"/>
                  <a:gd name="T83" fmla="*/ 850 h 850"/>
                  <a:gd name="T84" fmla="*/ 4187 w 5613"/>
                  <a:gd name="T85" fmla="*/ 850 h 850"/>
                  <a:gd name="T86" fmla="*/ 4284 w 5613"/>
                  <a:gd name="T87" fmla="*/ 850 h 850"/>
                  <a:gd name="T88" fmla="*/ 4385 w 5613"/>
                  <a:gd name="T89" fmla="*/ 850 h 850"/>
                  <a:gd name="T90" fmla="*/ 4482 w 5613"/>
                  <a:gd name="T91" fmla="*/ 850 h 850"/>
                  <a:gd name="T92" fmla="*/ 4579 w 5613"/>
                  <a:gd name="T93" fmla="*/ 850 h 850"/>
                  <a:gd name="T94" fmla="*/ 4676 w 5613"/>
                  <a:gd name="T95" fmla="*/ 850 h 850"/>
                  <a:gd name="T96" fmla="*/ 4773 w 5613"/>
                  <a:gd name="T97" fmla="*/ 850 h 850"/>
                  <a:gd name="T98" fmla="*/ 4874 w 5613"/>
                  <a:gd name="T99" fmla="*/ 850 h 850"/>
                  <a:gd name="T100" fmla="*/ 4971 w 5613"/>
                  <a:gd name="T101" fmla="*/ 850 h 850"/>
                  <a:gd name="T102" fmla="*/ 5068 w 5613"/>
                  <a:gd name="T103" fmla="*/ 850 h 850"/>
                  <a:gd name="T104" fmla="*/ 5165 w 5613"/>
                  <a:gd name="T105" fmla="*/ 850 h 850"/>
                  <a:gd name="T106" fmla="*/ 5262 w 5613"/>
                  <a:gd name="T107" fmla="*/ 850 h 850"/>
                  <a:gd name="T108" fmla="*/ 5360 w 5613"/>
                  <a:gd name="T109" fmla="*/ 850 h 850"/>
                  <a:gd name="T110" fmla="*/ 5460 w 5613"/>
                  <a:gd name="T111" fmla="*/ 850 h 850"/>
                  <a:gd name="T112" fmla="*/ 5557 w 5613"/>
                  <a:gd name="T113" fmla="*/ 850 h 85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  <a:cxn ang="0">
                    <a:pos x="T62" y="T63"/>
                  </a:cxn>
                  <a:cxn ang="0">
                    <a:pos x="T64" y="T65"/>
                  </a:cxn>
                  <a:cxn ang="0">
                    <a:pos x="T66" y="T67"/>
                  </a:cxn>
                  <a:cxn ang="0">
                    <a:pos x="T68" y="T69"/>
                  </a:cxn>
                  <a:cxn ang="0">
                    <a:pos x="T70" y="T71"/>
                  </a:cxn>
                  <a:cxn ang="0">
                    <a:pos x="T72" y="T73"/>
                  </a:cxn>
                  <a:cxn ang="0">
                    <a:pos x="T74" y="T75"/>
                  </a:cxn>
                  <a:cxn ang="0">
                    <a:pos x="T76" y="T77"/>
                  </a:cxn>
                  <a:cxn ang="0">
                    <a:pos x="T78" y="T79"/>
                  </a:cxn>
                  <a:cxn ang="0">
                    <a:pos x="T80" y="T81"/>
                  </a:cxn>
                  <a:cxn ang="0">
                    <a:pos x="T82" y="T83"/>
                  </a:cxn>
                  <a:cxn ang="0">
                    <a:pos x="T84" y="T85"/>
                  </a:cxn>
                  <a:cxn ang="0">
                    <a:pos x="T86" y="T87"/>
                  </a:cxn>
                  <a:cxn ang="0">
                    <a:pos x="T88" y="T89"/>
                  </a:cxn>
                  <a:cxn ang="0">
                    <a:pos x="T90" y="T91"/>
                  </a:cxn>
                  <a:cxn ang="0">
                    <a:pos x="T92" y="T93"/>
                  </a:cxn>
                  <a:cxn ang="0">
                    <a:pos x="T94" y="T95"/>
                  </a:cxn>
                  <a:cxn ang="0">
                    <a:pos x="T96" y="T97"/>
                  </a:cxn>
                  <a:cxn ang="0">
                    <a:pos x="T98" y="T99"/>
                  </a:cxn>
                  <a:cxn ang="0">
                    <a:pos x="T100" y="T101"/>
                  </a:cxn>
                  <a:cxn ang="0">
                    <a:pos x="T102" y="T103"/>
                  </a:cxn>
                  <a:cxn ang="0">
                    <a:pos x="T104" y="T105"/>
                  </a:cxn>
                  <a:cxn ang="0">
                    <a:pos x="T106" y="T107"/>
                  </a:cxn>
                  <a:cxn ang="0">
                    <a:pos x="T108" y="T109"/>
                  </a:cxn>
                  <a:cxn ang="0">
                    <a:pos x="T110" y="T111"/>
                  </a:cxn>
                  <a:cxn ang="0">
                    <a:pos x="T112" y="T113"/>
                  </a:cxn>
                </a:cxnLst>
                <a:rect l="0" t="0" r="r" b="b"/>
                <a:pathLst>
                  <a:path w="5613" h="850">
                    <a:moveTo>
                      <a:pt x="0" y="850"/>
                    </a:moveTo>
                    <a:lnTo>
                      <a:pt x="14" y="850"/>
                    </a:lnTo>
                    <a:lnTo>
                      <a:pt x="28" y="850"/>
                    </a:lnTo>
                    <a:lnTo>
                      <a:pt x="42" y="850"/>
                    </a:lnTo>
                    <a:lnTo>
                      <a:pt x="56" y="850"/>
                    </a:lnTo>
                    <a:lnTo>
                      <a:pt x="70" y="850"/>
                    </a:lnTo>
                    <a:lnTo>
                      <a:pt x="84" y="850"/>
                    </a:lnTo>
                    <a:lnTo>
                      <a:pt x="98" y="850"/>
                    </a:lnTo>
                    <a:lnTo>
                      <a:pt x="111" y="850"/>
                    </a:lnTo>
                    <a:lnTo>
                      <a:pt x="125" y="850"/>
                    </a:lnTo>
                    <a:lnTo>
                      <a:pt x="139" y="850"/>
                    </a:lnTo>
                    <a:lnTo>
                      <a:pt x="153" y="850"/>
                    </a:lnTo>
                    <a:lnTo>
                      <a:pt x="167" y="850"/>
                    </a:lnTo>
                    <a:lnTo>
                      <a:pt x="181" y="850"/>
                    </a:lnTo>
                    <a:lnTo>
                      <a:pt x="195" y="850"/>
                    </a:lnTo>
                    <a:lnTo>
                      <a:pt x="209" y="850"/>
                    </a:lnTo>
                    <a:lnTo>
                      <a:pt x="222" y="850"/>
                    </a:lnTo>
                    <a:lnTo>
                      <a:pt x="236" y="850"/>
                    </a:lnTo>
                    <a:lnTo>
                      <a:pt x="250" y="850"/>
                    </a:lnTo>
                    <a:lnTo>
                      <a:pt x="264" y="850"/>
                    </a:lnTo>
                    <a:lnTo>
                      <a:pt x="278" y="850"/>
                    </a:lnTo>
                    <a:lnTo>
                      <a:pt x="292" y="850"/>
                    </a:lnTo>
                    <a:lnTo>
                      <a:pt x="306" y="850"/>
                    </a:lnTo>
                    <a:lnTo>
                      <a:pt x="320" y="850"/>
                    </a:lnTo>
                    <a:lnTo>
                      <a:pt x="333" y="850"/>
                    </a:lnTo>
                    <a:lnTo>
                      <a:pt x="347" y="850"/>
                    </a:lnTo>
                    <a:lnTo>
                      <a:pt x="361" y="850"/>
                    </a:lnTo>
                    <a:lnTo>
                      <a:pt x="375" y="850"/>
                    </a:lnTo>
                    <a:lnTo>
                      <a:pt x="389" y="850"/>
                    </a:lnTo>
                    <a:lnTo>
                      <a:pt x="403" y="850"/>
                    </a:lnTo>
                    <a:lnTo>
                      <a:pt x="417" y="850"/>
                    </a:lnTo>
                    <a:lnTo>
                      <a:pt x="431" y="850"/>
                    </a:lnTo>
                    <a:lnTo>
                      <a:pt x="444" y="850"/>
                    </a:lnTo>
                    <a:lnTo>
                      <a:pt x="458" y="850"/>
                    </a:lnTo>
                    <a:lnTo>
                      <a:pt x="472" y="850"/>
                    </a:lnTo>
                    <a:lnTo>
                      <a:pt x="486" y="850"/>
                    </a:lnTo>
                    <a:lnTo>
                      <a:pt x="500" y="850"/>
                    </a:lnTo>
                    <a:lnTo>
                      <a:pt x="514" y="850"/>
                    </a:lnTo>
                    <a:lnTo>
                      <a:pt x="528" y="850"/>
                    </a:lnTo>
                    <a:lnTo>
                      <a:pt x="545" y="850"/>
                    </a:lnTo>
                    <a:lnTo>
                      <a:pt x="559" y="850"/>
                    </a:lnTo>
                    <a:lnTo>
                      <a:pt x="573" y="850"/>
                    </a:lnTo>
                    <a:lnTo>
                      <a:pt x="587" y="850"/>
                    </a:lnTo>
                    <a:lnTo>
                      <a:pt x="601" y="850"/>
                    </a:lnTo>
                    <a:lnTo>
                      <a:pt x="614" y="850"/>
                    </a:lnTo>
                    <a:lnTo>
                      <a:pt x="628" y="850"/>
                    </a:lnTo>
                    <a:lnTo>
                      <a:pt x="642" y="850"/>
                    </a:lnTo>
                    <a:lnTo>
                      <a:pt x="656" y="850"/>
                    </a:lnTo>
                    <a:lnTo>
                      <a:pt x="670" y="850"/>
                    </a:lnTo>
                    <a:lnTo>
                      <a:pt x="684" y="850"/>
                    </a:lnTo>
                    <a:lnTo>
                      <a:pt x="698" y="850"/>
                    </a:lnTo>
                    <a:lnTo>
                      <a:pt x="712" y="850"/>
                    </a:lnTo>
                    <a:lnTo>
                      <a:pt x="725" y="850"/>
                    </a:lnTo>
                    <a:lnTo>
                      <a:pt x="739" y="850"/>
                    </a:lnTo>
                    <a:lnTo>
                      <a:pt x="753" y="850"/>
                    </a:lnTo>
                    <a:lnTo>
                      <a:pt x="767" y="850"/>
                    </a:lnTo>
                    <a:lnTo>
                      <a:pt x="781" y="850"/>
                    </a:lnTo>
                    <a:lnTo>
                      <a:pt x="795" y="850"/>
                    </a:lnTo>
                    <a:lnTo>
                      <a:pt x="809" y="850"/>
                    </a:lnTo>
                    <a:lnTo>
                      <a:pt x="823" y="850"/>
                    </a:lnTo>
                    <a:lnTo>
                      <a:pt x="836" y="850"/>
                    </a:lnTo>
                    <a:lnTo>
                      <a:pt x="850" y="850"/>
                    </a:lnTo>
                    <a:lnTo>
                      <a:pt x="864" y="850"/>
                    </a:lnTo>
                    <a:lnTo>
                      <a:pt x="878" y="850"/>
                    </a:lnTo>
                    <a:lnTo>
                      <a:pt x="892" y="850"/>
                    </a:lnTo>
                    <a:lnTo>
                      <a:pt x="906" y="850"/>
                    </a:lnTo>
                    <a:lnTo>
                      <a:pt x="920" y="850"/>
                    </a:lnTo>
                    <a:lnTo>
                      <a:pt x="934" y="850"/>
                    </a:lnTo>
                    <a:lnTo>
                      <a:pt x="947" y="850"/>
                    </a:lnTo>
                    <a:lnTo>
                      <a:pt x="961" y="850"/>
                    </a:lnTo>
                    <a:lnTo>
                      <a:pt x="975" y="850"/>
                    </a:lnTo>
                    <a:lnTo>
                      <a:pt x="989" y="850"/>
                    </a:lnTo>
                    <a:lnTo>
                      <a:pt x="1003" y="850"/>
                    </a:lnTo>
                    <a:lnTo>
                      <a:pt x="1017" y="850"/>
                    </a:lnTo>
                    <a:lnTo>
                      <a:pt x="1031" y="850"/>
                    </a:lnTo>
                    <a:lnTo>
                      <a:pt x="1045" y="850"/>
                    </a:lnTo>
                    <a:lnTo>
                      <a:pt x="1058" y="850"/>
                    </a:lnTo>
                    <a:lnTo>
                      <a:pt x="1076" y="850"/>
                    </a:lnTo>
                    <a:lnTo>
                      <a:pt x="1090" y="850"/>
                    </a:lnTo>
                    <a:lnTo>
                      <a:pt x="1103" y="850"/>
                    </a:lnTo>
                    <a:lnTo>
                      <a:pt x="1117" y="850"/>
                    </a:lnTo>
                    <a:lnTo>
                      <a:pt x="1131" y="850"/>
                    </a:lnTo>
                    <a:lnTo>
                      <a:pt x="1145" y="850"/>
                    </a:lnTo>
                    <a:lnTo>
                      <a:pt x="1159" y="850"/>
                    </a:lnTo>
                    <a:lnTo>
                      <a:pt x="1173" y="850"/>
                    </a:lnTo>
                    <a:lnTo>
                      <a:pt x="1187" y="850"/>
                    </a:lnTo>
                    <a:lnTo>
                      <a:pt x="1201" y="850"/>
                    </a:lnTo>
                    <a:lnTo>
                      <a:pt x="1214" y="850"/>
                    </a:lnTo>
                    <a:lnTo>
                      <a:pt x="1228" y="850"/>
                    </a:lnTo>
                    <a:lnTo>
                      <a:pt x="1242" y="850"/>
                    </a:lnTo>
                    <a:lnTo>
                      <a:pt x="1256" y="850"/>
                    </a:lnTo>
                    <a:lnTo>
                      <a:pt x="1270" y="850"/>
                    </a:lnTo>
                    <a:lnTo>
                      <a:pt x="1284" y="850"/>
                    </a:lnTo>
                    <a:lnTo>
                      <a:pt x="1298" y="850"/>
                    </a:lnTo>
                    <a:lnTo>
                      <a:pt x="1312" y="850"/>
                    </a:lnTo>
                    <a:lnTo>
                      <a:pt x="1325" y="850"/>
                    </a:lnTo>
                    <a:lnTo>
                      <a:pt x="1339" y="850"/>
                    </a:lnTo>
                    <a:lnTo>
                      <a:pt x="1353" y="850"/>
                    </a:lnTo>
                    <a:lnTo>
                      <a:pt x="1367" y="850"/>
                    </a:lnTo>
                    <a:lnTo>
                      <a:pt x="1381" y="850"/>
                    </a:lnTo>
                    <a:lnTo>
                      <a:pt x="1395" y="850"/>
                    </a:lnTo>
                    <a:lnTo>
                      <a:pt x="1409" y="850"/>
                    </a:lnTo>
                    <a:lnTo>
                      <a:pt x="1423" y="850"/>
                    </a:lnTo>
                    <a:lnTo>
                      <a:pt x="1436" y="850"/>
                    </a:lnTo>
                    <a:lnTo>
                      <a:pt x="1450" y="850"/>
                    </a:lnTo>
                    <a:lnTo>
                      <a:pt x="1464" y="850"/>
                    </a:lnTo>
                    <a:lnTo>
                      <a:pt x="1478" y="850"/>
                    </a:lnTo>
                    <a:lnTo>
                      <a:pt x="1492" y="850"/>
                    </a:lnTo>
                    <a:lnTo>
                      <a:pt x="1506" y="850"/>
                    </a:lnTo>
                    <a:lnTo>
                      <a:pt x="1520" y="850"/>
                    </a:lnTo>
                    <a:lnTo>
                      <a:pt x="1534" y="850"/>
                    </a:lnTo>
                    <a:lnTo>
                      <a:pt x="1547" y="850"/>
                    </a:lnTo>
                    <a:lnTo>
                      <a:pt x="1561" y="850"/>
                    </a:lnTo>
                    <a:lnTo>
                      <a:pt x="1575" y="850"/>
                    </a:lnTo>
                    <a:lnTo>
                      <a:pt x="1589" y="850"/>
                    </a:lnTo>
                    <a:lnTo>
                      <a:pt x="1603" y="850"/>
                    </a:lnTo>
                    <a:lnTo>
                      <a:pt x="1620" y="850"/>
                    </a:lnTo>
                    <a:lnTo>
                      <a:pt x="1634" y="850"/>
                    </a:lnTo>
                    <a:lnTo>
                      <a:pt x="1648" y="850"/>
                    </a:lnTo>
                    <a:lnTo>
                      <a:pt x="1662" y="850"/>
                    </a:lnTo>
                    <a:lnTo>
                      <a:pt x="1676" y="850"/>
                    </a:lnTo>
                    <a:lnTo>
                      <a:pt x="1690" y="850"/>
                    </a:lnTo>
                    <a:lnTo>
                      <a:pt x="1704" y="850"/>
                    </a:lnTo>
                    <a:lnTo>
                      <a:pt x="1717" y="850"/>
                    </a:lnTo>
                    <a:lnTo>
                      <a:pt x="1731" y="850"/>
                    </a:lnTo>
                    <a:lnTo>
                      <a:pt x="1745" y="850"/>
                    </a:lnTo>
                    <a:lnTo>
                      <a:pt x="1759" y="850"/>
                    </a:lnTo>
                    <a:lnTo>
                      <a:pt x="1773" y="850"/>
                    </a:lnTo>
                    <a:lnTo>
                      <a:pt x="1787" y="850"/>
                    </a:lnTo>
                    <a:lnTo>
                      <a:pt x="1801" y="850"/>
                    </a:lnTo>
                    <a:lnTo>
                      <a:pt x="1815" y="850"/>
                    </a:lnTo>
                    <a:lnTo>
                      <a:pt x="1828" y="850"/>
                    </a:lnTo>
                    <a:lnTo>
                      <a:pt x="1842" y="850"/>
                    </a:lnTo>
                    <a:lnTo>
                      <a:pt x="1856" y="850"/>
                    </a:lnTo>
                    <a:lnTo>
                      <a:pt x="1870" y="850"/>
                    </a:lnTo>
                    <a:lnTo>
                      <a:pt x="1884" y="850"/>
                    </a:lnTo>
                    <a:lnTo>
                      <a:pt x="1898" y="850"/>
                    </a:lnTo>
                    <a:lnTo>
                      <a:pt x="1912" y="850"/>
                    </a:lnTo>
                    <a:lnTo>
                      <a:pt x="1926" y="850"/>
                    </a:lnTo>
                    <a:lnTo>
                      <a:pt x="1939" y="850"/>
                    </a:lnTo>
                    <a:lnTo>
                      <a:pt x="1953" y="850"/>
                    </a:lnTo>
                    <a:lnTo>
                      <a:pt x="1967" y="850"/>
                    </a:lnTo>
                    <a:lnTo>
                      <a:pt x="1981" y="850"/>
                    </a:lnTo>
                    <a:lnTo>
                      <a:pt x="1995" y="850"/>
                    </a:lnTo>
                    <a:lnTo>
                      <a:pt x="2009" y="850"/>
                    </a:lnTo>
                    <a:lnTo>
                      <a:pt x="2023" y="850"/>
                    </a:lnTo>
                    <a:lnTo>
                      <a:pt x="2037" y="850"/>
                    </a:lnTo>
                    <a:lnTo>
                      <a:pt x="2050" y="850"/>
                    </a:lnTo>
                    <a:lnTo>
                      <a:pt x="2064" y="850"/>
                    </a:lnTo>
                    <a:lnTo>
                      <a:pt x="2078" y="850"/>
                    </a:lnTo>
                    <a:lnTo>
                      <a:pt x="2092" y="850"/>
                    </a:lnTo>
                    <a:lnTo>
                      <a:pt x="2106" y="850"/>
                    </a:lnTo>
                    <a:lnTo>
                      <a:pt x="2120" y="850"/>
                    </a:lnTo>
                    <a:lnTo>
                      <a:pt x="2134" y="850"/>
                    </a:lnTo>
                    <a:lnTo>
                      <a:pt x="2148" y="850"/>
                    </a:lnTo>
                    <a:lnTo>
                      <a:pt x="2165" y="850"/>
                    </a:lnTo>
                    <a:lnTo>
                      <a:pt x="2179" y="850"/>
                    </a:lnTo>
                    <a:lnTo>
                      <a:pt x="2193" y="850"/>
                    </a:lnTo>
                    <a:lnTo>
                      <a:pt x="2207" y="850"/>
                    </a:lnTo>
                    <a:lnTo>
                      <a:pt x="2220" y="850"/>
                    </a:lnTo>
                    <a:lnTo>
                      <a:pt x="2234" y="850"/>
                    </a:lnTo>
                    <a:lnTo>
                      <a:pt x="2248" y="850"/>
                    </a:lnTo>
                    <a:lnTo>
                      <a:pt x="2262" y="850"/>
                    </a:lnTo>
                    <a:lnTo>
                      <a:pt x="2276" y="850"/>
                    </a:lnTo>
                    <a:lnTo>
                      <a:pt x="2290" y="850"/>
                    </a:lnTo>
                    <a:lnTo>
                      <a:pt x="2304" y="850"/>
                    </a:lnTo>
                    <a:lnTo>
                      <a:pt x="2318" y="850"/>
                    </a:lnTo>
                    <a:lnTo>
                      <a:pt x="2331" y="850"/>
                    </a:lnTo>
                    <a:lnTo>
                      <a:pt x="2345" y="850"/>
                    </a:lnTo>
                    <a:lnTo>
                      <a:pt x="2359" y="850"/>
                    </a:lnTo>
                    <a:lnTo>
                      <a:pt x="2373" y="850"/>
                    </a:lnTo>
                    <a:lnTo>
                      <a:pt x="2387" y="850"/>
                    </a:lnTo>
                    <a:lnTo>
                      <a:pt x="2401" y="850"/>
                    </a:lnTo>
                    <a:lnTo>
                      <a:pt x="2415" y="850"/>
                    </a:lnTo>
                    <a:lnTo>
                      <a:pt x="2429" y="850"/>
                    </a:lnTo>
                    <a:lnTo>
                      <a:pt x="2442" y="850"/>
                    </a:lnTo>
                    <a:lnTo>
                      <a:pt x="2456" y="850"/>
                    </a:lnTo>
                    <a:lnTo>
                      <a:pt x="2470" y="850"/>
                    </a:lnTo>
                    <a:lnTo>
                      <a:pt x="2484" y="850"/>
                    </a:lnTo>
                    <a:lnTo>
                      <a:pt x="2498" y="850"/>
                    </a:lnTo>
                    <a:lnTo>
                      <a:pt x="2512" y="850"/>
                    </a:lnTo>
                    <a:lnTo>
                      <a:pt x="2526" y="850"/>
                    </a:lnTo>
                    <a:lnTo>
                      <a:pt x="2540" y="850"/>
                    </a:lnTo>
                    <a:lnTo>
                      <a:pt x="2553" y="850"/>
                    </a:lnTo>
                    <a:lnTo>
                      <a:pt x="2567" y="850"/>
                    </a:lnTo>
                    <a:lnTo>
                      <a:pt x="2581" y="850"/>
                    </a:lnTo>
                    <a:lnTo>
                      <a:pt x="2595" y="850"/>
                    </a:lnTo>
                    <a:lnTo>
                      <a:pt x="2609" y="850"/>
                    </a:lnTo>
                    <a:lnTo>
                      <a:pt x="2623" y="850"/>
                    </a:lnTo>
                    <a:lnTo>
                      <a:pt x="2637" y="850"/>
                    </a:lnTo>
                    <a:lnTo>
                      <a:pt x="2651" y="850"/>
                    </a:lnTo>
                    <a:lnTo>
                      <a:pt x="2664" y="843"/>
                    </a:lnTo>
                    <a:lnTo>
                      <a:pt x="2678" y="788"/>
                    </a:lnTo>
                    <a:lnTo>
                      <a:pt x="2696" y="562"/>
                    </a:lnTo>
                    <a:lnTo>
                      <a:pt x="2709" y="229"/>
                    </a:lnTo>
                    <a:lnTo>
                      <a:pt x="2723" y="28"/>
                    </a:lnTo>
                    <a:lnTo>
                      <a:pt x="2737" y="0"/>
                    </a:lnTo>
                    <a:lnTo>
                      <a:pt x="2751" y="132"/>
                    </a:lnTo>
                    <a:lnTo>
                      <a:pt x="2765" y="340"/>
                    </a:lnTo>
                    <a:lnTo>
                      <a:pt x="2779" y="514"/>
                    </a:lnTo>
                    <a:lnTo>
                      <a:pt x="2793" y="642"/>
                    </a:lnTo>
                    <a:lnTo>
                      <a:pt x="2807" y="715"/>
                    </a:lnTo>
                    <a:lnTo>
                      <a:pt x="2820" y="763"/>
                    </a:lnTo>
                    <a:lnTo>
                      <a:pt x="2834" y="791"/>
                    </a:lnTo>
                    <a:lnTo>
                      <a:pt x="2848" y="805"/>
                    </a:lnTo>
                    <a:lnTo>
                      <a:pt x="2862" y="822"/>
                    </a:lnTo>
                    <a:lnTo>
                      <a:pt x="2876" y="833"/>
                    </a:lnTo>
                    <a:lnTo>
                      <a:pt x="2890" y="836"/>
                    </a:lnTo>
                    <a:lnTo>
                      <a:pt x="2904" y="836"/>
                    </a:lnTo>
                    <a:lnTo>
                      <a:pt x="2918" y="840"/>
                    </a:lnTo>
                    <a:lnTo>
                      <a:pt x="2931" y="840"/>
                    </a:lnTo>
                    <a:lnTo>
                      <a:pt x="2945" y="843"/>
                    </a:lnTo>
                    <a:lnTo>
                      <a:pt x="2959" y="843"/>
                    </a:lnTo>
                    <a:lnTo>
                      <a:pt x="2973" y="843"/>
                    </a:lnTo>
                    <a:lnTo>
                      <a:pt x="2987" y="847"/>
                    </a:lnTo>
                    <a:lnTo>
                      <a:pt x="3001" y="847"/>
                    </a:lnTo>
                    <a:lnTo>
                      <a:pt x="3015" y="850"/>
                    </a:lnTo>
                    <a:lnTo>
                      <a:pt x="3029" y="850"/>
                    </a:lnTo>
                    <a:lnTo>
                      <a:pt x="3042" y="850"/>
                    </a:lnTo>
                    <a:lnTo>
                      <a:pt x="3056" y="850"/>
                    </a:lnTo>
                    <a:lnTo>
                      <a:pt x="3070" y="850"/>
                    </a:lnTo>
                    <a:lnTo>
                      <a:pt x="3084" y="850"/>
                    </a:lnTo>
                    <a:lnTo>
                      <a:pt x="3098" y="850"/>
                    </a:lnTo>
                    <a:lnTo>
                      <a:pt x="3112" y="850"/>
                    </a:lnTo>
                    <a:lnTo>
                      <a:pt x="3126" y="850"/>
                    </a:lnTo>
                    <a:lnTo>
                      <a:pt x="3140" y="850"/>
                    </a:lnTo>
                    <a:lnTo>
                      <a:pt x="3153" y="847"/>
                    </a:lnTo>
                    <a:lnTo>
                      <a:pt x="3167" y="840"/>
                    </a:lnTo>
                    <a:lnTo>
                      <a:pt x="3181" y="836"/>
                    </a:lnTo>
                    <a:lnTo>
                      <a:pt x="3195" y="833"/>
                    </a:lnTo>
                    <a:lnTo>
                      <a:pt x="3209" y="840"/>
                    </a:lnTo>
                    <a:lnTo>
                      <a:pt x="3223" y="843"/>
                    </a:lnTo>
                    <a:lnTo>
                      <a:pt x="3240" y="847"/>
                    </a:lnTo>
                    <a:lnTo>
                      <a:pt x="3254" y="847"/>
                    </a:lnTo>
                    <a:lnTo>
                      <a:pt x="3268" y="850"/>
                    </a:lnTo>
                    <a:lnTo>
                      <a:pt x="3282" y="850"/>
                    </a:lnTo>
                    <a:lnTo>
                      <a:pt x="3296" y="850"/>
                    </a:lnTo>
                    <a:lnTo>
                      <a:pt x="3310" y="850"/>
                    </a:lnTo>
                    <a:lnTo>
                      <a:pt x="3323" y="850"/>
                    </a:lnTo>
                    <a:lnTo>
                      <a:pt x="3337" y="850"/>
                    </a:lnTo>
                    <a:lnTo>
                      <a:pt x="3351" y="850"/>
                    </a:lnTo>
                    <a:lnTo>
                      <a:pt x="3365" y="850"/>
                    </a:lnTo>
                    <a:lnTo>
                      <a:pt x="3379" y="850"/>
                    </a:lnTo>
                    <a:lnTo>
                      <a:pt x="3393" y="850"/>
                    </a:lnTo>
                    <a:lnTo>
                      <a:pt x="3407" y="850"/>
                    </a:lnTo>
                    <a:lnTo>
                      <a:pt x="3421" y="850"/>
                    </a:lnTo>
                    <a:lnTo>
                      <a:pt x="3434" y="850"/>
                    </a:lnTo>
                    <a:lnTo>
                      <a:pt x="3448" y="850"/>
                    </a:lnTo>
                    <a:lnTo>
                      <a:pt x="3462" y="850"/>
                    </a:lnTo>
                    <a:lnTo>
                      <a:pt x="3476" y="850"/>
                    </a:lnTo>
                    <a:lnTo>
                      <a:pt x="3490" y="850"/>
                    </a:lnTo>
                    <a:lnTo>
                      <a:pt x="3504" y="850"/>
                    </a:lnTo>
                    <a:lnTo>
                      <a:pt x="3518" y="850"/>
                    </a:lnTo>
                    <a:lnTo>
                      <a:pt x="3532" y="850"/>
                    </a:lnTo>
                    <a:lnTo>
                      <a:pt x="3545" y="850"/>
                    </a:lnTo>
                    <a:lnTo>
                      <a:pt x="3559" y="850"/>
                    </a:lnTo>
                    <a:lnTo>
                      <a:pt x="3573" y="850"/>
                    </a:lnTo>
                    <a:lnTo>
                      <a:pt x="3587" y="850"/>
                    </a:lnTo>
                    <a:lnTo>
                      <a:pt x="3601" y="850"/>
                    </a:lnTo>
                    <a:lnTo>
                      <a:pt x="3615" y="850"/>
                    </a:lnTo>
                    <a:lnTo>
                      <a:pt x="3629" y="850"/>
                    </a:lnTo>
                    <a:lnTo>
                      <a:pt x="3643" y="850"/>
                    </a:lnTo>
                    <a:lnTo>
                      <a:pt x="3656" y="850"/>
                    </a:lnTo>
                    <a:lnTo>
                      <a:pt x="3670" y="850"/>
                    </a:lnTo>
                    <a:lnTo>
                      <a:pt x="3684" y="850"/>
                    </a:lnTo>
                    <a:lnTo>
                      <a:pt x="3698" y="850"/>
                    </a:lnTo>
                    <a:lnTo>
                      <a:pt x="3712" y="850"/>
                    </a:lnTo>
                    <a:lnTo>
                      <a:pt x="3726" y="850"/>
                    </a:lnTo>
                    <a:lnTo>
                      <a:pt x="3740" y="850"/>
                    </a:lnTo>
                    <a:lnTo>
                      <a:pt x="3754" y="850"/>
                    </a:lnTo>
                    <a:lnTo>
                      <a:pt x="3767" y="850"/>
                    </a:lnTo>
                    <a:lnTo>
                      <a:pt x="3785" y="850"/>
                    </a:lnTo>
                    <a:lnTo>
                      <a:pt x="3799" y="850"/>
                    </a:lnTo>
                    <a:lnTo>
                      <a:pt x="3812" y="850"/>
                    </a:lnTo>
                    <a:lnTo>
                      <a:pt x="3826" y="850"/>
                    </a:lnTo>
                    <a:lnTo>
                      <a:pt x="3840" y="850"/>
                    </a:lnTo>
                    <a:lnTo>
                      <a:pt x="3854" y="850"/>
                    </a:lnTo>
                    <a:lnTo>
                      <a:pt x="3868" y="850"/>
                    </a:lnTo>
                    <a:lnTo>
                      <a:pt x="3882" y="850"/>
                    </a:lnTo>
                    <a:lnTo>
                      <a:pt x="3896" y="850"/>
                    </a:lnTo>
                    <a:lnTo>
                      <a:pt x="3910" y="850"/>
                    </a:lnTo>
                    <a:lnTo>
                      <a:pt x="3923" y="850"/>
                    </a:lnTo>
                    <a:lnTo>
                      <a:pt x="3937" y="850"/>
                    </a:lnTo>
                    <a:lnTo>
                      <a:pt x="3951" y="850"/>
                    </a:lnTo>
                    <a:lnTo>
                      <a:pt x="3965" y="850"/>
                    </a:lnTo>
                    <a:lnTo>
                      <a:pt x="3979" y="850"/>
                    </a:lnTo>
                    <a:lnTo>
                      <a:pt x="3993" y="850"/>
                    </a:lnTo>
                    <a:lnTo>
                      <a:pt x="4007" y="850"/>
                    </a:lnTo>
                    <a:lnTo>
                      <a:pt x="4021" y="850"/>
                    </a:lnTo>
                    <a:lnTo>
                      <a:pt x="4034" y="850"/>
                    </a:lnTo>
                    <a:lnTo>
                      <a:pt x="4048" y="850"/>
                    </a:lnTo>
                    <a:lnTo>
                      <a:pt x="4062" y="850"/>
                    </a:lnTo>
                    <a:lnTo>
                      <a:pt x="4076" y="850"/>
                    </a:lnTo>
                    <a:lnTo>
                      <a:pt x="4090" y="850"/>
                    </a:lnTo>
                    <a:lnTo>
                      <a:pt x="4104" y="850"/>
                    </a:lnTo>
                    <a:lnTo>
                      <a:pt x="4118" y="850"/>
                    </a:lnTo>
                    <a:lnTo>
                      <a:pt x="4132" y="850"/>
                    </a:lnTo>
                    <a:lnTo>
                      <a:pt x="4145" y="850"/>
                    </a:lnTo>
                    <a:lnTo>
                      <a:pt x="4159" y="850"/>
                    </a:lnTo>
                    <a:lnTo>
                      <a:pt x="4173" y="850"/>
                    </a:lnTo>
                    <a:lnTo>
                      <a:pt x="4187" y="850"/>
                    </a:lnTo>
                    <a:lnTo>
                      <a:pt x="4201" y="850"/>
                    </a:lnTo>
                    <a:lnTo>
                      <a:pt x="4215" y="850"/>
                    </a:lnTo>
                    <a:lnTo>
                      <a:pt x="4229" y="850"/>
                    </a:lnTo>
                    <a:lnTo>
                      <a:pt x="4243" y="850"/>
                    </a:lnTo>
                    <a:lnTo>
                      <a:pt x="4256" y="850"/>
                    </a:lnTo>
                    <a:lnTo>
                      <a:pt x="4270" y="850"/>
                    </a:lnTo>
                    <a:lnTo>
                      <a:pt x="4284" y="850"/>
                    </a:lnTo>
                    <a:lnTo>
                      <a:pt x="4298" y="850"/>
                    </a:lnTo>
                    <a:lnTo>
                      <a:pt x="4315" y="850"/>
                    </a:lnTo>
                    <a:lnTo>
                      <a:pt x="4329" y="850"/>
                    </a:lnTo>
                    <a:lnTo>
                      <a:pt x="4343" y="850"/>
                    </a:lnTo>
                    <a:lnTo>
                      <a:pt x="4357" y="850"/>
                    </a:lnTo>
                    <a:lnTo>
                      <a:pt x="4371" y="850"/>
                    </a:lnTo>
                    <a:lnTo>
                      <a:pt x="4385" y="850"/>
                    </a:lnTo>
                    <a:lnTo>
                      <a:pt x="4399" y="850"/>
                    </a:lnTo>
                    <a:lnTo>
                      <a:pt x="4413" y="850"/>
                    </a:lnTo>
                    <a:lnTo>
                      <a:pt x="4426" y="850"/>
                    </a:lnTo>
                    <a:lnTo>
                      <a:pt x="4440" y="850"/>
                    </a:lnTo>
                    <a:lnTo>
                      <a:pt x="4454" y="850"/>
                    </a:lnTo>
                    <a:lnTo>
                      <a:pt x="4468" y="850"/>
                    </a:lnTo>
                    <a:lnTo>
                      <a:pt x="4482" y="850"/>
                    </a:lnTo>
                    <a:lnTo>
                      <a:pt x="4496" y="850"/>
                    </a:lnTo>
                    <a:lnTo>
                      <a:pt x="4510" y="850"/>
                    </a:lnTo>
                    <a:lnTo>
                      <a:pt x="4524" y="850"/>
                    </a:lnTo>
                    <a:lnTo>
                      <a:pt x="4537" y="850"/>
                    </a:lnTo>
                    <a:lnTo>
                      <a:pt x="4551" y="850"/>
                    </a:lnTo>
                    <a:lnTo>
                      <a:pt x="4565" y="850"/>
                    </a:lnTo>
                    <a:lnTo>
                      <a:pt x="4579" y="850"/>
                    </a:lnTo>
                    <a:lnTo>
                      <a:pt x="4593" y="850"/>
                    </a:lnTo>
                    <a:lnTo>
                      <a:pt x="4607" y="850"/>
                    </a:lnTo>
                    <a:lnTo>
                      <a:pt x="4621" y="850"/>
                    </a:lnTo>
                    <a:lnTo>
                      <a:pt x="4635" y="850"/>
                    </a:lnTo>
                    <a:lnTo>
                      <a:pt x="4648" y="850"/>
                    </a:lnTo>
                    <a:lnTo>
                      <a:pt x="4662" y="850"/>
                    </a:lnTo>
                    <a:lnTo>
                      <a:pt x="4676" y="850"/>
                    </a:lnTo>
                    <a:lnTo>
                      <a:pt x="4690" y="850"/>
                    </a:lnTo>
                    <a:lnTo>
                      <a:pt x="4704" y="850"/>
                    </a:lnTo>
                    <a:lnTo>
                      <a:pt x="4718" y="850"/>
                    </a:lnTo>
                    <a:lnTo>
                      <a:pt x="4732" y="850"/>
                    </a:lnTo>
                    <a:lnTo>
                      <a:pt x="4746" y="850"/>
                    </a:lnTo>
                    <a:lnTo>
                      <a:pt x="4759" y="850"/>
                    </a:lnTo>
                    <a:lnTo>
                      <a:pt x="4773" y="850"/>
                    </a:lnTo>
                    <a:lnTo>
                      <a:pt x="4787" y="850"/>
                    </a:lnTo>
                    <a:lnTo>
                      <a:pt x="4801" y="850"/>
                    </a:lnTo>
                    <a:lnTo>
                      <a:pt x="4815" y="850"/>
                    </a:lnTo>
                    <a:lnTo>
                      <a:pt x="4829" y="850"/>
                    </a:lnTo>
                    <a:lnTo>
                      <a:pt x="4843" y="850"/>
                    </a:lnTo>
                    <a:lnTo>
                      <a:pt x="4860" y="850"/>
                    </a:lnTo>
                    <a:lnTo>
                      <a:pt x="4874" y="850"/>
                    </a:lnTo>
                    <a:lnTo>
                      <a:pt x="4888" y="850"/>
                    </a:lnTo>
                    <a:lnTo>
                      <a:pt x="4902" y="850"/>
                    </a:lnTo>
                    <a:lnTo>
                      <a:pt x="4916" y="850"/>
                    </a:lnTo>
                    <a:lnTo>
                      <a:pt x="4929" y="850"/>
                    </a:lnTo>
                    <a:lnTo>
                      <a:pt x="4943" y="850"/>
                    </a:lnTo>
                    <a:lnTo>
                      <a:pt x="4957" y="850"/>
                    </a:lnTo>
                    <a:lnTo>
                      <a:pt x="4971" y="850"/>
                    </a:lnTo>
                    <a:lnTo>
                      <a:pt x="4985" y="850"/>
                    </a:lnTo>
                    <a:lnTo>
                      <a:pt x="4999" y="850"/>
                    </a:lnTo>
                    <a:lnTo>
                      <a:pt x="5013" y="850"/>
                    </a:lnTo>
                    <a:lnTo>
                      <a:pt x="5027" y="850"/>
                    </a:lnTo>
                    <a:lnTo>
                      <a:pt x="5040" y="850"/>
                    </a:lnTo>
                    <a:lnTo>
                      <a:pt x="5054" y="850"/>
                    </a:lnTo>
                    <a:lnTo>
                      <a:pt x="5068" y="850"/>
                    </a:lnTo>
                    <a:lnTo>
                      <a:pt x="5082" y="850"/>
                    </a:lnTo>
                    <a:lnTo>
                      <a:pt x="5096" y="850"/>
                    </a:lnTo>
                    <a:lnTo>
                      <a:pt x="5110" y="850"/>
                    </a:lnTo>
                    <a:lnTo>
                      <a:pt x="5124" y="850"/>
                    </a:lnTo>
                    <a:lnTo>
                      <a:pt x="5138" y="850"/>
                    </a:lnTo>
                    <a:lnTo>
                      <a:pt x="5151" y="850"/>
                    </a:lnTo>
                    <a:lnTo>
                      <a:pt x="5165" y="850"/>
                    </a:lnTo>
                    <a:lnTo>
                      <a:pt x="5179" y="850"/>
                    </a:lnTo>
                    <a:lnTo>
                      <a:pt x="5193" y="850"/>
                    </a:lnTo>
                    <a:lnTo>
                      <a:pt x="5207" y="850"/>
                    </a:lnTo>
                    <a:lnTo>
                      <a:pt x="5221" y="850"/>
                    </a:lnTo>
                    <a:lnTo>
                      <a:pt x="5235" y="850"/>
                    </a:lnTo>
                    <a:lnTo>
                      <a:pt x="5249" y="850"/>
                    </a:lnTo>
                    <a:lnTo>
                      <a:pt x="5262" y="850"/>
                    </a:lnTo>
                    <a:lnTo>
                      <a:pt x="5276" y="850"/>
                    </a:lnTo>
                    <a:lnTo>
                      <a:pt x="5290" y="850"/>
                    </a:lnTo>
                    <a:lnTo>
                      <a:pt x="5304" y="850"/>
                    </a:lnTo>
                    <a:lnTo>
                      <a:pt x="5318" y="850"/>
                    </a:lnTo>
                    <a:lnTo>
                      <a:pt x="5332" y="850"/>
                    </a:lnTo>
                    <a:lnTo>
                      <a:pt x="5346" y="850"/>
                    </a:lnTo>
                    <a:lnTo>
                      <a:pt x="5360" y="850"/>
                    </a:lnTo>
                    <a:lnTo>
                      <a:pt x="5373" y="850"/>
                    </a:lnTo>
                    <a:lnTo>
                      <a:pt x="5391" y="850"/>
                    </a:lnTo>
                    <a:lnTo>
                      <a:pt x="5405" y="850"/>
                    </a:lnTo>
                    <a:lnTo>
                      <a:pt x="5418" y="850"/>
                    </a:lnTo>
                    <a:lnTo>
                      <a:pt x="5432" y="850"/>
                    </a:lnTo>
                    <a:lnTo>
                      <a:pt x="5446" y="850"/>
                    </a:lnTo>
                    <a:lnTo>
                      <a:pt x="5460" y="850"/>
                    </a:lnTo>
                    <a:lnTo>
                      <a:pt x="5474" y="850"/>
                    </a:lnTo>
                    <a:lnTo>
                      <a:pt x="5488" y="850"/>
                    </a:lnTo>
                    <a:lnTo>
                      <a:pt x="5502" y="850"/>
                    </a:lnTo>
                    <a:lnTo>
                      <a:pt x="5516" y="850"/>
                    </a:lnTo>
                    <a:lnTo>
                      <a:pt x="5529" y="850"/>
                    </a:lnTo>
                    <a:lnTo>
                      <a:pt x="5543" y="850"/>
                    </a:lnTo>
                    <a:lnTo>
                      <a:pt x="5557" y="850"/>
                    </a:lnTo>
                    <a:lnTo>
                      <a:pt x="5571" y="850"/>
                    </a:lnTo>
                    <a:lnTo>
                      <a:pt x="5585" y="850"/>
                    </a:lnTo>
                    <a:lnTo>
                      <a:pt x="5599" y="850"/>
                    </a:lnTo>
                    <a:lnTo>
                      <a:pt x="5613" y="850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53" name="Rectangle 175">
                <a:extLst>
                  <a:ext uri="{FF2B5EF4-FFF2-40B4-BE49-F238E27FC236}">
                    <a16:creationId xmlns:a16="http://schemas.microsoft.com/office/drawing/2014/main" id="{0F6F5A2C-E9B1-A22C-9833-8B7ACCD1CC3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90035" y="5138784"/>
                <a:ext cx="673261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5.850 min</a:t>
                </a:r>
                <a:endParaRPr kumimoji="0" lang="en-US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54" name="Rectangle 176">
                <a:extLst>
                  <a:ext uri="{FF2B5EF4-FFF2-40B4-BE49-F238E27FC236}">
                    <a16:creationId xmlns:a16="http://schemas.microsoft.com/office/drawing/2014/main" id="{47B4F47A-1BDF-9213-525A-3C84EE45DE4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1188" y="5013325"/>
                <a:ext cx="11266488" cy="1652588"/>
              </a:xfrm>
              <a:prstGeom prst="rect">
                <a:avLst/>
              </a:prstGeom>
              <a:noFill/>
              <a:ln w="11113" cap="flat">
                <a:solidFill>
                  <a:srgbClr val="F0F0F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55" name="Line 177">
                <a:extLst>
                  <a:ext uri="{FF2B5EF4-FFF2-40B4-BE49-F238E27FC236}">
                    <a16:creationId xmlns:a16="http://schemas.microsoft.com/office/drawing/2014/main" id="{D5607D45-F4C1-9275-F8CD-7F80E26852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33413" y="5149850"/>
                <a:ext cx="0" cy="1520825"/>
              </a:xfrm>
              <a:prstGeom prst="line">
                <a:avLst/>
              </a:prstGeom>
              <a:noFill/>
              <a:ln w="4763" cap="flat">
                <a:solidFill>
                  <a:srgbClr val="808080"/>
                </a:solidFill>
                <a:prstDash val="solid"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56" name="Rectangle 178">
                <a:extLst>
                  <a:ext uri="{FF2B5EF4-FFF2-40B4-BE49-F238E27FC236}">
                    <a16:creationId xmlns:a16="http://schemas.microsoft.com/office/drawing/2014/main" id="{72C25919-AC5F-5D49-838C-0555455E18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4526" y="5149850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808080"/>
                    </a:solidFill>
                    <a:effectLst/>
                    <a:latin typeface="Helvetica" pitchFamily="2" charset="0"/>
                  </a:rPr>
                  <a:t>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61" name="Rectangle 183">
                <a:extLst>
                  <a:ext uri="{FF2B5EF4-FFF2-40B4-BE49-F238E27FC236}">
                    <a16:creationId xmlns:a16="http://schemas.microsoft.com/office/drawing/2014/main" id="{A0C27FC2-39C9-9E3E-044E-E753ABC775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99138" y="6893026"/>
                <a:ext cx="248433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2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Counts vs. Acquisition Time (min)</a:t>
                </a:r>
                <a:endParaRPr kumimoji="0" lang="en-US" altLang="en-US" sz="1200" b="1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62" name="Line 184">
                <a:extLst>
                  <a:ext uri="{FF2B5EF4-FFF2-40B4-BE49-F238E27FC236}">
                    <a16:creationId xmlns:a16="http://schemas.microsoft.com/office/drawing/2014/main" id="{BCCE6E4E-F454-09C4-A6D3-F159F897F1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7538" y="6675438"/>
                <a:ext cx="11249025" cy="0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63" name="Line 185">
                <a:extLst>
                  <a:ext uri="{FF2B5EF4-FFF2-40B4-BE49-F238E27FC236}">
                    <a16:creationId xmlns:a16="http://schemas.microsoft.com/office/drawing/2014/main" id="{FDBF255C-A5A5-A062-6E24-B1371E0578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151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64" name="Rectangle 186">
                <a:extLst>
                  <a:ext uri="{FF2B5EF4-FFF2-40B4-BE49-F238E27FC236}">
                    <a16:creationId xmlns:a16="http://schemas.microsoft.com/office/drawing/2014/main" id="{63F4A20A-0EAC-56C2-E4A1-50C2372849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865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65" name="Line 187">
                <a:extLst>
                  <a:ext uri="{FF2B5EF4-FFF2-40B4-BE49-F238E27FC236}">
                    <a16:creationId xmlns:a16="http://schemas.microsoft.com/office/drawing/2014/main" id="{C110F13D-FBE0-6EEC-7B77-4D6580702A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740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66" name="Rectangle 188">
                <a:extLst>
                  <a:ext uri="{FF2B5EF4-FFF2-40B4-BE49-F238E27FC236}">
                    <a16:creationId xmlns:a16="http://schemas.microsoft.com/office/drawing/2014/main" id="{45FCD981-66B2-2962-A240-33D948B7D8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295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67" name="Line 189">
                <a:extLst>
                  <a:ext uri="{FF2B5EF4-FFF2-40B4-BE49-F238E27FC236}">
                    <a16:creationId xmlns:a16="http://schemas.microsoft.com/office/drawing/2014/main" id="{16CA6A69-4BC0-0D9F-F53E-E5C280248E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9852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68" name="Rectangle 190">
                <a:extLst>
                  <a:ext uri="{FF2B5EF4-FFF2-40B4-BE49-F238E27FC236}">
                    <a16:creationId xmlns:a16="http://schemas.microsoft.com/office/drawing/2014/main" id="{B04F3171-95C6-07EA-07F8-66AB36D260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407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69" name="Line 191">
                <a:extLst>
                  <a:ext uri="{FF2B5EF4-FFF2-40B4-BE49-F238E27FC236}">
                    <a16:creationId xmlns:a16="http://schemas.microsoft.com/office/drawing/2014/main" id="{F6892B8C-6AD2-E36E-3F2A-6C5938CA58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1282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70" name="Rectangle 192">
                <a:extLst>
                  <a:ext uri="{FF2B5EF4-FFF2-40B4-BE49-F238E27FC236}">
                    <a16:creationId xmlns:a16="http://schemas.microsoft.com/office/drawing/2014/main" id="{5AA0BA9D-7C6A-A5BD-ABFE-A07C531025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6996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71" name="Line 193">
                <a:extLst>
                  <a:ext uri="{FF2B5EF4-FFF2-40B4-BE49-F238E27FC236}">
                    <a16:creationId xmlns:a16="http://schemas.microsoft.com/office/drawing/2014/main" id="{7A529FD5-FD6E-C117-5560-B2945F915B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2871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72" name="Rectangle 194">
                <a:extLst>
                  <a:ext uri="{FF2B5EF4-FFF2-40B4-BE49-F238E27FC236}">
                    <a16:creationId xmlns:a16="http://schemas.microsoft.com/office/drawing/2014/main" id="{B5403C87-2A25-7C8D-2974-C1C069C5A5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585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73" name="Line 195">
                <a:extLst>
                  <a:ext uri="{FF2B5EF4-FFF2-40B4-BE49-F238E27FC236}">
                    <a16:creationId xmlns:a16="http://schemas.microsoft.com/office/drawing/2014/main" id="{E8617FA2-A2DA-9E8C-42D8-73F9D0C5BC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4460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74" name="Rectangle 196">
                <a:extLst>
                  <a:ext uri="{FF2B5EF4-FFF2-40B4-BE49-F238E27FC236}">
                    <a16:creationId xmlns:a16="http://schemas.microsoft.com/office/drawing/2014/main" id="{6B21CB45-FF79-1385-CC58-65F6FE4AEA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0015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75" name="Line 197">
                <a:extLst>
                  <a:ext uri="{FF2B5EF4-FFF2-40B4-BE49-F238E27FC236}">
                    <a16:creationId xmlns:a16="http://schemas.microsoft.com/office/drawing/2014/main" id="{FBC8FEBE-BA07-7229-30EF-B848FA9EA57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6048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76" name="Rectangle 198">
                <a:extLst>
                  <a:ext uri="{FF2B5EF4-FFF2-40B4-BE49-F238E27FC236}">
                    <a16:creationId xmlns:a16="http://schemas.microsoft.com/office/drawing/2014/main" id="{817FE982-E918-6DCD-E0A1-229057E132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31603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77" name="Line 199">
                <a:extLst>
                  <a:ext uri="{FF2B5EF4-FFF2-40B4-BE49-F238E27FC236}">
                    <a16:creationId xmlns:a16="http://schemas.microsoft.com/office/drawing/2014/main" id="{3254D396-0BAC-6308-181F-1C45DDCA39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637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78" name="Rectangle 200">
                <a:extLst>
                  <a:ext uri="{FF2B5EF4-FFF2-40B4-BE49-F238E27FC236}">
                    <a16:creationId xmlns:a16="http://schemas.microsoft.com/office/drawing/2014/main" id="{F26A9647-4822-7F9C-CAE7-3F18C6BE14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43192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79" name="Line 201">
                <a:extLst>
                  <a:ext uri="{FF2B5EF4-FFF2-40B4-BE49-F238E27FC236}">
                    <a16:creationId xmlns:a16="http://schemas.microsoft.com/office/drawing/2014/main" id="{33903339-87F6-BF77-4B3F-8384F1BC1F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226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80" name="Rectangle 202">
                <a:extLst>
                  <a:ext uri="{FF2B5EF4-FFF2-40B4-BE49-F238E27FC236}">
                    <a16:creationId xmlns:a16="http://schemas.microsoft.com/office/drawing/2014/main" id="{1B4E0F84-F3D5-A6D8-7CDF-48AA265B7E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4781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0.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81" name="Line 203">
                <a:extLst>
                  <a:ext uri="{FF2B5EF4-FFF2-40B4-BE49-F238E27FC236}">
                    <a16:creationId xmlns:a16="http://schemas.microsoft.com/office/drawing/2014/main" id="{0B80A740-ECB5-CB99-FBEA-2DD1C78CE3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0656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82" name="Rectangle 204">
                <a:extLst>
                  <a:ext uri="{FF2B5EF4-FFF2-40B4-BE49-F238E27FC236}">
                    <a16:creationId xmlns:a16="http://schemas.microsoft.com/office/drawing/2014/main" id="{46C1B7EE-C847-769A-D653-3F247C5A05C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90688" y="6697663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5" name="Line 206">
                <a:extLst>
                  <a:ext uri="{FF2B5EF4-FFF2-40B4-BE49-F238E27FC236}">
                    <a16:creationId xmlns:a16="http://schemas.microsoft.com/office/drawing/2014/main" id="{F2E03C8B-6FB5-554F-389D-BA19539D23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1768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6" name="Rectangle 207">
                <a:extLst>
                  <a:ext uri="{FF2B5EF4-FFF2-40B4-BE49-F238E27FC236}">
                    <a16:creationId xmlns:a16="http://schemas.microsoft.com/office/drawing/2014/main" id="{27F05257-C612-4099-F806-B058C0AFD72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7323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7" name="Line 208">
                <a:extLst>
                  <a:ext uri="{FF2B5EF4-FFF2-40B4-BE49-F238E27FC236}">
                    <a16:creationId xmlns:a16="http://schemas.microsoft.com/office/drawing/2014/main" id="{F26953C0-E6FA-900F-B120-383C83AA8FA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357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8" name="Rectangle 209">
                <a:extLst>
                  <a:ext uri="{FF2B5EF4-FFF2-40B4-BE49-F238E27FC236}">
                    <a16:creationId xmlns:a16="http://schemas.microsoft.com/office/drawing/2014/main" id="{04BB1B00-B2E6-A21F-9D88-9E27B6C367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8912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9" name="Line 210">
                <a:extLst>
                  <a:ext uri="{FF2B5EF4-FFF2-40B4-BE49-F238E27FC236}">
                    <a16:creationId xmlns:a16="http://schemas.microsoft.com/office/drawing/2014/main" id="{850D9939-A876-6B19-73CA-5F8E90D871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946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0" name="Rectangle 211">
                <a:extLst>
                  <a:ext uri="{FF2B5EF4-FFF2-40B4-BE49-F238E27FC236}">
                    <a16:creationId xmlns:a16="http://schemas.microsoft.com/office/drawing/2014/main" id="{55F72B56-5B74-7AB9-9831-6C4665AA95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0501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2" name="Line 212">
                <a:extLst>
                  <a:ext uri="{FF2B5EF4-FFF2-40B4-BE49-F238E27FC236}">
                    <a16:creationId xmlns:a16="http://schemas.microsoft.com/office/drawing/2014/main" id="{B87A9DD8-B02B-4815-9477-08297F0163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6376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3" name="Rectangle 213">
                <a:extLst>
                  <a:ext uri="{FF2B5EF4-FFF2-40B4-BE49-F238E27FC236}">
                    <a16:creationId xmlns:a16="http://schemas.microsoft.com/office/drawing/2014/main" id="{1AC76E99-BC66-5710-A11B-2629FF726E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2090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4" name="Line 214">
                <a:extLst>
                  <a:ext uri="{FF2B5EF4-FFF2-40B4-BE49-F238E27FC236}">
                    <a16:creationId xmlns:a16="http://schemas.microsoft.com/office/drawing/2014/main" id="{A1D66A7E-C25D-359C-8D10-FC361C1679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7965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6" name="Rectangle 215">
                <a:extLst>
                  <a:ext uri="{FF2B5EF4-FFF2-40B4-BE49-F238E27FC236}">
                    <a16:creationId xmlns:a16="http://schemas.microsoft.com/office/drawing/2014/main" id="{536B7E0F-459F-8BF7-4966-A068148EF07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3520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7" name="Line 216">
                <a:extLst>
                  <a:ext uri="{FF2B5EF4-FFF2-40B4-BE49-F238E27FC236}">
                    <a16:creationId xmlns:a16="http://schemas.microsoft.com/office/drawing/2014/main" id="{B55A2FFA-D6B8-F9C2-944E-E459AD7AB24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553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8" name="Rectangle 217">
                <a:extLst>
                  <a:ext uri="{FF2B5EF4-FFF2-40B4-BE49-F238E27FC236}">
                    <a16:creationId xmlns:a16="http://schemas.microsoft.com/office/drawing/2014/main" id="{6765119A-2818-0F1A-B146-3947C7562B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108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9" name="Line 218">
                <a:extLst>
                  <a:ext uri="{FF2B5EF4-FFF2-40B4-BE49-F238E27FC236}">
                    <a16:creationId xmlns:a16="http://schemas.microsoft.com/office/drawing/2014/main" id="{9C092933-A43F-C193-7C57-4F8836FA56F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1142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0" name="Rectangle 219">
                <a:extLst>
                  <a:ext uri="{FF2B5EF4-FFF2-40B4-BE49-F238E27FC236}">
                    <a16:creationId xmlns:a16="http://schemas.microsoft.com/office/drawing/2014/main" id="{D238B7FF-6AC8-5F11-FBDC-D2634B93E3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6697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1" name="Line 220">
                <a:extLst>
                  <a:ext uri="{FF2B5EF4-FFF2-40B4-BE49-F238E27FC236}">
                    <a16:creationId xmlns:a16="http://schemas.microsoft.com/office/drawing/2014/main" id="{26101928-978B-13E9-3A26-2460FEF1CE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731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2" name="Rectangle 221">
                <a:extLst>
                  <a:ext uri="{FF2B5EF4-FFF2-40B4-BE49-F238E27FC236}">
                    <a16:creationId xmlns:a16="http://schemas.microsoft.com/office/drawing/2014/main" id="{2D92F546-FA6A-86C6-6F56-8FD50BC843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8286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3" name="Line 222">
                <a:extLst>
                  <a:ext uri="{FF2B5EF4-FFF2-40B4-BE49-F238E27FC236}">
                    <a16:creationId xmlns:a16="http://schemas.microsoft.com/office/drawing/2014/main" id="{0D599880-A009-312D-79C7-9F664060D0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320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4" name="Rectangle 223">
                <a:extLst>
                  <a:ext uri="{FF2B5EF4-FFF2-40B4-BE49-F238E27FC236}">
                    <a16:creationId xmlns:a16="http://schemas.microsoft.com/office/drawing/2014/main" id="{7F052FAC-C5F7-84D6-E6E8-C75D27CD40F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9875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1.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5" name="Line 224">
                <a:extLst>
                  <a:ext uri="{FF2B5EF4-FFF2-40B4-BE49-F238E27FC236}">
                    <a16:creationId xmlns:a16="http://schemas.microsoft.com/office/drawing/2014/main" id="{735CCB48-7864-C22D-53B7-07A8F949E3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5273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6" name="Rectangle 225">
                <a:extLst>
                  <a:ext uri="{FF2B5EF4-FFF2-40B4-BE49-F238E27FC236}">
                    <a16:creationId xmlns:a16="http://schemas.microsoft.com/office/drawing/2014/main" id="{A9E78026-3856-DEC0-9C3E-0F385036C7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836863" y="6697663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7" name="Line 226">
                <a:extLst>
                  <a:ext uri="{FF2B5EF4-FFF2-40B4-BE49-F238E27FC236}">
                    <a16:creationId xmlns:a16="http://schemas.microsoft.com/office/drawing/2014/main" id="{49DDAF1D-5D9C-9871-24DE-619249B1A0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6862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28" name="Rectangle 227">
                <a:extLst>
                  <a:ext uri="{FF2B5EF4-FFF2-40B4-BE49-F238E27FC236}">
                    <a16:creationId xmlns:a16="http://schemas.microsoft.com/office/drawing/2014/main" id="{FB9CBCCA-C4C4-93CF-1341-4F41B9FC2A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2417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.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29" name="Line 228">
                <a:extLst>
                  <a:ext uri="{FF2B5EF4-FFF2-40B4-BE49-F238E27FC236}">
                    <a16:creationId xmlns:a16="http://schemas.microsoft.com/office/drawing/2014/main" id="{FEA0A27D-2239-ED47-47F5-9D4692F53E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8451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0" name="Rectangle 229">
                <a:extLst>
                  <a:ext uri="{FF2B5EF4-FFF2-40B4-BE49-F238E27FC236}">
                    <a16:creationId xmlns:a16="http://schemas.microsoft.com/office/drawing/2014/main" id="{59F2251B-A974-007E-D524-32E92A9304F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4006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.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1" name="Line 230">
                <a:extLst>
                  <a:ext uri="{FF2B5EF4-FFF2-40B4-BE49-F238E27FC236}">
                    <a16:creationId xmlns:a16="http://schemas.microsoft.com/office/drawing/2014/main" id="{BE9FAAF2-64B8-7D7B-789E-1BF8F87EB9D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9881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2" name="Rectangle 231">
                <a:extLst>
                  <a:ext uri="{FF2B5EF4-FFF2-40B4-BE49-F238E27FC236}">
                    <a16:creationId xmlns:a16="http://schemas.microsoft.com/office/drawing/2014/main" id="{61BEFA89-B2A6-2A44-6F55-5C170E318D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15595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.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3" name="Line 232">
                <a:extLst>
                  <a:ext uri="{FF2B5EF4-FFF2-40B4-BE49-F238E27FC236}">
                    <a16:creationId xmlns:a16="http://schemas.microsoft.com/office/drawing/2014/main" id="{ED495749-8135-CDEE-9E4C-9EEEFE53BD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1470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4" name="Rectangle 233">
                <a:extLst>
                  <a:ext uri="{FF2B5EF4-FFF2-40B4-BE49-F238E27FC236}">
                    <a16:creationId xmlns:a16="http://schemas.microsoft.com/office/drawing/2014/main" id="{438B06C8-4DF3-243F-5493-3AB9EFF0CF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27183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.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5" name="Line 234">
                <a:extLst>
                  <a:ext uri="{FF2B5EF4-FFF2-40B4-BE49-F238E27FC236}">
                    <a16:creationId xmlns:a16="http://schemas.microsoft.com/office/drawing/2014/main" id="{DEDAC66E-F4B4-4D59-6C60-F3F66F3E1D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3058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6" name="Rectangle 235">
                <a:extLst>
                  <a:ext uri="{FF2B5EF4-FFF2-40B4-BE49-F238E27FC236}">
                    <a16:creationId xmlns:a16="http://schemas.microsoft.com/office/drawing/2014/main" id="{37A1BC1C-4287-0B29-33E7-CFE5E2061F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38613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7" name="Line 236">
                <a:extLst>
                  <a:ext uri="{FF2B5EF4-FFF2-40B4-BE49-F238E27FC236}">
                    <a16:creationId xmlns:a16="http://schemas.microsoft.com/office/drawing/2014/main" id="{A2905231-A689-C227-9BD2-E6BC1A9505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4647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38" name="Rectangle 237">
                <a:extLst>
                  <a:ext uri="{FF2B5EF4-FFF2-40B4-BE49-F238E27FC236}">
                    <a16:creationId xmlns:a16="http://schemas.microsoft.com/office/drawing/2014/main" id="{B38DBF60-D5EE-6978-C04E-AAF2B23BBC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0202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.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39" name="Line 238">
                <a:extLst>
                  <a:ext uri="{FF2B5EF4-FFF2-40B4-BE49-F238E27FC236}">
                    <a16:creationId xmlns:a16="http://schemas.microsoft.com/office/drawing/2014/main" id="{9EB4A063-08AE-75D3-17A0-E6BA409025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6236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40" name="Rectangle 239">
                <a:extLst>
                  <a:ext uri="{FF2B5EF4-FFF2-40B4-BE49-F238E27FC236}">
                    <a16:creationId xmlns:a16="http://schemas.microsoft.com/office/drawing/2014/main" id="{E2B8553A-40EC-1826-24AD-59E05DA643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1791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.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41" name="Line 240">
                <a:extLst>
                  <a:ext uri="{FF2B5EF4-FFF2-40B4-BE49-F238E27FC236}">
                    <a16:creationId xmlns:a16="http://schemas.microsoft.com/office/drawing/2014/main" id="{8B8EDC8B-33EC-9022-7ABA-34B27F40D5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7825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42" name="Rectangle 241">
                <a:extLst>
                  <a:ext uri="{FF2B5EF4-FFF2-40B4-BE49-F238E27FC236}">
                    <a16:creationId xmlns:a16="http://schemas.microsoft.com/office/drawing/2014/main" id="{AB2D6678-7623-F4B6-CDE2-852F1869095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3380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.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43" name="Line 242">
                <a:extLst>
                  <a:ext uri="{FF2B5EF4-FFF2-40B4-BE49-F238E27FC236}">
                    <a16:creationId xmlns:a16="http://schemas.microsoft.com/office/drawing/2014/main" id="{3D09668A-3BD2-D137-0BD5-0AD919FDA7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8778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44" name="Rectangle 243">
                <a:extLst>
                  <a:ext uri="{FF2B5EF4-FFF2-40B4-BE49-F238E27FC236}">
                    <a16:creationId xmlns:a16="http://schemas.microsoft.com/office/drawing/2014/main" id="{E210B048-1A8A-3017-DB58-D6F361A0D4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4333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2.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45" name="Line 244">
                <a:extLst>
                  <a:ext uri="{FF2B5EF4-FFF2-40B4-BE49-F238E27FC236}">
                    <a16:creationId xmlns:a16="http://schemas.microsoft.com/office/drawing/2014/main" id="{4B88D4B2-506E-E319-45D1-03A77A6573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0367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46" name="Rectangle 245">
                <a:extLst>
                  <a:ext uri="{FF2B5EF4-FFF2-40B4-BE49-F238E27FC236}">
                    <a16:creationId xmlns:a16="http://schemas.microsoft.com/office/drawing/2014/main" id="{951A0C0E-1E03-788D-D07A-784E2B2249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87801" y="6697663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47" name="Line 246">
                <a:extLst>
                  <a:ext uri="{FF2B5EF4-FFF2-40B4-BE49-F238E27FC236}">
                    <a16:creationId xmlns:a16="http://schemas.microsoft.com/office/drawing/2014/main" id="{21BB4580-F9EF-CB22-F2EA-C5122B775E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1956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48" name="Rectangle 247">
                <a:extLst>
                  <a:ext uri="{FF2B5EF4-FFF2-40B4-BE49-F238E27FC236}">
                    <a16:creationId xmlns:a16="http://schemas.microsoft.com/office/drawing/2014/main" id="{3D7AA5D0-40B8-DABB-1E6E-58B6678DA2D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7511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.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49" name="Line 248">
                <a:extLst>
                  <a:ext uri="{FF2B5EF4-FFF2-40B4-BE49-F238E27FC236}">
                    <a16:creationId xmlns:a16="http://schemas.microsoft.com/office/drawing/2014/main" id="{BEA263F2-60C4-8910-658C-3096BE7219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3545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50" name="Rectangle 249">
                <a:extLst>
                  <a:ext uri="{FF2B5EF4-FFF2-40B4-BE49-F238E27FC236}">
                    <a16:creationId xmlns:a16="http://schemas.microsoft.com/office/drawing/2014/main" id="{971C3F23-318C-AD5C-2684-D0C6BE0CE2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9100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.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51" name="Line 250">
                <a:extLst>
                  <a:ext uri="{FF2B5EF4-FFF2-40B4-BE49-F238E27FC236}">
                    <a16:creationId xmlns:a16="http://schemas.microsoft.com/office/drawing/2014/main" id="{57E460FF-5B4A-BAE4-C91B-07609162C6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4975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52" name="Rectangle 251">
                <a:extLst>
                  <a:ext uri="{FF2B5EF4-FFF2-40B4-BE49-F238E27FC236}">
                    <a16:creationId xmlns:a16="http://schemas.microsoft.com/office/drawing/2014/main" id="{3717213B-4414-5B59-A1A8-4CC5B2A74E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0688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.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53" name="Line 252">
                <a:extLst>
                  <a:ext uri="{FF2B5EF4-FFF2-40B4-BE49-F238E27FC236}">
                    <a16:creationId xmlns:a16="http://schemas.microsoft.com/office/drawing/2014/main" id="{9C44E0DD-7049-D548-A223-5082E43107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6563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54" name="Rectangle 253">
                <a:extLst>
                  <a:ext uri="{FF2B5EF4-FFF2-40B4-BE49-F238E27FC236}">
                    <a16:creationId xmlns:a16="http://schemas.microsoft.com/office/drawing/2014/main" id="{F9BF31EC-7243-FC2D-4D47-0DD4D3ACAEE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42277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.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55" name="Line 254">
                <a:extLst>
                  <a:ext uri="{FF2B5EF4-FFF2-40B4-BE49-F238E27FC236}">
                    <a16:creationId xmlns:a16="http://schemas.microsoft.com/office/drawing/2014/main" id="{3C56B545-FCB2-0B96-421F-1987768155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8152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56" name="Rectangle 255">
                <a:extLst>
                  <a:ext uri="{FF2B5EF4-FFF2-40B4-BE49-F238E27FC236}">
                    <a16:creationId xmlns:a16="http://schemas.microsoft.com/office/drawing/2014/main" id="{300E6ACF-E41C-646D-8639-296914A199B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53707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57" name="Line 256">
                <a:extLst>
                  <a:ext uri="{FF2B5EF4-FFF2-40B4-BE49-F238E27FC236}">
                    <a16:creationId xmlns:a16="http://schemas.microsoft.com/office/drawing/2014/main" id="{143F1389-94F5-9637-8A29-50E3C1E080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69741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58" name="Rectangle 257">
                <a:extLst>
                  <a:ext uri="{FF2B5EF4-FFF2-40B4-BE49-F238E27FC236}">
                    <a16:creationId xmlns:a16="http://schemas.microsoft.com/office/drawing/2014/main" id="{DBA021E4-689F-0F8C-4BF6-87F842437C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5296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.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59" name="Line 258">
                <a:extLst>
                  <a:ext uri="{FF2B5EF4-FFF2-40B4-BE49-F238E27FC236}">
                    <a16:creationId xmlns:a16="http://schemas.microsoft.com/office/drawing/2014/main" id="{9E27819D-D8BA-76FA-6662-87A4B3086C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1330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60" name="Rectangle 259">
                <a:extLst>
                  <a:ext uri="{FF2B5EF4-FFF2-40B4-BE49-F238E27FC236}">
                    <a16:creationId xmlns:a16="http://schemas.microsoft.com/office/drawing/2014/main" id="{FA0165C9-7D31-4D68-F6A8-E3A58F47EB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76885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.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61" name="Line 260">
                <a:extLst>
                  <a:ext uri="{FF2B5EF4-FFF2-40B4-BE49-F238E27FC236}">
                    <a16:creationId xmlns:a16="http://schemas.microsoft.com/office/drawing/2014/main" id="{873D15DE-81D5-D068-8306-D9F3E102A6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2283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62" name="Rectangle 261">
                <a:extLst>
                  <a:ext uri="{FF2B5EF4-FFF2-40B4-BE49-F238E27FC236}">
                    <a16:creationId xmlns:a16="http://schemas.microsoft.com/office/drawing/2014/main" id="{339C026F-CFAD-B619-4A8B-0E613D1E88C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7838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.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63" name="Line 262">
                <a:extLst>
                  <a:ext uri="{FF2B5EF4-FFF2-40B4-BE49-F238E27FC236}">
                    <a16:creationId xmlns:a16="http://schemas.microsoft.com/office/drawing/2014/main" id="{1DBCA384-CBF8-6532-3DEA-838584E7A7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3872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64" name="Rectangle 263">
                <a:extLst>
                  <a:ext uri="{FF2B5EF4-FFF2-40B4-BE49-F238E27FC236}">
                    <a16:creationId xmlns:a16="http://schemas.microsoft.com/office/drawing/2014/main" id="{5E1311A0-A6DF-5C45-E900-42CCF7ACDEE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9427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3.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65" name="Line 264">
                <a:extLst>
                  <a:ext uri="{FF2B5EF4-FFF2-40B4-BE49-F238E27FC236}">
                    <a16:creationId xmlns:a16="http://schemas.microsoft.com/office/drawing/2014/main" id="{F70E64B5-5B5D-D8C9-2777-BB8C3C038E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15461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66" name="Rectangle 265">
                <a:extLst>
                  <a:ext uri="{FF2B5EF4-FFF2-40B4-BE49-F238E27FC236}">
                    <a16:creationId xmlns:a16="http://schemas.microsoft.com/office/drawing/2014/main" id="{0DAF63EB-CB33-F5ED-1405-B4E97C06AE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37151" y="6697663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67" name="Line 266">
                <a:extLst>
                  <a:ext uri="{FF2B5EF4-FFF2-40B4-BE49-F238E27FC236}">
                    <a16:creationId xmlns:a16="http://schemas.microsoft.com/office/drawing/2014/main" id="{C5E4ECD7-C237-F6D9-F1AC-48CA00F342B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7050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68" name="Rectangle 267">
                <a:extLst>
                  <a:ext uri="{FF2B5EF4-FFF2-40B4-BE49-F238E27FC236}">
                    <a16:creationId xmlns:a16="http://schemas.microsoft.com/office/drawing/2014/main" id="{5D02DFD4-2653-FC2B-4237-6795F566F0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2605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.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69" name="Line 268">
                <a:extLst>
                  <a:ext uri="{FF2B5EF4-FFF2-40B4-BE49-F238E27FC236}">
                    <a16:creationId xmlns:a16="http://schemas.microsoft.com/office/drawing/2014/main" id="{544E9A22-74E3-4035-6D3F-92ADBB13A80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38638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70" name="Rectangle 269">
                <a:extLst>
                  <a:ext uri="{FF2B5EF4-FFF2-40B4-BE49-F238E27FC236}">
                    <a16:creationId xmlns:a16="http://schemas.microsoft.com/office/drawing/2014/main" id="{032386E5-0060-3641-F47F-2062DB8F92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4193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.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71" name="Line 270">
                <a:extLst>
                  <a:ext uri="{FF2B5EF4-FFF2-40B4-BE49-F238E27FC236}">
                    <a16:creationId xmlns:a16="http://schemas.microsoft.com/office/drawing/2014/main" id="{053B0E91-3A72-9CD2-6F19-14947BE7F77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0068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72" name="Rectangle 271">
                <a:extLst>
                  <a:ext uri="{FF2B5EF4-FFF2-40B4-BE49-F238E27FC236}">
                    <a16:creationId xmlns:a16="http://schemas.microsoft.com/office/drawing/2014/main" id="{221630DC-033A-2206-6C08-7D98E0FA775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782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.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73" name="Line 272">
                <a:extLst>
                  <a:ext uri="{FF2B5EF4-FFF2-40B4-BE49-F238E27FC236}">
                    <a16:creationId xmlns:a16="http://schemas.microsoft.com/office/drawing/2014/main" id="{AD4E46AF-C718-1EC8-FCF8-F155764785A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1657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74" name="Rectangle 273">
                <a:extLst>
                  <a:ext uri="{FF2B5EF4-FFF2-40B4-BE49-F238E27FC236}">
                    <a16:creationId xmlns:a16="http://schemas.microsoft.com/office/drawing/2014/main" id="{A8727CFF-396A-DD65-E4B5-0521FC23B59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57212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.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75" name="Line 274">
                <a:extLst>
                  <a:ext uri="{FF2B5EF4-FFF2-40B4-BE49-F238E27FC236}">
                    <a16:creationId xmlns:a16="http://schemas.microsoft.com/office/drawing/2014/main" id="{772BFFD7-2AD6-970A-F7ED-0A0E3B87FA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3246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76" name="Rectangle 275">
                <a:extLst>
                  <a:ext uri="{FF2B5EF4-FFF2-40B4-BE49-F238E27FC236}">
                    <a16:creationId xmlns:a16="http://schemas.microsoft.com/office/drawing/2014/main" id="{EE8325EF-0F94-EFBD-58CA-2DEC7A48B8E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68801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77" name="Line 276">
                <a:extLst>
                  <a:ext uri="{FF2B5EF4-FFF2-40B4-BE49-F238E27FC236}">
                    <a16:creationId xmlns:a16="http://schemas.microsoft.com/office/drawing/2014/main" id="{6AE9D2BD-8920-3A32-15CE-F5CDFFDF8F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4200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78" name="Rectangle 277">
                <a:extLst>
                  <a:ext uri="{FF2B5EF4-FFF2-40B4-BE49-F238E27FC236}">
                    <a16:creationId xmlns:a16="http://schemas.microsoft.com/office/drawing/2014/main" id="{B9FB5FB4-75A4-6D33-3130-20FA448A11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9913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.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79" name="Line 278">
                <a:extLst>
                  <a:ext uri="{FF2B5EF4-FFF2-40B4-BE49-F238E27FC236}">
                    <a16:creationId xmlns:a16="http://schemas.microsoft.com/office/drawing/2014/main" id="{BFB2396B-3F1F-CADA-4AE4-B81AB46703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5788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80" name="Rectangle 279">
                <a:extLst>
                  <a:ext uri="{FF2B5EF4-FFF2-40B4-BE49-F238E27FC236}">
                    <a16:creationId xmlns:a16="http://schemas.microsoft.com/office/drawing/2014/main" id="{1B67E7F9-6690-E353-8C91-B1B14A5F86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1502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.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81" name="Line 280">
                <a:extLst>
                  <a:ext uri="{FF2B5EF4-FFF2-40B4-BE49-F238E27FC236}">
                    <a16:creationId xmlns:a16="http://schemas.microsoft.com/office/drawing/2014/main" id="{8153D6C0-2D1F-E2FA-6C1E-563ABC7B6A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7377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82" name="Rectangle 281">
                <a:extLst>
                  <a:ext uri="{FF2B5EF4-FFF2-40B4-BE49-F238E27FC236}">
                    <a16:creationId xmlns:a16="http://schemas.microsoft.com/office/drawing/2014/main" id="{08C183F6-FA0D-F44B-7BDE-0596653E3A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2932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.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83" name="Line 282">
                <a:extLst>
                  <a:ext uri="{FF2B5EF4-FFF2-40B4-BE49-F238E27FC236}">
                    <a16:creationId xmlns:a16="http://schemas.microsoft.com/office/drawing/2014/main" id="{410AA41F-618C-A35E-D7FB-090369B092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8966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84" name="Rectangle 283">
                <a:extLst>
                  <a:ext uri="{FF2B5EF4-FFF2-40B4-BE49-F238E27FC236}">
                    <a16:creationId xmlns:a16="http://schemas.microsoft.com/office/drawing/2014/main" id="{1AA3C6C3-FE9E-8CDE-8631-0CF03FDFD2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4521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4.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85" name="Line 284">
                <a:extLst>
                  <a:ext uri="{FF2B5EF4-FFF2-40B4-BE49-F238E27FC236}">
                    <a16:creationId xmlns:a16="http://schemas.microsoft.com/office/drawing/2014/main" id="{935D5F31-8D1C-D27D-25FE-C32236D5CB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0555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86" name="Rectangle 285">
                <a:extLst>
                  <a:ext uri="{FF2B5EF4-FFF2-40B4-BE49-F238E27FC236}">
                    <a16:creationId xmlns:a16="http://schemas.microsoft.com/office/drawing/2014/main" id="{2D7C2491-039F-85F3-4763-755F4F96DFE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88088" y="6697663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87" name="Line 286">
                <a:extLst>
                  <a:ext uri="{FF2B5EF4-FFF2-40B4-BE49-F238E27FC236}">
                    <a16:creationId xmlns:a16="http://schemas.microsoft.com/office/drawing/2014/main" id="{CF0EC674-F8A5-1337-4BFA-2D5A9A94B8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2143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88" name="Rectangle 287">
                <a:extLst>
                  <a:ext uri="{FF2B5EF4-FFF2-40B4-BE49-F238E27FC236}">
                    <a16:creationId xmlns:a16="http://schemas.microsoft.com/office/drawing/2014/main" id="{26E0244B-DBAC-D9E8-0135-B1C873562EA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37698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5.1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89" name="Line 288">
                <a:extLst>
                  <a:ext uri="{FF2B5EF4-FFF2-40B4-BE49-F238E27FC236}">
                    <a16:creationId xmlns:a16="http://schemas.microsoft.com/office/drawing/2014/main" id="{B37065C7-AC01-B9DD-6716-B36FB51D29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3573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90" name="Rectangle 289">
                <a:extLst>
                  <a:ext uri="{FF2B5EF4-FFF2-40B4-BE49-F238E27FC236}">
                    <a16:creationId xmlns:a16="http://schemas.microsoft.com/office/drawing/2014/main" id="{EA23DF14-8C79-C7FB-CA28-1297818DAD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49287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5.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91" name="Line 290">
                <a:extLst>
                  <a:ext uri="{FF2B5EF4-FFF2-40B4-BE49-F238E27FC236}">
                    <a16:creationId xmlns:a16="http://schemas.microsoft.com/office/drawing/2014/main" id="{6BD5ED57-3908-9F3D-190B-B253199F66B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5162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92" name="Rectangle 291">
                <a:extLst>
                  <a:ext uri="{FF2B5EF4-FFF2-40B4-BE49-F238E27FC236}">
                    <a16:creationId xmlns:a16="http://schemas.microsoft.com/office/drawing/2014/main" id="{6949FB4C-A479-DA42-B30C-E402C99C60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0876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5.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93" name="Line 292">
                <a:extLst>
                  <a:ext uri="{FF2B5EF4-FFF2-40B4-BE49-F238E27FC236}">
                    <a16:creationId xmlns:a16="http://schemas.microsoft.com/office/drawing/2014/main" id="{DDAB3485-DB29-5A82-33DB-BD00C17C02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6751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94" name="Rectangle 293">
                <a:extLst>
                  <a:ext uri="{FF2B5EF4-FFF2-40B4-BE49-F238E27FC236}">
                    <a16:creationId xmlns:a16="http://schemas.microsoft.com/office/drawing/2014/main" id="{82ED24DA-2887-091D-FB93-AA6D7293EA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2306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5.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95" name="Line 294">
                <a:extLst>
                  <a:ext uri="{FF2B5EF4-FFF2-40B4-BE49-F238E27FC236}">
                    <a16:creationId xmlns:a16="http://schemas.microsoft.com/office/drawing/2014/main" id="{3E17950F-6C86-33AC-9F3D-0E006A81CDF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87863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96" name="Rectangle 295">
                <a:extLst>
                  <a:ext uri="{FF2B5EF4-FFF2-40B4-BE49-F238E27FC236}">
                    <a16:creationId xmlns:a16="http://schemas.microsoft.com/office/drawing/2014/main" id="{EE534CD8-AC4E-8389-62E8-B6163F41677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3418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5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97" name="Line 296">
                <a:extLst>
                  <a:ext uri="{FF2B5EF4-FFF2-40B4-BE49-F238E27FC236}">
                    <a16:creationId xmlns:a16="http://schemas.microsoft.com/office/drawing/2014/main" id="{A8F6725C-EED4-3396-973E-F36A494D8C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9293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98" name="Rectangle 297">
                <a:extLst>
                  <a:ext uri="{FF2B5EF4-FFF2-40B4-BE49-F238E27FC236}">
                    <a16:creationId xmlns:a16="http://schemas.microsoft.com/office/drawing/2014/main" id="{94792209-94B0-F2F7-8AB5-870AE689A44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95007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5.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99" name="Line 298">
                <a:extLst>
                  <a:ext uri="{FF2B5EF4-FFF2-40B4-BE49-F238E27FC236}">
                    <a16:creationId xmlns:a16="http://schemas.microsoft.com/office/drawing/2014/main" id="{4CC5A841-D09A-60E1-B585-90F87963C3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0882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00" name="Rectangle 299">
                <a:extLst>
                  <a:ext uri="{FF2B5EF4-FFF2-40B4-BE49-F238E27FC236}">
                    <a16:creationId xmlns:a16="http://schemas.microsoft.com/office/drawing/2014/main" id="{85A2F0A4-A36C-D478-5D05-D630D104DCC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06437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5.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01" name="Line 300">
                <a:extLst>
                  <a:ext uri="{FF2B5EF4-FFF2-40B4-BE49-F238E27FC236}">
                    <a16:creationId xmlns:a16="http://schemas.microsoft.com/office/drawing/2014/main" id="{CF8AE234-E1F8-A40C-A3CD-8B7F37A60A9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2471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02" name="Rectangle 301">
                <a:extLst>
                  <a:ext uri="{FF2B5EF4-FFF2-40B4-BE49-F238E27FC236}">
                    <a16:creationId xmlns:a16="http://schemas.microsoft.com/office/drawing/2014/main" id="{7F7ED657-3EBC-313C-5145-BB8B8D2462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8026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5.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03" name="Line 302">
                <a:extLst>
                  <a:ext uri="{FF2B5EF4-FFF2-40B4-BE49-F238E27FC236}">
                    <a16:creationId xmlns:a16="http://schemas.microsoft.com/office/drawing/2014/main" id="{5056943C-A3C5-9C45-13DD-B15AE9A416D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4060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04" name="Rectangle 303">
                <a:extLst>
                  <a:ext uri="{FF2B5EF4-FFF2-40B4-BE49-F238E27FC236}">
                    <a16:creationId xmlns:a16="http://schemas.microsoft.com/office/drawing/2014/main" id="{C6CC6D26-D408-5299-E2A2-3D76D56D1BF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9615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5.9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05" name="Line 304">
                <a:extLst>
                  <a:ext uri="{FF2B5EF4-FFF2-40B4-BE49-F238E27FC236}">
                    <a16:creationId xmlns:a16="http://schemas.microsoft.com/office/drawing/2014/main" id="{287DDA21-EC3D-24D4-CBEC-AB83446742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45648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06" name="Rectangle 305">
                <a:extLst>
                  <a:ext uri="{FF2B5EF4-FFF2-40B4-BE49-F238E27FC236}">
                    <a16:creationId xmlns:a16="http://schemas.microsoft.com/office/drawing/2014/main" id="{DACC3403-172D-DE96-4EE5-D499FC712B6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439026" y="6697663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07" name="Line 306">
                <a:extLst>
                  <a:ext uri="{FF2B5EF4-FFF2-40B4-BE49-F238E27FC236}">
                    <a16:creationId xmlns:a16="http://schemas.microsoft.com/office/drawing/2014/main" id="{975D388F-6E1C-69E3-5BBF-A82DA54AAA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57237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08" name="Rectangle 307">
                <a:extLst>
                  <a:ext uri="{FF2B5EF4-FFF2-40B4-BE49-F238E27FC236}">
                    <a16:creationId xmlns:a16="http://schemas.microsoft.com/office/drawing/2014/main" id="{228D0ECD-7294-4034-0573-E9415088EC1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52792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.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09" name="Line 308">
                <a:extLst>
                  <a:ext uri="{FF2B5EF4-FFF2-40B4-BE49-F238E27FC236}">
                    <a16:creationId xmlns:a16="http://schemas.microsoft.com/office/drawing/2014/main" id="{39D9F08B-26BF-ED23-DF63-407F485720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8667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10" name="Rectangle 309">
                <a:extLst>
                  <a:ext uri="{FF2B5EF4-FFF2-40B4-BE49-F238E27FC236}">
                    <a16:creationId xmlns:a16="http://schemas.microsoft.com/office/drawing/2014/main" id="{A53107CE-F764-3BA9-6344-B8B629E7DF1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4381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.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11" name="Line 310">
                <a:extLst>
                  <a:ext uri="{FF2B5EF4-FFF2-40B4-BE49-F238E27FC236}">
                    <a16:creationId xmlns:a16="http://schemas.microsoft.com/office/drawing/2014/main" id="{4668A8E0-302B-85CA-E494-2FB98FBFB6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0256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12" name="Rectangle 311">
                <a:extLst>
                  <a:ext uri="{FF2B5EF4-FFF2-40B4-BE49-F238E27FC236}">
                    <a16:creationId xmlns:a16="http://schemas.microsoft.com/office/drawing/2014/main" id="{75D37571-55E0-DB07-E7A0-88A3FEC63F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75970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.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13" name="Line 312">
                <a:extLst>
                  <a:ext uri="{FF2B5EF4-FFF2-40B4-BE49-F238E27FC236}">
                    <a16:creationId xmlns:a16="http://schemas.microsoft.com/office/drawing/2014/main" id="{B5010950-1C79-31BC-91F3-1A3218BAB0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91368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14" name="Rectangle 313">
                <a:extLst>
                  <a:ext uri="{FF2B5EF4-FFF2-40B4-BE49-F238E27FC236}">
                    <a16:creationId xmlns:a16="http://schemas.microsoft.com/office/drawing/2014/main" id="{A58CB8AD-F810-CA8C-4BEE-CDF428C617C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86923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.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15" name="Line 314">
                <a:extLst>
                  <a:ext uri="{FF2B5EF4-FFF2-40B4-BE49-F238E27FC236}">
                    <a16:creationId xmlns:a16="http://schemas.microsoft.com/office/drawing/2014/main" id="{A30D7671-E4FF-C349-AD04-961FE0555E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02798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16" name="Rectangle 315">
                <a:extLst>
                  <a:ext uri="{FF2B5EF4-FFF2-40B4-BE49-F238E27FC236}">
                    <a16:creationId xmlns:a16="http://schemas.microsoft.com/office/drawing/2014/main" id="{A3173A5F-00E1-658F-8AE3-7E7B0015E29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8512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17" name="Line 316">
                <a:extLst>
                  <a:ext uri="{FF2B5EF4-FFF2-40B4-BE49-F238E27FC236}">
                    <a16:creationId xmlns:a16="http://schemas.microsoft.com/office/drawing/2014/main" id="{D49A0E2F-1B42-55BD-AA3C-44DF784E1E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14387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18" name="Rectangle 317">
                <a:extLst>
                  <a:ext uri="{FF2B5EF4-FFF2-40B4-BE49-F238E27FC236}">
                    <a16:creationId xmlns:a16="http://schemas.microsoft.com/office/drawing/2014/main" id="{2B803FAD-4DD7-8DC7-CF44-29B3D3CC31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0101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.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19" name="Line 318">
                <a:extLst>
                  <a:ext uri="{FF2B5EF4-FFF2-40B4-BE49-F238E27FC236}">
                    <a16:creationId xmlns:a16="http://schemas.microsoft.com/office/drawing/2014/main" id="{2E56192D-7D94-6065-4D47-A9FB60C5F9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5976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20" name="Rectangle 319">
                <a:extLst>
                  <a:ext uri="{FF2B5EF4-FFF2-40B4-BE49-F238E27FC236}">
                    <a16:creationId xmlns:a16="http://schemas.microsoft.com/office/drawing/2014/main" id="{9A7F6E1A-C95A-5096-9B11-E2291BC6EE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21531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.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21" name="Line 320">
                <a:extLst>
                  <a:ext uri="{FF2B5EF4-FFF2-40B4-BE49-F238E27FC236}">
                    <a16:creationId xmlns:a16="http://schemas.microsoft.com/office/drawing/2014/main" id="{8AA50F3D-D855-1440-0CA1-AD52AECC4E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7565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22" name="Rectangle 321">
                <a:extLst>
                  <a:ext uri="{FF2B5EF4-FFF2-40B4-BE49-F238E27FC236}">
                    <a16:creationId xmlns:a16="http://schemas.microsoft.com/office/drawing/2014/main" id="{A7FC51D4-540A-809A-093C-1215DFDD99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3120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.8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23" name="Line 322">
                <a:extLst>
                  <a:ext uri="{FF2B5EF4-FFF2-40B4-BE49-F238E27FC236}">
                    <a16:creationId xmlns:a16="http://schemas.microsoft.com/office/drawing/2014/main" id="{E580A2B6-301A-9DC6-6546-66CBB8DC34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9153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24" name="Rectangle 323">
                <a:extLst>
                  <a:ext uri="{FF2B5EF4-FFF2-40B4-BE49-F238E27FC236}">
                    <a16:creationId xmlns:a16="http://schemas.microsoft.com/office/drawing/2014/main" id="{2DB7BDB4-EA90-EC74-F525-D20DA97345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4708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6.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25" name="Line 324">
                <a:extLst>
                  <a:ext uri="{FF2B5EF4-FFF2-40B4-BE49-F238E27FC236}">
                    <a16:creationId xmlns:a16="http://schemas.microsoft.com/office/drawing/2014/main" id="{17D88224-2C02-70F9-C8B2-DAD105718F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0742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26" name="Rectangle 325">
                <a:extLst>
                  <a:ext uri="{FF2B5EF4-FFF2-40B4-BE49-F238E27FC236}">
                    <a16:creationId xmlns:a16="http://schemas.microsoft.com/office/drawing/2014/main" id="{21E9BADC-D827-F1FE-83D7-7A330DB665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89963" y="6697663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27" name="Line 326">
                <a:extLst>
                  <a:ext uri="{FF2B5EF4-FFF2-40B4-BE49-F238E27FC236}">
                    <a16:creationId xmlns:a16="http://schemas.microsoft.com/office/drawing/2014/main" id="{AE59984A-9ED3-545E-F18C-33CC2E0FC4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2331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28" name="Rectangle 327">
                <a:extLst>
                  <a:ext uri="{FF2B5EF4-FFF2-40B4-BE49-F238E27FC236}">
                    <a16:creationId xmlns:a16="http://schemas.microsoft.com/office/drawing/2014/main" id="{20A0A4F5-4169-881F-8847-61AD6DE5C6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67886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7.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29" name="Line 328">
                <a:extLst>
                  <a:ext uri="{FF2B5EF4-FFF2-40B4-BE49-F238E27FC236}">
                    <a16:creationId xmlns:a16="http://schemas.microsoft.com/office/drawing/2014/main" id="{BDAB9DCE-B894-7588-8EDF-340C0F5132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83761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30" name="Rectangle 329">
                <a:extLst>
                  <a:ext uri="{FF2B5EF4-FFF2-40B4-BE49-F238E27FC236}">
                    <a16:creationId xmlns:a16="http://schemas.microsoft.com/office/drawing/2014/main" id="{41C33D24-47AF-7908-85AD-177C33C324C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79475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7.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31" name="Line 330">
                <a:extLst>
                  <a:ext uri="{FF2B5EF4-FFF2-40B4-BE49-F238E27FC236}">
                    <a16:creationId xmlns:a16="http://schemas.microsoft.com/office/drawing/2014/main" id="{58734573-6F40-D531-7682-EBD1F52D4E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94873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32" name="Rectangle 331">
                <a:extLst>
                  <a:ext uri="{FF2B5EF4-FFF2-40B4-BE49-F238E27FC236}">
                    <a16:creationId xmlns:a16="http://schemas.microsoft.com/office/drawing/2014/main" id="{5F4474D9-F5D9-B6DC-711D-7F17E93AE1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90428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7.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33" name="Line 332">
                <a:extLst>
                  <a:ext uri="{FF2B5EF4-FFF2-40B4-BE49-F238E27FC236}">
                    <a16:creationId xmlns:a16="http://schemas.microsoft.com/office/drawing/2014/main" id="{B902FEB8-8BE1-1C59-6A45-7F329CEFD5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6462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34" name="Rectangle 333">
                <a:extLst>
                  <a:ext uri="{FF2B5EF4-FFF2-40B4-BE49-F238E27FC236}">
                    <a16:creationId xmlns:a16="http://schemas.microsoft.com/office/drawing/2014/main" id="{8895A4FB-EA06-68CE-919D-1B1CB13ED6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02017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7.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35" name="Line 334">
                <a:extLst>
                  <a:ext uri="{FF2B5EF4-FFF2-40B4-BE49-F238E27FC236}">
                    <a16:creationId xmlns:a16="http://schemas.microsoft.com/office/drawing/2014/main" id="{E0041345-1AE9-4293-1344-041AB2E29FA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17892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36" name="Rectangle 335">
                <a:extLst>
                  <a:ext uri="{FF2B5EF4-FFF2-40B4-BE49-F238E27FC236}">
                    <a16:creationId xmlns:a16="http://schemas.microsoft.com/office/drawing/2014/main" id="{7D7D67CD-AA96-15E0-AA78-39A5687E92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13606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7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37" name="Line 336">
                <a:extLst>
                  <a:ext uri="{FF2B5EF4-FFF2-40B4-BE49-F238E27FC236}">
                    <a16:creationId xmlns:a16="http://schemas.microsoft.com/office/drawing/2014/main" id="{7CF7D7A8-4DD5-0B1E-0489-4CDB43B070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29481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38" name="Rectangle 337">
                <a:extLst>
                  <a:ext uri="{FF2B5EF4-FFF2-40B4-BE49-F238E27FC236}">
                    <a16:creationId xmlns:a16="http://schemas.microsoft.com/office/drawing/2014/main" id="{CAA7F861-E3CF-70B7-A377-57C36D8C7F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25195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7.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39" name="Line 338">
                <a:extLst>
                  <a:ext uri="{FF2B5EF4-FFF2-40B4-BE49-F238E27FC236}">
                    <a16:creationId xmlns:a16="http://schemas.microsoft.com/office/drawing/2014/main" id="{79FDA9E6-A022-3674-7179-8B73BA2B92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41070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40" name="Rectangle 339">
                <a:extLst>
                  <a:ext uri="{FF2B5EF4-FFF2-40B4-BE49-F238E27FC236}">
                    <a16:creationId xmlns:a16="http://schemas.microsoft.com/office/drawing/2014/main" id="{39FDA336-7909-6A53-BCEE-318496445D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36625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7.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41" name="Line 340">
                <a:extLst>
                  <a:ext uri="{FF2B5EF4-FFF2-40B4-BE49-F238E27FC236}">
                    <a16:creationId xmlns:a16="http://schemas.microsoft.com/office/drawing/2014/main" id="{A16C162D-F6F5-C132-710C-F0FCC6A3BF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2658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42" name="Rectangle 341">
                <a:extLst>
                  <a:ext uri="{FF2B5EF4-FFF2-40B4-BE49-F238E27FC236}">
                    <a16:creationId xmlns:a16="http://schemas.microsoft.com/office/drawing/2014/main" id="{C64B55D5-F974-25DC-4F24-1B40351FD8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48213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7.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43" name="Line 342">
                <a:extLst>
                  <a:ext uri="{FF2B5EF4-FFF2-40B4-BE49-F238E27FC236}">
                    <a16:creationId xmlns:a16="http://schemas.microsoft.com/office/drawing/2014/main" id="{A2B5FFDE-CCBA-B941-1701-F26940061E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64247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44" name="Rectangle 343">
                <a:extLst>
                  <a:ext uri="{FF2B5EF4-FFF2-40B4-BE49-F238E27FC236}">
                    <a16:creationId xmlns:a16="http://schemas.microsoft.com/office/drawing/2014/main" id="{B95A3D5B-126F-E6E4-F1FE-95B54EFEA80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59802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7.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45" name="Line 344">
                <a:extLst>
                  <a:ext uri="{FF2B5EF4-FFF2-40B4-BE49-F238E27FC236}">
                    <a16:creationId xmlns:a16="http://schemas.microsoft.com/office/drawing/2014/main" id="{E1F8E698-2541-1A53-8571-858A4B37F5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75836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46" name="Rectangle 345">
                <a:extLst>
                  <a:ext uri="{FF2B5EF4-FFF2-40B4-BE49-F238E27FC236}">
                    <a16:creationId xmlns:a16="http://schemas.microsoft.com/office/drawing/2014/main" id="{86A75E94-D143-609E-AF4D-93BE444DC3F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740901" y="6697663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47" name="Line 346">
                <a:extLst>
                  <a:ext uri="{FF2B5EF4-FFF2-40B4-BE49-F238E27FC236}">
                    <a16:creationId xmlns:a16="http://schemas.microsoft.com/office/drawing/2014/main" id="{940F109E-AE02-4BF2-E809-2B8A36756B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86790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48" name="Rectangle 347">
                <a:extLst>
                  <a:ext uri="{FF2B5EF4-FFF2-40B4-BE49-F238E27FC236}">
                    <a16:creationId xmlns:a16="http://schemas.microsoft.com/office/drawing/2014/main" id="{8357BB25-3D6A-3619-CF0A-F1F882E6888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82345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8.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49" name="Line 348">
                <a:extLst>
                  <a:ext uri="{FF2B5EF4-FFF2-40B4-BE49-F238E27FC236}">
                    <a16:creationId xmlns:a16="http://schemas.microsoft.com/office/drawing/2014/main" id="{7F840DF1-B53E-B56B-C6A4-812FE1F45B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98378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50" name="Rectangle 349">
                <a:extLst>
                  <a:ext uri="{FF2B5EF4-FFF2-40B4-BE49-F238E27FC236}">
                    <a16:creationId xmlns:a16="http://schemas.microsoft.com/office/drawing/2014/main" id="{F0F4B2D0-F04D-0EE4-8F5C-3C6579D0A5D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3933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8.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51" name="Line 350">
                <a:extLst>
                  <a:ext uri="{FF2B5EF4-FFF2-40B4-BE49-F238E27FC236}">
                    <a16:creationId xmlns:a16="http://schemas.microsoft.com/office/drawing/2014/main" id="{71DD8685-17AC-2CD8-83B1-E32B594DC18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9967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52" name="Rectangle 351">
                <a:extLst>
                  <a:ext uri="{FF2B5EF4-FFF2-40B4-BE49-F238E27FC236}">
                    <a16:creationId xmlns:a16="http://schemas.microsoft.com/office/drawing/2014/main" id="{C193B165-527E-94F3-803B-198156411CA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05522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8.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53" name="Line 352">
                <a:extLst>
                  <a:ext uri="{FF2B5EF4-FFF2-40B4-BE49-F238E27FC236}">
                    <a16:creationId xmlns:a16="http://schemas.microsoft.com/office/drawing/2014/main" id="{3C9F0394-352C-1A83-30F7-1621F1501A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21556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54" name="Rectangle 353">
                <a:extLst>
                  <a:ext uri="{FF2B5EF4-FFF2-40B4-BE49-F238E27FC236}">
                    <a16:creationId xmlns:a16="http://schemas.microsoft.com/office/drawing/2014/main" id="{A354034D-E6EC-BD9A-C3FF-71364DEA9BD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17111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8.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55" name="Line 354">
                <a:extLst>
                  <a:ext uri="{FF2B5EF4-FFF2-40B4-BE49-F238E27FC236}">
                    <a16:creationId xmlns:a16="http://schemas.microsoft.com/office/drawing/2014/main" id="{7E651C72-4077-2B2F-AF3F-EF32E9CD0F0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32986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56" name="Rectangle 355">
                <a:extLst>
                  <a:ext uri="{FF2B5EF4-FFF2-40B4-BE49-F238E27FC236}">
                    <a16:creationId xmlns:a16="http://schemas.microsoft.com/office/drawing/2014/main" id="{D300C2AD-C7BD-49F9-CE73-F6ED63ABF4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28700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8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57" name="Line 356">
                <a:extLst>
                  <a:ext uri="{FF2B5EF4-FFF2-40B4-BE49-F238E27FC236}">
                    <a16:creationId xmlns:a16="http://schemas.microsoft.com/office/drawing/2014/main" id="{4FEBD715-969C-246B-2D73-B7476E7462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44575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58" name="Rectangle 357">
                <a:extLst>
                  <a:ext uri="{FF2B5EF4-FFF2-40B4-BE49-F238E27FC236}">
                    <a16:creationId xmlns:a16="http://schemas.microsoft.com/office/drawing/2014/main" id="{07EC2776-89D3-B19B-DC8A-1F7CF13AED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40130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8.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59" name="Line 358">
                <a:extLst>
                  <a:ext uri="{FF2B5EF4-FFF2-40B4-BE49-F238E27FC236}">
                    <a16:creationId xmlns:a16="http://schemas.microsoft.com/office/drawing/2014/main" id="{E8EE0664-C1CD-87E4-3CAB-CB3B8E51DC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56163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60" name="Rectangle 359">
                <a:extLst>
                  <a:ext uri="{FF2B5EF4-FFF2-40B4-BE49-F238E27FC236}">
                    <a16:creationId xmlns:a16="http://schemas.microsoft.com/office/drawing/2014/main" id="{C1792D3D-961B-F649-2726-C688F8F2BF9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51718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8.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61" name="Line 360">
                <a:extLst>
                  <a:ext uri="{FF2B5EF4-FFF2-40B4-BE49-F238E27FC236}">
                    <a16:creationId xmlns:a16="http://schemas.microsoft.com/office/drawing/2014/main" id="{01A69137-2FCA-F818-F62A-EA6422E24A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67752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62" name="Rectangle 361">
                <a:extLst>
                  <a:ext uri="{FF2B5EF4-FFF2-40B4-BE49-F238E27FC236}">
                    <a16:creationId xmlns:a16="http://schemas.microsoft.com/office/drawing/2014/main" id="{99F6BC57-CEE2-B1C8-19B5-43FBB84A20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63307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8.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63" name="Line 362">
                <a:extLst>
                  <a:ext uri="{FF2B5EF4-FFF2-40B4-BE49-F238E27FC236}">
                    <a16:creationId xmlns:a16="http://schemas.microsoft.com/office/drawing/2014/main" id="{269FC92A-F6B3-9C6F-D113-9EF0C0ECA7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79341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64" name="Rectangle 363">
                <a:extLst>
                  <a:ext uri="{FF2B5EF4-FFF2-40B4-BE49-F238E27FC236}">
                    <a16:creationId xmlns:a16="http://schemas.microsoft.com/office/drawing/2014/main" id="{F3212C5A-DB7E-1574-A071-8B25D2B6BE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74896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8.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65" name="Line 364">
                <a:extLst>
                  <a:ext uri="{FF2B5EF4-FFF2-40B4-BE49-F238E27FC236}">
                    <a16:creationId xmlns:a16="http://schemas.microsoft.com/office/drawing/2014/main" id="{F5F2A6EB-1177-9F85-036A-9B0DE6E398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90295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66" name="Rectangle 365">
                <a:extLst>
                  <a:ext uri="{FF2B5EF4-FFF2-40B4-BE49-F238E27FC236}">
                    <a16:creationId xmlns:a16="http://schemas.microsoft.com/office/drawing/2014/main" id="{12F3F459-D0A8-F611-4A0E-9CEBAC4003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887076" y="6697663"/>
                <a:ext cx="352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9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67" name="Line 366">
                <a:extLst>
                  <a:ext uri="{FF2B5EF4-FFF2-40B4-BE49-F238E27FC236}">
                    <a16:creationId xmlns:a16="http://schemas.microsoft.com/office/drawing/2014/main" id="{A5B0322F-4645-555C-1FCA-374C24BE90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01883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68" name="Rectangle 367">
                <a:extLst>
                  <a:ext uri="{FF2B5EF4-FFF2-40B4-BE49-F238E27FC236}">
                    <a16:creationId xmlns:a16="http://schemas.microsoft.com/office/drawing/2014/main" id="{5B595C2A-BB3E-9A2C-F4D0-6FF3DDDED2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7438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9.1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69" name="Line 368">
                <a:extLst>
                  <a:ext uri="{FF2B5EF4-FFF2-40B4-BE49-F238E27FC236}">
                    <a16:creationId xmlns:a16="http://schemas.microsoft.com/office/drawing/2014/main" id="{65715118-805A-12B8-7509-EFE0E300CC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13472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70" name="Rectangle 369">
                <a:extLst>
                  <a:ext uri="{FF2B5EF4-FFF2-40B4-BE49-F238E27FC236}">
                    <a16:creationId xmlns:a16="http://schemas.microsoft.com/office/drawing/2014/main" id="{0C8013FC-15F2-B189-5FEB-F22D7A9CC2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09027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9.2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71" name="Line 370">
                <a:extLst>
                  <a:ext uri="{FF2B5EF4-FFF2-40B4-BE49-F238E27FC236}">
                    <a16:creationId xmlns:a16="http://schemas.microsoft.com/office/drawing/2014/main" id="{F8F4E744-389B-E16B-13D3-8866E0B777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25061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72" name="Rectangle 371">
                <a:extLst>
                  <a:ext uri="{FF2B5EF4-FFF2-40B4-BE49-F238E27FC236}">
                    <a16:creationId xmlns:a16="http://schemas.microsoft.com/office/drawing/2014/main" id="{CFF1E711-4822-8F5D-F804-B642AE93B2C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20616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9.3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73" name="Line 372">
                <a:extLst>
                  <a:ext uri="{FF2B5EF4-FFF2-40B4-BE49-F238E27FC236}">
                    <a16:creationId xmlns:a16="http://schemas.microsoft.com/office/drawing/2014/main" id="{A1E57D8D-7716-6A4C-6B0C-2A55CCEE30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36491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74" name="Rectangle 373">
                <a:extLst>
                  <a:ext uri="{FF2B5EF4-FFF2-40B4-BE49-F238E27FC236}">
                    <a16:creationId xmlns:a16="http://schemas.microsoft.com/office/drawing/2014/main" id="{0D4A77F6-2A48-3B96-5226-3A0858E229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322051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9.4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75" name="Line 374">
                <a:extLst>
                  <a:ext uri="{FF2B5EF4-FFF2-40B4-BE49-F238E27FC236}">
                    <a16:creationId xmlns:a16="http://schemas.microsoft.com/office/drawing/2014/main" id="{C334CC0E-FB50-3EB2-9076-A45BCC74D5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480801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76" name="Rectangle 375">
                <a:extLst>
                  <a:ext uri="{FF2B5EF4-FFF2-40B4-BE49-F238E27FC236}">
                    <a16:creationId xmlns:a16="http://schemas.microsoft.com/office/drawing/2014/main" id="{BAE907AD-A1F9-1AB3-8E50-1F1B0B7C3B9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43793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9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77" name="Line 376">
                <a:extLst>
                  <a:ext uri="{FF2B5EF4-FFF2-40B4-BE49-F238E27FC236}">
                    <a16:creationId xmlns:a16="http://schemas.microsoft.com/office/drawing/2014/main" id="{D47F96EE-2CEE-DAE4-F67F-4EA70C16CE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596688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78" name="Rectangle 377">
                <a:extLst>
                  <a:ext uri="{FF2B5EF4-FFF2-40B4-BE49-F238E27FC236}">
                    <a16:creationId xmlns:a16="http://schemas.microsoft.com/office/drawing/2014/main" id="{D65B2387-0825-4FDD-6182-51B28E8F6B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552238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9.6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79" name="Line 378">
                <a:extLst>
                  <a:ext uri="{FF2B5EF4-FFF2-40B4-BE49-F238E27FC236}">
                    <a16:creationId xmlns:a16="http://schemas.microsoft.com/office/drawing/2014/main" id="{CC0F01AA-2629-75C6-4B5B-75DEF27169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712576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80" name="Rectangle 379">
                <a:extLst>
                  <a:ext uri="{FF2B5EF4-FFF2-40B4-BE49-F238E27FC236}">
                    <a16:creationId xmlns:a16="http://schemas.microsoft.com/office/drawing/2014/main" id="{CE1696AA-56F7-3132-5721-CF9D0CF21A4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68126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9.7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  <p:sp>
            <p:nvSpPr>
              <p:cNvPr id="181" name="Line 380">
                <a:extLst>
                  <a:ext uri="{FF2B5EF4-FFF2-40B4-BE49-F238E27FC236}">
                    <a16:creationId xmlns:a16="http://schemas.microsoft.com/office/drawing/2014/main" id="{268BAF8A-7267-0627-DFE9-607A08A271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828463" y="6675438"/>
                <a:ext cx="0" cy="22225"/>
              </a:xfrm>
              <a:prstGeom prst="line">
                <a:avLst/>
              </a:prstGeom>
              <a:noFill/>
              <a:ln w="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>
                  <a:latin typeface="Helvetica" pitchFamily="2" charset="0"/>
                </a:endParaRPr>
              </a:p>
            </p:txBody>
          </p:sp>
          <p:sp>
            <p:nvSpPr>
              <p:cNvPr id="182" name="Rectangle 381">
                <a:extLst>
                  <a:ext uri="{FF2B5EF4-FFF2-40B4-BE49-F238E27FC236}">
                    <a16:creationId xmlns:a16="http://schemas.microsoft.com/office/drawing/2014/main" id="{4F110055-40B5-05D8-89F0-76BD5CCB4E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784013" y="6697663"/>
                <a:ext cx="88166" cy="769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Helvetica" pitchFamily="2" charset="0"/>
                  </a:rPr>
                  <a:t>9.8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Helvetica" pitchFamily="2" charset="0"/>
                </a:endParaRPr>
              </a:p>
            </p:txBody>
          </p:sp>
        </p:grpSp>
      </p:grpSp>
      <p:sp>
        <p:nvSpPr>
          <p:cNvPr id="2" name="Rectangle 87">
            <a:extLst>
              <a:ext uri="{FF2B5EF4-FFF2-40B4-BE49-F238E27FC236}">
                <a16:creationId xmlns:a16="http://schemas.microsoft.com/office/drawing/2014/main" id="{648500D5-B120-353C-328D-93082F6BE4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209" y="3390091"/>
            <a:ext cx="183832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VMR_Eg1_2</a:t>
            </a:r>
            <a:endParaRPr kumimoji="0" lang="en-US" altLang="en-US" sz="6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4" name="Rectangle 87">
            <a:extLst>
              <a:ext uri="{FF2B5EF4-FFF2-40B4-BE49-F238E27FC236}">
                <a16:creationId xmlns:a16="http://schemas.microsoft.com/office/drawing/2014/main" id="{F85B29E9-2156-AB1C-059F-9AB22C6F4D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345" y="5071492"/>
            <a:ext cx="183832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Oyster mushroom</a:t>
            </a:r>
            <a:endParaRPr kumimoji="0" lang="en-US" altLang="en-US" sz="6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C73F5E1F-2DA5-2E70-C4CB-A71FC6179C02}"/>
              </a:ext>
            </a:extLst>
          </p:cNvPr>
          <p:cNvSpPr/>
          <p:nvPr/>
        </p:nvSpPr>
        <p:spPr>
          <a:xfrm>
            <a:off x="9178308" y="78581"/>
            <a:ext cx="2784122" cy="673258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F3E98BD-AA22-4247-A149-65C12B570166}"/>
              </a:ext>
            </a:extLst>
          </p:cNvPr>
          <p:cNvSpPr txBox="1"/>
          <p:nvPr/>
        </p:nvSpPr>
        <p:spPr>
          <a:xfrm>
            <a:off x="7599294" y="84868"/>
            <a:ext cx="42896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rgothioneine extracted ion chromatograms</a:t>
            </a:r>
          </a:p>
          <a:p>
            <a:r>
              <a:rPr lang="en-US" dirty="0"/>
              <a:t>- annotated</a:t>
            </a:r>
          </a:p>
        </p:txBody>
      </p:sp>
    </p:spTree>
    <p:extLst>
      <p:ext uri="{BB962C8B-B14F-4D97-AF65-F5344CB8AC3E}">
        <p14:creationId xmlns:p14="http://schemas.microsoft.com/office/powerpoint/2010/main" val="38593399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5812F390-738B-D349-85FE-95EDC1739C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3884" y="0"/>
            <a:ext cx="10304231" cy="6858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87819CF8-B772-8AB1-6C5E-A1A81FC0CDFA}"/>
              </a:ext>
            </a:extLst>
          </p:cNvPr>
          <p:cNvSpPr txBox="1"/>
          <p:nvPr/>
        </p:nvSpPr>
        <p:spPr>
          <a:xfrm>
            <a:off x="6505127" y="196381"/>
            <a:ext cx="277204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rgothioneine mass spectra</a:t>
            </a:r>
          </a:p>
          <a:p>
            <a:r>
              <a:rPr lang="en-US" dirty="0"/>
              <a:t>-output from softwar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C553891-9796-EA28-484D-1964055E4C1E}"/>
              </a:ext>
            </a:extLst>
          </p:cNvPr>
          <p:cNvSpPr txBox="1"/>
          <p:nvPr/>
        </p:nvSpPr>
        <p:spPr>
          <a:xfrm>
            <a:off x="4771212" y="17450"/>
            <a:ext cx="1816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[M + H]</a:t>
            </a:r>
            <a:r>
              <a:rPr lang="en-US" sz="1200" baseline="30000" dirty="0">
                <a:latin typeface="Helvetica" pitchFamily="2" charset="0"/>
              </a:rPr>
              <a:t>+</a:t>
            </a:r>
            <a:r>
              <a:rPr lang="en-US" sz="1200" dirty="0">
                <a:latin typeface="Helvetica" pitchFamily="2" charset="0"/>
              </a:rPr>
              <a:t>, 0.86 ppm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848A536-ABEC-C8DA-31B8-A657874D3A2D}"/>
              </a:ext>
            </a:extLst>
          </p:cNvPr>
          <p:cNvSpPr txBox="1"/>
          <p:nvPr/>
        </p:nvSpPr>
        <p:spPr>
          <a:xfrm>
            <a:off x="4705752" y="1678561"/>
            <a:ext cx="1816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[M + H]</a:t>
            </a:r>
            <a:r>
              <a:rPr lang="en-US" sz="1200" baseline="30000" dirty="0">
                <a:latin typeface="Helvetica" pitchFamily="2" charset="0"/>
              </a:rPr>
              <a:t>+</a:t>
            </a:r>
            <a:r>
              <a:rPr lang="en-US" sz="1200" dirty="0">
                <a:latin typeface="Helvetica" pitchFamily="2" charset="0"/>
              </a:rPr>
              <a:t>, 1.63 ppm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A048C04-3DB1-3118-AA86-122DB767CB68}"/>
              </a:ext>
            </a:extLst>
          </p:cNvPr>
          <p:cNvSpPr txBox="1"/>
          <p:nvPr/>
        </p:nvSpPr>
        <p:spPr>
          <a:xfrm>
            <a:off x="4640292" y="3371327"/>
            <a:ext cx="13902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Helvetica" pitchFamily="2" charset="0"/>
              </a:rPr>
              <a:t>[M + H]</a:t>
            </a:r>
            <a:r>
              <a:rPr lang="en-US" sz="1100" baseline="30000" dirty="0">
                <a:latin typeface="Helvetica" pitchFamily="2" charset="0"/>
              </a:rPr>
              <a:t>+</a:t>
            </a:r>
            <a:r>
              <a:rPr lang="en-US" sz="1100" dirty="0">
                <a:latin typeface="Helvetica" pitchFamily="2" charset="0"/>
              </a:rPr>
              <a:t>, 1.64 ppm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2A34B9D-D36C-13D8-136B-B22EF4C06D6D}"/>
              </a:ext>
            </a:extLst>
          </p:cNvPr>
          <p:cNvSpPr txBox="1"/>
          <p:nvPr/>
        </p:nvSpPr>
        <p:spPr>
          <a:xfrm>
            <a:off x="4574832" y="5051819"/>
            <a:ext cx="20749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[M + H]</a:t>
            </a:r>
            <a:r>
              <a:rPr lang="en-US" sz="1200" baseline="30000" dirty="0">
                <a:latin typeface="Helvetica" pitchFamily="2" charset="0"/>
              </a:rPr>
              <a:t>+</a:t>
            </a:r>
            <a:r>
              <a:rPr lang="en-US" sz="1200" dirty="0">
                <a:latin typeface="Helvetica" pitchFamily="2" charset="0"/>
              </a:rPr>
              <a:t>, 2.48 ppm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DECAADB9-F0B1-4CEA-1BC4-BE29D1F243F1}"/>
              </a:ext>
            </a:extLst>
          </p:cNvPr>
          <p:cNvCxnSpPr/>
          <p:nvPr/>
        </p:nvCxnSpPr>
        <p:spPr>
          <a:xfrm>
            <a:off x="6254839" y="2760372"/>
            <a:ext cx="394953" cy="4722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02831014-7E84-67E4-592A-023E4C26B7FD}"/>
              </a:ext>
            </a:extLst>
          </p:cNvPr>
          <p:cNvCxnSpPr/>
          <p:nvPr/>
        </p:nvCxnSpPr>
        <p:spPr>
          <a:xfrm>
            <a:off x="6254839" y="4449651"/>
            <a:ext cx="394953" cy="4722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006BE13E-344C-BD19-FE0F-962D9E318D1E}"/>
              </a:ext>
            </a:extLst>
          </p:cNvPr>
          <p:cNvCxnSpPr/>
          <p:nvPr/>
        </p:nvCxnSpPr>
        <p:spPr>
          <a:xfrm>
            <a:off x="6254839" y="6138930"/>
            <a:ext cx="394953" cy="4722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FB6E7152-E238-2A25-E634-43002C97A7B5}"/>
              </a:ext>
            </a:extLst>
          </p:cNvPr>
          <p:cNvSpPr txBox="1"/>
          <p:nvPr/>
        </p:nvSpPr>
        <p:spPr>
          <a:xfrm>
            <a:off x="5500047" y="2543911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32.09380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6FFE73E-E287-69C2-00D9-9A87196AB025}"/>
              </a:ext>
            </a:extLst>
          </p:cNvPr>
          <p:cNvSpPr txBox="1"/>
          <p:nvPr/>
        </p:nvSpPr>
        <p:spPr>
          <a:xfrm>
            <a:off x="5522252" y="4211640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32.09374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6290589-BBD0-4C4C-DEF1-D20203E75999}"/>
              </a:ext>
            </a:extLst>
          </p:cNvPr>
          <p:cNvSpPr txBox="1"/>
          <p:nvPr/>
        </p:nvSpPr>
        <p:spPr>
          <a:xfrm>
            <a:off x="5513685" y="5892085"/>
            <a:ext cx="10086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32.0946631</a:t>
            </a:r>
          </a:p>
        </p:txBody>
      </p:sp>
    </p:spTree>
    <p:extLst>
      <p:ext uri="{BB962C8B-B14F-4D97-AF65-F5344CB8AC3E}">
        <p14:creationId xmlns:p14="http://schemas.microsoft.com/office/powerpoint/2010/main" val="191491804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>
            <a:extLst>
              <a:ext uri="{FF2B5EF4-FFF2-40B4-BE49-F238E27FC236}">
                <a16:creationId xmlns:a16="http://schemas.microsoft.com/office/drawing/2014/main" id="{5812F390-738B-D349-85FE-95EDC1739C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43884" y="0"/>
            <a:ext cx="10304231" cy="6858000"/>
          </a:xfrm>
          <a:prstGeom prst="rect">
            <a:avLst/>
          </a:prstGeom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3C553891-9796-EA28-484D-1964055E4C1E}"/>
              </a:ext>
            </a:extLst>
          </p:cNvPr>
          <p:cNvSpPr txBox="1"/>
          <p:nvPr/>
        </p:nvSpPr>
        <p:spPr>
          <a:xfrm>
            <a:off x="4771212" y="17450"/>
            <a:ext cx="1816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[M + H]</a:t>
            </a:r>
            <a:r>
              <a:rPr lang="en-US" sz="1200" baseline="30000" dirty="0">
                <a:latin typeface="Helvetica" pitchFamily="2" charset="0"/>
              </a:rPr>
              <a:t>+</a:t>
            </a:r>
            <a:r>
              <a:rPr lang="en-US" sz="1200" dirty="0">
                <a:latin typeface="Helvetica" pitchFamily="2" charset="0"/>
              </a:rPr>
              <a:t>, 0.86 ppm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848A536-ABEC-C8DA-31B8-A657874D3A2D}"/>
              </a:ext>
            </a:extLst>
          </p:cNvPr>
          <p:cNvSpPr txBox="1"/>
          <p:nvPr/>
        </p:nvSpPr>
        <p:spPr>
          <a:xfrm>
            <a:off x="4705752" y="1678561"/>
            <a:ext cx="18165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[M + H]</a:t>
            </a:r>
            <a:r>
              <a:rPr lang="en-US" sz="1200" baseline="30000" dirty="0">
                <a:latin typeface="Helvetica" pitchFamily="2" charset="0"/>
              </a:rPr>
              <a:t>+</a:t>
            </a:r>
            <a:r>
              <a:rPr lang="en-US" sz="1200" dirty="0">
                <a:latin typeface="Helvetica" pitchFamily="2" charset="0"/>
              </a:rPr>
              <a:t>, 1.63 ppm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3A048C04-3DB1-3118-AA86-122DB767CB68}"/>
              </a:ext>
            </a:extLst>
          </p:cNvPr>
          <p:cNvSpPr txBox="1"/>
          <p:nvPr/>
        </p:nvSpPr>
        <p:spPr>
          <a:xfrm>
            <a:off x="4640292" y="3371327"/>
            <a:ext cx="139024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Helvetica" pitchFamily="2" charset="0"/>
              </a:rPr>
              <a:t>[M + H]</a:t>
            </a:r>
            <a:r>
              <a:rPr lang="en-US" sz="1100" baseline="30000" dirty="0">
                <a:latin typeface="Helvetica" pitchFamily="2" charset="0"/>
              </a:rPr>
              <a:t>+</a:t>
            </a:r>
            <a:r>
              <a:rPr lang="en-US" sz="1100" dirty="0">
                <a:latin typeface="Helvetica" pitchFamily="2" charset="0"/>
              </a:rPr>
              <a:t>, 1.64 ppm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2A34B9D-D36C-13D8-136B-B22EF4C06D6D}"/>
              </a:ext>
            </a:extLst>
          </p:cNvPr>
          <p:cNvSpPr txBox="1"/>
          <p:nvPr/>
        </p:nvSpPr>
        <p:spPr>
          <a:xfrm>
            <a:off x="4574832" y="5051819"/>
            <a:ext cx="20749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[M + H]</a:t>
            </a:r>
            <a:r>
              <a:rPr lang="en-US" sz="1200" baseline="30000" dirty="0">
                <a:latin typeface="Helvetica" pitchFamily="2" charset="0"/>
              </a:rPr>
              <a:t>+</a:t>
            </a:r>
            <a:r>
              <a:rPr lang="en-US" sz="1200" dirty="0">
                <a:latin typeface="Helvetica" pitchFamily="2" charset="0"/>
              </a:rPr>
              <a:t>, 2.48 ppm</a:t>
            </a:r>
          </a:p>
        </p:txBody>
      </p:sp>
      <p:cxnSp>
        <p:nvCxnSpPr>
          <p:cNvPr id="3" name="Straight Arrow Connector 2">
            <a:extLst>
              <a:ext uri="{FF2B5EF4-FFF2-40B4-BE49-F238E27FC236}">
                <a16:creationId xmlns:a16="http://schemas.microsoft.com/office/drawing/2014/main" id="{DECAADB9-F0B1-4CEA-1BC4-BE29D1F243F1}"/>
              </a:ext>
            </a:extLst>
          </p:cNvPr>
          <p:cNvCxnSpPr/>
          <p:nvPr/>
        </p:nvCxnSpPr>
        <p:spPr>
          <a:xfrm>
            <a:off x="6254839" y="2760372"/>
            <a:ext cx="394953" cy="4722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02831014-7E84-67E4-592A-023E4C26B7FD}"/>
              </a:ext>
            </a:extLst>
          </p:cNvPr>
          <p:cNvCxnSpPr/>
          <p:nvPr/>
        </p:nvCxnSpPr>
        <p:spPr>
          <a:xfrm>
            <a:off x="6254839" y="4449651"/>
            <a:ext cx="394953" cy="4722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006BE13E-344C-BD19-FE0F-962D9E318D1E}"/>
              </a:ext>
            </a:extLst>
          </p:cNvPr>
          <p:cNvCxnSpPr/>
          <p:nvPr/>
        </p:nvCxnSpPr>
        <p:spPr>
          <a:xfrm>
            <a:off x="6254839" y="6138930"/>
            <a:ext cx="394953" cy="4722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>
            <a:extLst>
              <a:ext uri="{FF2B5EF4-FFF2-40B4-BE49-F238E27FC236}">
                <a16:creationId xmlns:a16="http://schemas.microsoft.com/office/drawing/2014/main" id="{FB6E7152-E238-2A25-E634-43002C97A7B5}"/>
              </a:ext>
            </a:extLst>
          </p:cNvPr>
          <p:cNvSpPr txBox="1"/>
          <p:nvPr/>
        </p:nvSpPr>
        <p:spPr>
          <a:xfrm>
            <a:off x="5500047" y="2543911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32.093802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6FFE73E-E287-69C2-00D9-9A87196AB025}"/>
              </a:ext>
            </a:extLst>
          </p:cNvPr>
          <p:cNvSpPr txBox="1"/>
          <p:nvPr/>
        </p:nvSpPr>
        <p:spPr>
          <a:xfrm>
            <a:off x="5522252" y="4211640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32.093740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6290589-BBD0-4C4C-DEF1-D20203E75999}"/>
              </a:ext>
            </a:extLst>
          </p:cNvPr>
          <p:cNvSpPr txBox="1"/>
          <p:nvPr/>
        </p:nvSpPr>
        <p:spPr>
          <a:xfrm>
            <a:off x="5513685" y="5892085"/>
            <a:ext cx="10086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32.0946631</a:t>
            </a:r>
          </a:p>
        </p:txBody>
      </p:sp>
      <p:cxnSp>
        <p:nvCxnSpPr>
          <p:cNvPr id="2" name="Straight Arrow Connector 1">
            <a:extLst>
              <a:ext uri="{FF2B5EF4-FFF2-40B4-BE49-F238E27FC236}">
                <a16:creationId xmlns:a16="http://schemas.microsoft.com/office/drawing/2014/main" id="{157C35E1-F11E-045C-B1F2-1D46958C0AD5}"/>
              </a:ext>
            </a:extLst>
          </p:cNvPr>
          <p:cNvCxnSpPr/>
          <p:nvPr/>
        </p:nvCxnSpPr>
        <p:spPr>
          <a:xfrm>
            <a:off x="6203654" y="1029019"/>
            <a:ext cx="394953" cy="47222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>
            <a:extLst>
              <a:ext uri="{FF2B5EF4-FFF2-40B4-BE49-F238E27FC236}">
                <a16:creationId xmlns:a16="http://schemas.microsoft.com/office/drawing/2014/main" id="{C820E617-0A41-1F64-C605-6F3E1E0D15B4}"/>
              </a:ext>
            </a:extLst>
          </p:cNvPr>
          <p:cNvSpPr txBox="1"/>
          <p:nvPr/>
        </p:nvSpPr>
        <p:spPr>
          <a:xfrm>
            <a:off x="5448862" y="812558"/>
            <a:ext cx="9300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232.093250</a:t>
            </a:r>
          </a:p>
        </p:txBody>
      </p:sp>
      <p:sp>
        <p:nvSpPr>
          <p:cNvPr id="12" name="Rectangle 87">
            <a:extLst>
              <a:ext uri="{FF2B5EF4-FFF2-40B4-BE49-F238E27FC236}">
                <a16:creationId xmlns:a16="http://schemas.microsoft.com/office/drawing/2014/main" id="{1E0261CE-B8C3-C8AA-C1A9-3E9A08F3FF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66758" y="3509826"/>
            <a:ext cx="183832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VMR_Eg1_2</a:t>
            </a:r>
            <a:endParaRPr kumimoji="0" lang="en-US" altLang="en-US" sz="6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8" name="Rectangle 87">
            <a:extLst>
              <a:ext uri="{FF2B5EF4-FFF2-40B4-BE49-F238E27FC236}">
                <a16:creationId xmlns:a16="http://schemas.microsoft.com/office/drawing/2014/main" id="{64C33D33-8D67-9910-9189-05E7AE8BFE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66894" y="5191227"/>
            <a:ext cx="183832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Oyster mushroom</a:t>
            </a:r>
            <a:endParaRPr kumimoji="0" lang="en-US" altLang="en-US" sz="6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19" name="Rectangle 38">
            <a:extLst>
              <a:ext uri="{FF2B5EF4-FFF2-40B4-BE49-F238E27FC236}">
                <a16:creationId xmlns:a16="http://schemas.microsoft.com/office/drawing/2014/main" id="{B7DE5CFC-DC7E-5A20-9C0C-437E015B3A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02211" y="134826"/>
            <a:ext cx="161262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100 µM standard</a:t>
            </a:r>
            <a:endParaRPr kumimoji="0" lang="en-US" altLang="en-US" sz="6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0" name="Rectangle 87">
            <a:extLst>
              <a:ext uri="{FF2B5EF4-FFF2-40B4-BE49-F238E27FC236}">
                <a16:creationId xmlns:a16="http://schemas.microsoft.com/office/drawing/2014/main" id="{F0D6B784-D290-8425-010C-9ECB8CCEC29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02211" y="1797844"/>
            <a:ext cx="183832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6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VMR_Eg1-2</a:t>
            </a:r>
            <a:endParaRPr kumimoji="0" lang="en-US" altLang="en-US" sz="60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ED9C5975-185B-0BCD-BE43-8B4554E7FA04}"/>
              </a:ext>
            </a:extLst>
          </p:cNvPr>
          <p:cNvSpPr/>
          <p:nvPr/>
        </p:nvSpPr>
        <p:spPr>
          <a:xfrm>
            <a:off x="7886919" y="0"/>
            <a:ext cx="4174371" cy="685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91929B8E-A29C-725D-CEEF-107004F300C2}"/>
              </a:ext>
            </a:extLst>
          </p:cNvPr>
          <p:cNvSpPr/>
          <p:nvPr/>
        </p:nvSpPr>
        <p:spPr>
          <a:xfrm>
            <a:off x="1274491" y="11654"/>
            <a:ext cx="3365801" cy="141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76A5142B-833B-5B24-2331-134BC605FB3A}"/>
              </a:ext>
            </a:extLst>
          </p:cNvPr>
          <p:cNvSpPr/>
          <p:nvPr/>
        </p:nvSpPr>
        <p:spPr>
          <a:xfrm>
            <a:off x="1274491" y="1680931"/>
            <a:ext cx="3365801" cy="141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7417249C-4275-350F-0C4E-F20824AD8E14}"/>
              </a:ext>
            </a:extLst>
          </p:cNvPr>
          <p:cNvSpPr/>
          <p:nvPr/>
        </p:nvSpPr>
        <p:spPr>
          <a:xfrm>
            <a:off x="1274490" y="3345871"/>
            <a:ext cx="3365801" cy="141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B1375962-9C7B-41F3-2714-847E8B097E0C}"/>
              </a:ext>
            </a:extLst>
          </p:cNvPr>
          <p:cNvSpPr/>
          <p:nvPr/>
        </p:nvSpPr>
        <p:spPr>
          <a:xfrm>
            <a:off x="1268618" y="5024762"/>
            <a:ext cx="3365801" cy="141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FC898C35-5CE4-1E2D-F9C2-AC16EB0609EE}"/>
              </a:ext>
            </a:extLst>
          </p:cNvPr>
          <p:cNvSpPr/>
          <p:nvPr/>
        </p:nvSpPr>
        <p:spPr>
          <a:xfrm>
            <a:off x="4634419" y="6782325"/>
            <a:ext cx="3365801" cy="14163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Helvetica" pitchFamily="2" charset="0"/>
            </a:endParaRPr>
          </a:p>
        </p:txBody>
      </p:sp>
      <p:sp>
        <p:nvSpPr>
          <p:cNvPr id="27" name="Rectangle 183">
            <a:extLst>
              <a:ext uri="{FF2B5EF4-FFF2-40B4-BE49-F238E27FC236}">
                <a16:creationId xmlns:a16="http://schemas.microsoft.com/office/drawing/2014/main" id="{0F344DB0-E714-D012-B425-5FF7A9BECF1A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38773" y="6869654"/>
            <a:ext cx="239328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Counts vs. </a:t>
            </a:r>
            <a:r>
              <a:rPr lang="en-US" altLang="en-US" sz="1200" b="1" dirty="0">
                <a:solidFill>
                  <a:srgbClr val="000000"/>
                </a:solidFill>
                <a:latin typeface="Helvetica" pitchFamily="2" charset="0"/>
              </a:rPr>
              <a:t>M</a:t>
            </a:r>
            <a:r>
              <a:rPr kumimoji="0" lang="en-US" altLang="en-US" sz="12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Helvetica" pitchFamily="2" charset="0"/>
              </a:rPr>
              <a:t>ass-to-Charge (m/z)</a:t>
            </a:r>
            <a:endParaRPr kumimoji="0" lang="en-US" altLang="en-US" sz="12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 pitchFamily="2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0F8079F-F49B-117D-B397-9DA630187A41}"/>
              </a:ext>
            </a:extLst>
          </p:cNvPr>
          <p:cNvSpPr txBox="1"/>
          <p:nvPr/>
        </p:nvSpPr>
        <p:spPr>
          <a:xfrm>
            <a:off x="6505127" y="196381"/>
            <a:ext cx="277204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rgothioneine mass spectra</a:t>
            </a:r>
          </a:p>
          <a:p>
            <a:r>
              <a:rPr lang="en-US" dirty="0"/>
              <a:t>-annotated</a:t>
            </a:r>
          </a:p>
        </p:txBody>
      </p:sp>
    </p:spTree>
    <p:extLst>
      <p:ext uri="{BB962C8B-B14F-4D97-AF65-F5344CB8AC3E}">
        <p14:creationId xmlns:p14="http://schemas.microsoft.com/office/powerpoint/2010/main" val="4089818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5</TotalTime>
  <Words>298</Words>
  <Application>Microsoft Macintosh PowerPoint</Application>
  <PresentationFormat>Widescreen</PresentationFormat>
  <Paragraphs>19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Helvetica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ward Baidoo</dc:creator>
  <cp:lastModifiedBy>Vayu Maini Rekdal</cp:lastModifiedBy>
  <cp:revision>12</cp:revision>
  <dcterms:created xsi:type="dcterms:W3CDTF">2023-09-05T22:17:42Z</dcterms:created>
  <dcterms:modified xsi:type="dcterms:W3CDTF">2024-02-03T03:06:27Z</dcterms:modified>
</cp:coreProperties>
</file>